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5" r:id="rId3"/>
    <p:sldId id="266" r:id="rId4"/>
    <p:sldId id="267" r:id="rId5"/>
    <p:sldId id="275" r:id="rId6"/>
    <p:sldId id="269" r:id="rId7"/>
    <p:sldId id="270" r:id="rId8"/>
    <p:sldId id="271" r:id="rId9"/>
    <p:sldId id="273" r:id="rId10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7C7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62" autoAdjust="0"/>
    <p:restoredTop sz="94660"/>
  </p:normalViewPr>
  <p:slideViewPr>
    <p:cSldViewPr snapToGrid="0">
      <p:cViewPr varScale="1">
        <p:scale>
          <a:sx n="72" d="100"/>
          <a:sy n="72" d="100"/>
        </p:scale>
        <p:origin x="48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4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5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6.xlsx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7.xlsx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498140608170991E-2"/>
          <c:y val="0.18223183656497355"/>
          <c:w val="0.85841373009920108"/>
          <c:h val="0.3991852009524139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16"/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6:$A$33</c:f>
              <c:strCache>
                <c:ptCount val="8"/>
                <c:pt idx="0">
                  <c:v>Control</c:v>
                </c:pt>
                <c:pt idx="1">
                  <c:v>CK</c:v>
                </c:pt>
                <c:pt idx="2">
                  <c:v>ANI</c:v>
                </c:pt>
                <c:pt idx="3">
                  <c:v>ANI+CK</c:v>
                </c:pt>
                <c:pt idx="4">
                  <c:v>3AB</c:v>
                </c:pt>
                <c:pt idx="5">
                  <c:v>3AB+CK</c:v>
                </c:pt>
                <c:pt idx="6">
                  <c:v>zVAD</c:v>
                </c:pt>
                <c:pt idx="7">
                  <c:v>zVAD+CK</c:v>
                </c:pt>
              </c:strCache>
            </c:strRef>
          </c:cat>
          <c:val>
            <c:numRef>
              <c:f>Sheet1!$C$26:$C$33</c:f>
              <c:numCache>
                <c:formatCode>0.00</c:formatCode>
                <c:ptCount val="8"/>
                <c:pt idx="0" formatCode="General">
                  <c:v>1</c:v>
                </c:pt>
                <c:pt idx="1">
                  <c:v>10.1961139605794</c:v>
                </c:pt>
                <c:pt idx="2">
                  <c:v>0.21323078498618073</c:v>
                </c:pt>
                <c:pt idx="3">
                  <c:v>0.19297063875908127</c:v>
                </c:pt>
                <c:pt idx="4">
                  <c:v>5.0276995139174212E-2</c:v>
                </c:pt>
                <c:pt idx="5">
                  <c:v>2.7174966564297132E-2</c:v>
                </c:pt>
                <c:pt idx="6">
                  <c:v>0.75039257233632972</c:v>
                </c:pt>
                <c:pt idx="7">
                  <c:v>1.17700074735044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11-43D7-BD24-3A184CA2A6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4598576"/>
        <c:axId val="327156640"/>
      </c:barChart>
      <c:catAx>
        <c:axId val="254598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27156640"/>
        <c:crosses val="autoZero"/>
        <c:auto val="1"/>
        <c:lblAlgn val="ctr"/>
        <c:lblOffset val="100"/>
        <c:noMultiLvlLbl val="0"/>
      </c:catAx>
      <c:valAx>
        <c:axId val="327156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54598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855418422940171"/>
          <c:y val="0.20467514962383432"/>
          <c:w val="0.79738678165520083"/>
          <c:h val="0.4671941044180237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35:$E$4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.2</c:v>
                  </c:pt>
                  <c:pt idx="2">
                    <c:v>0.4</c:v>
                  </c:pt>
                  <c:pt idx="3">
                    <c:v>0.3</c:v>
                  </c:pt>
                  <c:pt idx="4">
                    <c:v>0.09</c:v>
                  </c:pt>
                  <c:pt idx="5">
                    <c:v>0.08</c:v>
                  </c:pt>
                  <c:pt idx="7">
                    <c:v>0</c:v>
                  </c:pt>
                  <c:pt idx="8">
                    <c:v>0.05</c:v>
                  </c:pt>
                  <c:pt idx="9">
                    <c:v>0.03</c:v>
                  </c:pt>
                  <c:pt idx="10">
                    <c:v>0.06</c:v>
                  </c:pt>
                  <c:pt idx="11">
                    <c:v>7.0000000000000007E-2</c:v>
                  </c:pt>
                  <c:pt idx="12">
                    <c:v>0.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6:$A$1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15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7">
                  <c:v>0</c:v>
                </c:pt>
                <c:pt idx="8">
                  <c:v>1</c:v>
                </c:pt>
                <c:pt idx="9">
                  <c:v>3</c:v>
                </c:pt>
                <c:pt idx="10">
                  <c:v>6</c:v>
                </c:pt>
                <c:pt idx="11">
                  <c:v>12</c:v>
                </c:pt>
                <c:pt idx="12">
                  <c:v>24</c:v>
                </c:pt>
              </c:numCache>
            </c:numRef>
          </c:cat>
          <c:val>
            <c:numRef>
              <c:f>Sheet1!$G$6:$G$18</c:f>
              <c:numCache>
                <c:formatCode>0.00</c:formatCode>
                <c:ptCount val="13"/>
                <c:pt idx="0" formatCode="General">
                  <c:v>1</c:v>
                </c:pt>
                <c:pt idx="1">
                  <c:v>2.5924818317903946</c:v>
                </c:pt>
                <c:pt idx="2">
                  <c:v>2.0164279083770293</c:v>
                </c:pt>
                <c:pt idx="3">
                  <c:v>2.8467113240840631</c:v>
                </c:pt>
                <c:pt idx="4">
                  <c:v>6.7404266706808169</c:v>
                </c:pt>
                <c:pt idx="5">
                  <c:v>13.56140896660729</c:v>
                </c:pt>
                <c:pt idx="7" formatCode="General">
                  <c:v>1</c:v>
                </c:pt>
                <c:pt idx="8">
                  <c:v>1.0784374084280255</c:v>
                </c:pt>
                <c:pt idx="9">
                  <c:v>0.65366184301270691</c:v>
                </c:pt>
                <c:pt idx="10">
                  <c:v>0.74335575952570532</c:v>
                </c:pt>
                <c:pt idx="11">
                  <c:v>2.2494383585566333</c:v>
                </c:pt>
                <c:pt idx="12">
                  <c:v>11.3866875438435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ADE-4C4F-9862-194D62BF95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37895584"/>
        <c:axId val="326497872"/>
      </c:barChart>
      <c:catAx>
        <c:axId val="337895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26497872"/>
        <c:crosses val="autoZero"/>
        <c:auto val="1"/>
        <c:lblAlgn val="ctr"/>
        <c:lblOffset val="100"/>
        <c:noMultiLvlLbl val="0"/>
      </c:catAx>
      <c:valAx>
        <c:axId val="3264978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37895584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37761966746284"/>
          <c:y val="0.12350781648877976"/>
          <c:w val="0.79206106484348338"/>
          <c:h val="0.5756217937808465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5:$H$17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0.1</c:v>
                  </c:pt>
                  <c:pt idx="2">
                    <c:v>0.4</c:v>
                  </c:pt>
                  <c:pt idx="3">
                    <c:v>0.6</c:v>
                  </c:pt>
                  <c:pt idx="4">
                    <c:v>0.2</c:v>
                  </c:pt>
                  <c:pt idx="5">
                    <c:v>0.15</c:v>
                  </c:pt>
                  <c:pt idx="7">
                    <c:v>0</c:v>
                  </c:pt>
                  <c:pt idx="8">
                    <c:v>0.1</c:v>
                  </c:pt>
                  <c:pt idx="9">
                    <c:v>0.4</c:v>
                  </c:pt>
                  <c:pt idx="10">
                    <c:v>0.5</c:v>
                  </c:pt>
                  <c:pt idx="11">
                    <c:v>6</c:v>
                  </c:pt>
                  <c:pt idx="12">
                    <c:v>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6:$A$1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15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7">
                  <c:v>0</c:v>
                </c:pt>
                <c:pt idx="8">
                  <c:v>1</c:v>
                </c:pt>
                <c:pt idx="9">
                  <c:v>3</c:v>
                </c:pt>
                <c:pt idx="10">
                  <c:v>6</c:v>
                </c:pt>
                <c:pt idx="11">
                  <c:v>12</c:v>
                </c:pt>
                <c:pt idx="12">
                  <c:v>24</c:v>
                </c:pt>
              </c:numCache>
            </c:numRef>
          </c:cat>
          <c:val>
            <c:numRef>
              <c:f>Sheet1!$C$6:$C$18</c:f>
              <c:numCache>
                <c:formatCode>0.00</c:formatCode>
                <c:ptCount val="13"/>
                <c:pt idx="0" formatCode="General">
                  <c:v>1</c:v>
                </c:pt>
                <c:pt idx="1">
                  <c:v>2.3560275091592211</c:v>
                </c:pt>
                <c:pt idx="2">
                  <c:v>3.0700027635142959</c:v>
                </c:pt>
                <c:pt idx="3">
                  <c:v>16.629257793211917</c:v>
                </c:pt>
                <c:pt idx="4">
                  <c:v>18.510760433790466</c:v>
                </c:pt>
                <c:pt idx="5">
                  <c:v>24.76384754341867</c:v>
                </c:pt>
                <c:pt idx="7" formatCode="General">
                  <c:v>1</c:v>
                </c:pt>
                <c:pt idx="8">
                  <c:v>1.926533820861829</c:v>
                </c:pt>
                <c:pt idx="9">
                  <c:v>3.98234200212802</c:v>
                </c:pt>
                <c:pt idx="10">
                  <c:v>5.71312177489812</c:v>
                </c:pt>
                <c:pt idx="11">
                  <c:v>16.897255463282139</c:v>
                </c:pt>
                <c:pt idx="12">
                  <c:v>32.6722877737827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A2-4B78-B266-5F5E27B0ED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overlap val="-27"/>
        <c:axId val="255082912"/>
        <c:axId val="339754720"/>
      </c:barChart>
      <c:catAx>
        <c:axId val="2550829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39754720"/>
        <c:crosses val="autoZero"/>
        <c:auto val="1"/>
        <c:lblAlgn val="ctr"/>
        <c:lblOffset val="100"/>
        <c:noMultiLvlLbl val="0"/>
      </c:catAx>
      <c:valAx>
        <c:axId val="33975472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55082912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5:$H$18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02</c:v>
                  </c:pt>
                  <c:pt idx="2">
                    <c:v>0.05</c:v>
                  </c:pt>
                  <c:pt idx="3">
                    <c:v>7.0000000000000007E-2</c:v>
                  </c:pt>
                  <c:pt idx="4">
                    <c:v>0.04</c:v>
                  </c:pt>
                  <c:pt idx="5">
                    <c:v>0.2</c:v>
                  </c:pt>
                  <c:pt idx="6">
                    <c:v>0.02</c:v>
                  </c:pt>
                  <c:pt idx="8">
                    <c:v>0</c:v>
                  </c:pt>
                  <c:pt idx="9">
                    <c:v>0.04</c:v>
                  </c:pt>
                  <c:pt idx="10">
                    <c:v>0.09</c:v>
                  </c:pt>
                  <c:pt idx="11">
                    <c:v>0.1</c:v>
                  </c:pt>
                  <c:pt idx="12">
                    <c:v>7.0000000000000007E-2</c:v>
                  </c:pt>
                  <c:pt idx="13">
                    <c:v>0.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6:$A$18</c:f>
              <c:numCache>
                <c:formatCode>General</c:formatCode>
                <c:ptCount val="13"/>
                <c:pt idx="0">
                  <c:v>0</c:v>
                </c:pt>
                <c:pt idx="1">
                  <c:v>5</c:v>
                </c:pt>
                <c:pt idx="2">
                  <c:v>15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7">
                  <c:v>0</c:v>
                </c:pt>
                <c:pt idx="8">
                  <c:v>1</c:v>
                </c:pt>
                <c:pt idx="9">
                  <c:v>3</c:v>
                </c:pt>
                <c:pt idx="10">
                  <c:v>6</c:v>
                </c:pt>
                <c:pt idx="11">
                  <c:v>12</c:v>
                </c:pt>
                <c:pt idx="12">
                  <c:v>24</c:v>
                </c:pt>
              </c:numCache>
            </c:numRef>
          </c:cat>
          <c:val>
            <c:numRef>
              <c:f>Sheet1!$E$6:$E$18</c:f>
              <c:numCache>
                <c:formatCode>0.00</c:formatCode>
                <c:ptCount val="13"/>
                <c:pt idx="0" formatCode="General">
                  <c:v>1</c:v>
                </c:pt>
                <c:pt idx="1">
                  <c:v>1.3108072833095112</c:v>
                </c:pt>
                <c:pt idx="2">
                  <c:v>1.7967023695412785</c:v>
                </c:pt>
                <c:pt idx="3">
                  <c:v>1.8583374161077972</c:v>
                </c:pt>
                <c:pt idx="4">
                  <c:v>1.2907714891809605</c:v>
                </c:pt>
                <c:pt idx="5">
                  <c:v>0.8822327024878357</c:v>
                </c:pt>
                <c:pt idx="7" formatCode="General">
                  <c:v>1</c:v>
                </c:pt>
                <c:pt idx="8">
                  <c:v>1.221858020080042</c:v>
                </c:pt>
                <c:pt idx="9">
                  <c:v>1.284755400981286</c:v>
                </c:pt>
                <c:pt idx="10">
                  <c:v>1.3923334970448136</c:v>
                </c:pt>
                <c:pt idx="11">
                  <c:v>0.92020253288605114</c:v>
                </c:pt>
                <c:pt idx="12">
                  <c:v>0.71973830752392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18F-4E05-B21D-39DB7697BB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overlap val="-27"/>
        <c:axId val="350243856"/>
        <c:axId val="350473840"/>
      </c:barChart>
      <c:catAx>
        <c:axId val="3502438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50473840"/>
        <c:crosses val="autoZero"/>
        <c:auto val="1"/>
        <c:lblAlgn val="ctr"/>
        <c:lblOffset val="100"/>
        <c:noMultiLvlLbl val="0"/>
      </c:catAx>
      <c:valAx>
        <c:axId val="350473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5024385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95264032461566"/>
          <c:y val="0.19979885267363004"/>
          <c:w val="0.85182581048623018"/>
          <c:h val="0.5220762000011237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solidFill>
                <a:srgbClr val="328BA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M$56:$M$69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02</c:v>
                  </c:pt>
                  <c:pt idx="2">
                    <c:v>0.5</c:v>
                  </c:pt>
                  <c:pt idx="3">
                    <c:v>0.04</c:v>
                  </c:pt>
                  <c:pt idx="5">
                    <c:v>0</c:v>
                  </c:pt>
                  <c:pt idx="6">
                    <c:v>0.4</c:v>
                  </c:pt>
                  <c:pt idx="7">
                    <c:v>0.6</c:v>
                  </c:pt>
                  <c:pt idx="8">
                    <c:v>0.04</c:v>
                  </c:pt>
                  <c:pt idx="10">
                    <c:v>0</c:v>
                  </c:pt>
                  <c:pt idx="11">
                    <c:v>2.5000000000000001E-2</c:v>
                  </c:pt>
                  <c:pt idx="12">
                    <c:v>0.4</c:v>
                  </c:pt>
                  <c:pt idx="13">
                    <c:v>0.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H$5:$H$18</c:f>
              <c:numCache>
                <c:formatCode>General</c:formatCode>
                <c:ptCount val="14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5">
                  <c:v>0</c:v>
                </c:pt>
                <c:pt idx="6">
                  <c:v>6</c:v>
                </c:pt>
                <c:pt idx="7">
                  <c:v>12</c:v>
                </c:pt>
                <c:pt idx="8">
                  <c:v>18</c:v>
                </c:pt>
                <c:pt idx="10">
                  <c:v>0</c:v>
                </c:pt>
                <c:pt idx="11">
                  <c:v>6</c:v>
                </c:pt>
                <c:pt idx="12">
                  <c:v>12</c:v>
                </c:pt>
                <c:pt idx="13">
                  <c:v>18</c:v>
                </c:pt>
              </c:numCache>
            </c:numRef>
          </c:cat>
          <c:val>
            <c:numRef>
              <c:f>Sheet1!$J$5:$J$18</c:f>
              <c:numCache>
                <c:formatCode>0.00</c:formatCode>
                <c:ptCount val="14"/>
                <c:pt idx="0" formatCode="General">
                  <c:v>1</c:v>
                </c:pt>
                <c:pt idx="1">
                  <c:v>1.1835428074356504</c:v>
                </c:pt>
                <c:pt idx="2">
                  <c:v>1.6689807196768049</c:v>
                </c:pt>
                <c:pt idx="3">
                  <c:v>1.5145645450360103</c:v>
                </c:pt>
                <c:pt idx="5">
                  <c:v>0.79478242829182544</c:v>
                </c:pt>
                <c:pt idx="6">
                  <c:v>5.3516625147458567</c:v>
                </c:pt>
                <c:pt idx="7">
                  <c:v>4.9518133213558615</c:v>
                </c:pt>
                <c:pt idx="8">
                  <c:v>4.0076839056946163</c:v>
                </c:pt>
                <c:pt idx="10">
                  <c:v>0.11248537261887648</c:v>
                </c:pt>
                <c:pt idx="11">
                  <c:v>1.1071834460960273</c:v>
                </c:pt>
                <c:pt idx="12">
                  <c:v>1.6984375052107439</c:v>
                </c:pt>
                <c:pt idx="13">
                  <c:v>1.43077472858934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A9-4C57-A9E0-CDF7744BD8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overlap val="-27"/>
        <c:axId val="1281923247"/>
        <c:axId val="1468406767"/>
      </c:barChart>
      <c:catAx>
        <c:axId val="12819232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468406767"/>
        <c:crosses val="autoZero"/>
        <c:auto val="1"/>
        <c:lblAlgn val="ctr"/>
        <c:lblOffset val="100"/>
        <c:noMultiLvlLbl val="0"/>
      </c:catAx>
      <c:valAx>
        <c:axId val="1468406767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281923247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71391350002565"/>
          <c:y val="8.4611214796866868E-2"/>
          <c:w val="0.81904219774510201"/>
          <c:h val="0.546394828081740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Z$4:$Z$17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02</c:v>
                  </c:pt>
                  <c:pt idx="2">
                    <c:v>0.3</c:v>
                  </c:pt>
                  <c:pt idx="3">
                    <c:v>0.04</c:v>
                  </c:pt>
                  <c:pt idx="5">
                    <c:v>0</c:v>
                  </c:pt>
                  <c:pt idx="6">
                    <c:v>0.1</c:v>
                  </c:pt>
                  <c:pt idx="7">
                    <c:v>0.12</c:v>
                  </c:pt>
                  <c:pt idx="8">
                    <c:v>0.04</c:v>
                  </c:pt>
                  <c:pt idx="10">
                    <c:v>0</c:v>
                  </c:pt>
                  <c:pt idx="11">
                    <c:v>2.5000000000000001E-2</c:v>
                  </c:pt>
                  <c:pt idx="12">
                    <c:v>0.2</c:v>
                  </c:pt>
                  <c:pt idx="13">
                    <c:v>0.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H$5:$H$18</c:f>
              <c:numCache>
                <c:formatCode>General</c:formatCode>
                <c:ptCount val="14"/>
                <c:pt idx="0">
                  <c:v>0</c:v>
                </c:pt>
                <c:pt idx="1">
                  <c:v>6</c:v>
                </c:pt>
                <c:pt idx="2">
                  <c:v>12</c:v>
                </c:pt>
                <c:pt idx="3">
                  <c:v>18</c:v>
                </c:pt>
                <c:pt idx="5">
                  <c:v>0</c:v>
                </c:pt>
                <c:pt idx="6">
                  <c:v>6</c:v>
                </c:pt>
                <c:pt idx="7">
                  <c:v>12</c:v>
                </c:pt>
                <c:pt idx="8">
                  <c:v>18</c:v>
                </c:pt>
                <c:pt idx="10">
                  <c:v>0</c:v>
                </c:pt>
                <c:pt idx="11">
                  <c:v>6</c:v>
                </c:pt>
                <c:pt idx="12">
                  <c:v>12</c:v>
                </c:pt>
                <c:pt idx="13">
                  <c:v>18</c:v>
                </c:pt>
              </c:numCache>
            </c:numRef>
          </c:cat>
          <c:val>
            <c:numRef>
              <c:f>Sheet1!$X$3:$X$16</c:f>
              <c:numCache>
                <c:formatCode>0.00</c:formatCode>
                <c:ptCount val="14"/>
                <c:pt idx="0">
                  <c:v>1</c:v>
                </c:pt>
                <c:pt idx="1">
                  <c:v>1.741931609861791</c:v>
                </c:pt>
                <c:pt idx="2">
                  <c:v>2.1705416252229797</c:v>
                </c:pt>
                <c:pt idx="3">
                  <c:v>2.4169886964916145</c:v>
                </c:pt>
                <c:pt idx="5">
                  <c:v>0.27196166690866852</c:v>
                </c:pt>
                <c:pt idx="6">
                  <c:v>0.30644253530332588</c:v>
                </c:pt>
                <c:pt idx="7">
                  <c:v>0.28078859681754326</c:v>
                </c:pt>
                <c:pt idx="8">
                  <c:v>0.32924831439093571</c:v>
                </c:pt>
                <c:pt idx="10">
                  <c:v>1.809372710310408</c:v>
                </c:pt>
                <c:pt idx="11">
                  <c:v>2.2722313559900056</c:v>
                </c:pt>
                <c:pt idx="12">
                  <c:v>1.8292901590893589</c:v>
                </c:pt>
                <c:pt idx="13">
                  <c:v>1.39237041429180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80C-4DA8-9353-B9417DFC1D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overlap val="-27"/>
        <c:axId val="422398159"/>
        <c:axId val="305341119"/>
      </c:barChart>
      <c:catAx>
        <c:axId val="4223981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05341119"/>
        <c:crosses val="autoZero"/>
        <c:auto val="1"/>
        <c:lblAlgn val="ctr"/>
        <c:lblOffset val="100"/>
        <c:noMultiLvlLbl val="0"/>
      </c:catAx>
      <c:valAx>
        <c:axId val="305341119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22398159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6350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76696670881585"/>
          <c:y val="0.27506436301756831"/>
          <c:w val="0.63859098474133236"/>
          <c:h val="0.407708845728359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11:$D$1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05</c:v>
                  </c:pt>
                  <c:pt idx="2">
                    <c:v>0.04</c:v>
                  </c:pt>
                  <c:pt idx="3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6:$B$9</c:f>
              <c:strCache>
                <c:ptCount val="4"/>
                <c:pt idx="0">
                  <c:v>DMSO</c:v>
                </c:pt>
                <c:pt idx="1">
                  <c:v>DMSO+CK</c:v>
                </c:pt>
                <c:pt idx="2">
                  <c:v>LMB</c:v>
                </c:pt>
                <c:pt idx="3">
                  <c:v>LMB+CK</c:v>
                </c:pt>
              </c:strCache>
            </c:strRef>
          </c:cat>
          <c:val>
            <c:numRef>
              <c:f>Sheet1!$D$6:$D$9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0.92776668819288022</c:v>
                </c:pt>
                <c:pt idx="2">
                  <c:v>0.35391535310401145</c:v>
                </c:pt>
                <c:pt idx="3">
                  <c:v>0.265275423953403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FC-493B-8CC2-90E3D00D02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015192287"/>
        <c:axId val="179346735"/>
      </c:barChart>
      <c:catAx>
        <c:axId val="201519228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79346735"/>
        <c:crosses val="autoZero"/>
        <c:auto val="1"/>
        <c:lblAlgn val="ctr"/>
        <c:lblOffset val="100"/>
        <c:noMultiLvlLbl val="0"/>
      </c:catAx>
      <c:valAx>
        <c:axId val="17934673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015192287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ko-KR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495318641522767"/>
          <c:y val="4.9762592116697625E-2"/>
          <c:w val="0.60080488451176961"/>
          <c:h val="0.492722443934129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N$5:$N$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06</c:v>
                  </c:pt>
                  <c:pt idx="2">
                    <c:v>0.02</c:v>
                  </c:pt>
                  <c:pt idx="3">
                    <c:v>0.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6:$B$9</c:f>
              <c:strCache>
                <c:ptCount val="4"/>
                <c:pt idx="0">
                  <c:v>DMSO</c:v>
                </c:pt>
                <c:pt idx="1">
                  <c:v>DMSO+CK</c:v>
                </c:pt>
                <c:pt idx="2">
                  <c:v>LMB</c:v>
                </c:pt>
                <c:pt idx="3">
                  <c:v>LMB+CK</c:v>
                </c:pt>
              </c:strCache>
            </c:strRef>
          </c:cat>
          <c:val>
            <c:numRef>
              <c:f>Sheet1!$G$6:$G$9</c:f>
              <c:numCache>
                <c:formatCode>0.00</c:formatCode>
                <c:ptCount val="4"/>
                <c:pt idx="0" formatCode="General">
                  <c:v>1</c:v>
                </c:pt>
                <c:pt idx="1">
                  <c:v>0.9924755617858958</c:v>
                </c:pt>
                <c:pt idx="2">
                  <c:v>0.82084985400295518</c:v>
                </c:pt>
                <c:pt idx="3">
                  <c:v>0.523422658789393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69-43DB-8620-EAE0196559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231719199"/>
        <c:axId val="239550543"/>
      </c:barChart>
      <c:catAx>
        <c:axId val="23171919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39550543"/>
        <c:crosses val="autoZero"/>
        <c:auto val="1"/>
        <c:lblAlgn val="ctr"/>
        <c:lblOffset val="100"/>
        <c:noMultiLvlLbl val="0"/>
      </c:catAx>
      <c:valAx>
        <c:axId val="23955054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31719199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40264313223182"/>
          <c:y val="0.28742937202447316"/>
          <c:w val="0.80509297040481231"/>
          <c:h val="0.4772642258670219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31:$C$44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05</c:v>
                  </c:pt>
                  <c:pt idx="2">
                    <c:v>0.1</c:v>
                  </c:pt>
                  <c:pt idx="3">
                    <c:v>0.08</c:v>
                  </c:pt>
                  <c:pt idx="5">
                    <c:v>0</c:v>
                  </c:pt>
                  <c:pt idx="6">
                    <c:v>0.02</c:v>
                  </c:pt>
                  <c:pt idx="7">
                    <c:v>0.05</c:v>
                  </c:pt>
                  <c:pt idx="8">
                    <c:v>0.01</c:v>
                  </c:pt>
                  <c:pt idx="10">
                    <c:v>0.02</c:v>
                  </c:pt>
                  <c:pt idx="11">
                    <c:v>0.08</c:v>
                  </c:pt>
                  <c:pt idx="12">
                    <c:v>0.02</c:v>
                  </c:pt>
                  <c:pt idx="13">
                    <c:v>0.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5:$B$28</c:f>
              <c:strCache>
                <c:ptCount val="14"/>
                <c:pt idx="0">
                  <c:v>DMSO</c:v>
                </c:pt>
                <c:pt idx="1">
                  <c:v>DMSO+CK</c:v>
                </c:pt>
                <c:pt idx="2">
                  <c:v>LMB</c:v>
                </c:pt>
                <c:pt idx="3">
                  <c:v>LMB+CK</c:v>
                </c:pt>
                <c:pt idx="5">
                  <c:v>DMSO</c:v>
                </c:pt>
                <c:pt idx="6">
                  <c:v>DMSO+CK</c:v>
                </c:pt>
                <c:pt idx="7">
                  <c:v>LMB</c:v>
                </c:pt>
                <c:pt idx="8">
                  <c:v>LMB+CK</c:v>
                </c:pt>
                <c:pt idx="10">
                  <c:v>DMSO</c:v>
                </c:pt>
                <c:pt idx="11">
                  <c:v>DMSO+CK</c:v>
                </c:pt>
                <c:pt idx="12">
                  <c:v>LMB</c:v>
                </c:pt>
                <c:pt idx="13">
                  <c:v>LMB+CK</c:v>
                </c:pt>
              </c:strCache>
            </c:strRef>
          </c:cat>
          <c:val>
            <c:numRef>
              <c:f>Sheet1!$D$15:$D$28</c:f>
              <c:numCache>
                <c:formatCode>0.00</c:formatCode>
                <c:ptCount val="14"/>
                <c:pt idx="0" formatCode="General">
                  <c:v>1</c:v>
                </c:pt>
                <c:pt idx="1">
                  <c:v>1.0872302666091891</c:v>
                </c:pt>
                <c:pt idx="2">
                  <c:v>0.94335472187701574</c:v>
                </c:pt>
                <c:pt idx="3">
                  <c:v>0.82406578146113163</c:v>
                </c:pt>
                <c:pt idx="5">
                  <c:v>9.8085506353780771E-2</c:v>
                </c:pt>
                <c:pt idx="6">
                  <c:v>6.2639499927921713E-2</c:v>
                </c:pt>
                <c:pt idx="7">
                  <c:v>1.9408969147302075E-2</c:v>
                </c:pt>
                <c:pt idx="8">
                  <c:v>3.1235982368776935E-2</c:v>
                </c:pt>
                <c:pt idx="10">
                  <c:v>3.8149462479124006E-2</c:v>
                </c:pt>
                <c:pt idx="11">
                  <c:v>0.45651709115620931</c:v>
                </c:pt>
                <c:pt idx="12">
                  <c:v>0.14933656758341829</c:v>
                </c:pt>
                <c:pt idx="13">
                  <c:v>0.282863709879831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E5-481D-9EF6-349CA4C11F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289950239"/>
        <c:axId val="282428191"/>
      </c:barChart>
      <c:catAx>
        <c:axId val="2899502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2428191"/>
        <c:crosses val="autoZero"/>
        <c:auto val="1"/>
        <c:lblAlgn val="ctr"/>
        <c:lblOffset val="100"/>
        <c:noMultiLvlLbl val="0"/>
      </c:catAx>
      <c:valAx>
        <c:axId val="28242819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9950239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32760743182401"/>
          <c:y val="0.24852589025928881"/>
          <c:w val="0.81444872973431637"/>
          <c:h val="0.3900074671061101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31:$C$44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0.05</c:v>
                  </c:pt>
                  <c:pt idx="2">
                    <c:v>0.2</c:v>
                  </c:pt>
                  <c:pt idx="3">
                    <c:v>0.35</c:v>
                  </c:pt>
                  <c:pt idx="5">
                    <c:v>0</c:v>
                  </c:pt>
                  <c:pt idx="6">
                    <c:v>0.4</c:v>
                  </c:pt>
                  <c:pt idx="7">
                    <c:v>0.05</c:v>
                  </c:pt>
                  <c:pt idx="8">
                    <c:v>0.01</c:v>
                  </c:pt>
                  <c:pt idx="10">
                    <c:v>0.02</c:v>
                  </c:pt>
                  <c:pt idx="11">
                    <c:v>0.08</c:v>
                  </c:pt>
                  <c:pt idx="12">
                    <c:v>0.02</c:v>
                  </c:pt>
                  <c:pt idx="13">
                    <c:v>0.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5:$B$28</c:f>
              <c:strCache>
                <c:ptCount val="14"/>
                <c:pt idx="0">
                  <c:v>DMSO</c:v>
                </c:pt>
                <c:pt idx="1">
                  <c:v>DMSO+CK</c:v>
                </c:pt>
                <c:pt idx="2">
                  <c:v>LMB</c:v>
                </c:pt>
                <c:pt idx="3">
                  <c:v>LMB+CK</c:v>
                </c:pt>
                <c:pt idx="5">
                  <c:v>DMSO</c:v>
                </c:pt>
                <c:pt idx="6">
                  <c:v>DMSO+CK</c:v>
                </c:pt>
                <c:pt idx="7">
                  <c:v>LMB</c:v>
                </c:pt>
                <c:pt idx="8">
                  <c:v>LMB+CK</c:v>
                </c:pt>
                <c:pt idx="10">
                  <c:v>DMSO</c:v>
                </c:pt>
                <c:pt idx="11">
                  <c:v>DMSO+CK</c:v>
                </c:pt>
                <c:pt idx="12">
                  <c:v>LMB</c:v>
                </c:pt>
                <c:pt idx="13">
                  <c:v>LMB+CK</c:v>
                </c:pt>
              </c:strCache>
            </c:strRef>
          </c:cat>
          <c:val>
            <c:numRef>
              <c:f>Sheet1!$G$15:$G$28</c:f>
              <c:numCache>
                <c:formatCode>0.00</c:formatCode>
                <c:ptCount val="14"/>
                <c:pt idx="0" formatCode="General">
                  <c:v>1</c:v>
                </c:pt>
                <c:pt idx="1">
                  <c:v>0.32419552509485688</c:v>
                </c:pt>
                <c:pt idx="2">
                  <c:v>1.3784008654969775</c:v>
                </c:pt>
                <c:pt idx="3">
                  <c:v>1.5670656806808221</c:v>
                </c:pt>
                <c:pt idx="4">
                  <c:v>0</c:v>
                </c:pt>
                <c:pt idx="5">
                  <c:v>1.397696744131536</c:v>
                </c:pt>
                <c:pt idx="6">
                  <c:v>3.1616407115907115</c:v>
                </c:pt>
                <c:pt idx="7">
                  <c:v>1.3891914823762956</c:v>
                </c:pt>
                <c:pt idx="8">
                  <c:v>1.4715475494543182</c:v>
                </c:pt>
                <c:pt idx="9">
                  <c:v>0</c:v>
                </c:pt>
                <c:pt idx="10">
                  <c:v>2.0325572798735227E-2</c:v>
                </c:pt>
                <c:pt idx="11">
                  <c:v>4.5466084611520734E-2</c:v>
                </c:pt>
                <c:pt idx="12">
                  <c:v>7.6680206613120964E-3</c:v>
                </c:pt>
                <c:pt idx="13">
                  <c:v>8.112529056098964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1D-42A7-8939-691F5BF830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80"/>
        <c:axId val="309626799"/>
        <c:axId val="289689775"/>
      </c:barChart>
      <c:catAx>
        <c:axId val="30962679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89689775"/>
        <c:crosses val="autoZero"/>
        <c:auto val="1"/>
        <c:lblAlgn val="ctr"/>
        <c:lblOffset val="100"/>
        <c:noMultiLvlLbl val="0"/>
      </c:catAx>
      <c:valAx>
        <c:axId val="28968977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09626799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498140608170991E-2"/>
          <c:y val="0.12860628660248324"/>
          <c:w val="0.85841373009920108"/>
          <c:h val="0.4301220527286643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percentage"/>
            <c:noEndCap val="0"/>
            <c:val val="20"/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6:$A$33</c:f>
              <c:strCache>
                <c:ptCount val="8"/>
                <c:pt idx="0">
                  <c:v>Control</c:v>
                </c:pt>
                <c:pt idx="1">
                  <c:v>CK</c:v>
                </c:pt>
                <c:pt idx="2">
                  <c:v>ANI</c:v>
                </c:pt>
                <c:pt idx="3">
                  <c:v>ANI+CK</c:v>
                </c:pt>
                <c:pt idx="4">
                  <c:v>3AB</c:v>
                </c:pt>
                <c:pt idx="5">
                  <c:v>3AB+CK</c:v>
                </c:pt>
                <c:pt idx="6">
                  <c:v>zVAD</c:v>
                </c:pt>
                <c:pt idx="7">
                  <c:v>zVAD+CK</c:v>
                </c:pt>
              </c:strCache>
            </c:strRef>
          </c:cat>
          <c:val>
            <c:numRef>
              <c:f>Sheet1!$E$26:$E$33</c:f>
              <c:numCache>
                <c:formatCode>0.00</c:formatCode>
                <c:ptCount val="8"/>
                <c:pt idx="0" formatCode="General">
                  <c:v>1</c:v>
                </c:pt>
                <c:pt idx="1">
                  <c:v>1.1134554596055615</c:v>
                </c:pt>
                <c:pt idx="2">
                  <c:v>2.6157889914561241</c:v>
                </c:pt>
                <c:pt idx="3">
                  <c:v>3.0662350825755325</c:v>
                </c:pt>
                <c:pt idx="4">
                  <c:v>2.8294173901092612</c:v>
                </c:pt>
                <c:pt idx="5">
                  <c:v>10.462650605859313</c:v>
                </c:pt>
                <c:pt idx="6">
                  <c:v>0.92963470921043601</c:v>
                </c:pt>
                <c:pt idx="7">
                  <c:v>0.562826408136152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75-4CF2-8DFA-6A114736EB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0"/>
        <c:overlap val="-27"/>
        <c:axId val="193318320"/>
        <c:axId val="390867216"/>
      </c:barChart>
      <c:catAx>
        <c:axId val="193318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90867216"/>
        <c:crosses val="autoZero"/>
        <c:auto val="1"/>
        <c:lblAlgn val="ctr"/>
        <c:lblOffset val="100"/>
        <c:noMultiLvlLbl val="0"/>
      </c:catAx>
      <c:valAx>
        <c:axId val="390867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3318320"/>
        <c:crosses val="autoZero"/>
        <c:crossBetween val="between"/>
        <c:majorUnit val="5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247113718628304E-2"/>
          <c:y val="8.6921653457242648E-2"/>
          <c:w val="0.85682260305697078"/>
          <c:h val="0.4674521995089042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47:$C$54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02</c:v>
                  </c:pt>
                  <c:pt idx="2">
                    <c:v>0.05</c:v>
                  </c:pt>
                  <c:pt idx="3">
                    <c:v>7.0000000000000007E-2</c:v>
                  </c:pt>
                  <c:pt idx="4">
                    <c:v>0.04</c:v>
                  </c:pt>
                  <c:pt idx="5">
                    <c:v>0.09</c:v>
                  </c:pt>
                  <c:pt idx="6">
                    <c:v>0.05</c:v>
                  </c:pt>
                  <c:pt idx="7">
                    <c:v>0.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6:$A$33</c:f>
              <c:strCache>
                <c:ptCount val="8"/>
                <c:pt idx="0">
                  <c:v>Control</c:v>
                </c:pt>
                <c:pt idx="1">
                  <c:v>CK</c:v>
                </c:pt>
                <c:pt idx="2">
                  <c:v>ANI</c:v>
                </c:pt>
                <c:pt idx="3">
                  <c:v>ANI+CK</c:v>
                </c:pt>
                <c:pt idx="4">
                  <c:v>3AB</c:v>
                </c:pt>
                <c:pt idx="5">
                  <c:v>3AB+CK</c:v>
                </c:pt>
                <c:pt idx="6">
                  <c:v>zVAD</c:v>
                </c:pt>
                <c:pt idx="7">
                  <c:v>zVAD+CK</c:v>
                </c:pt>
              </c:strCache>
            </c:strRef>
          </c:cat>
          <c:val>
            <c:numRef>
              <c:f>Sheet1!$G$26:$G$33</c:f>
              <c:numCache>
                <c:formatCode>0.00</c:formatCode>
                <c:ptCount val="8"/>
                <c:pt idx="0" formatCode="General">
                  <c:v>1</c:v>
                </c:pt>
                <c:pt idx="1">
                  <c:v>0.90938705325061964</c:v>
                </c:pt>
                <c:pt idx="2">
                  <c:v>1.044970256863653</c:v>
                </c:pt>
                <c:pt idx="3">
                  <c:v>0.52997001592958304</c:v>
                </c:pt>
                <c:pt idx="4">
                  <c:v>0.90809447688324907</c:v>
                </c:pt>
                <c:pt idx="5">
                  <c:v>0.37264329815695912</c:v>
                </c:pt>
                <c:pt idx="6">
                  <c:v>0.80618687265482114</c:v>
                </c:pt>
                <c:pt idx="7">
                  <c:v>0.635966777636010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81-41E7-AF45-E78D1F7110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95250688"/>
        <c:axId val="327100064"/>
      </c:barChart>
      <c:catAx>
        <c:axId val="495250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27100064"/>
        <c:crosses val="autoZero"/>
        <c:auto val="1"/>
        <c:lblAlgn val="ctr"/>
        <c:lblOffset val="100"/>
        <c:noMultiLvlLbl val="0"/>
      </c:catAx>
      <c:valAx>
        <c:axId val="3271000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95250688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98410154487294"/>
          <c:y val="9.4600743252517772E-2"/>
          <c:w val="0.84068254476069471"/>
          <c:h val="0.470351240194608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47:$I$54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02</c:v>
                  </c:pt>
                  <c:pt idx="2">
                    <c:v>0.05</c:v>
                  </c:pt>
                  <c:pt idx="3">
                    <c:v>7.0000000000000007E-2</c:v>
                  </c:pt>
                  <c:pt idx="4">
                    <c:v>0.15</c:v>
                  </c:pt>
                  <c:pt idx="5">
                    <c:v>0.09</c:v>
                  </c:pt>
                  <c:pt idx="6">
                    <c:v>0.08</c:v>
                  </c:pt>
                  <c:pt idx="7">
                    <c:v>0.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6:$A$33</c:f>
              <c:strCache>
                <c:ptCount val="8"/>
                <c:pt idx="0">
                  <c:v>Control</c:v>
                </c:pt>
                <c:pt idx="1">
                  <c:v>CK</c:v>
                </c:pt>
                <c:pt idx="2">
                  <c:v>ANI</c:v>
                </c:pt>
                <c:pt idx="3">
                  <c:v>ANI+CK</c:v>
                </c:pt>
                <c:pt idx="4">
                  <c:v>3AB</c:v>
                </c:pt>
                <c:pt idx="5">
                  <c:v>3AB+CK</c:v>
                </c:pt>
                <c:pt idx="6">
                  <c:v>zVAD</c:v>
                </c:pt>
                <c:pt idx="7">
                  <c:v>zVAD+CK</c:v>
                </c:pt>
              </c:strCache>
            </c:strRef>
          </c:cat>
          <c:val>
            <c:numRef>
              <c:f>Sheet1!$I$26:$I$33</c:f>
              <c:numCache>
                <c:formatCode>0.00</c:formatCode>
                <c:ptCount val="8"/>
                <c:pt idx="0" formatCode="General">
                  <c:v>1</c:v>
                </c:pt>
                <c:pt idx="1">
                  <c:v>0.97727385014005408</c:v>
                </c:pt>
                <c:pt idx="2">
                  <c:v>1.0626661893672655</c:v>
                </c:pt>
                <c:pt idx="3">
                  <c:v>0.69219549930405788</c:v>
                </c:pt>
                <c:pt idx="4">
                  <c:v>0.7414870002603362</c:v>
                </c:pt>
                <c:pt idx="5">
                  <c:v>0.48777970369412316</c:v>
                </c:pt>
                <c:pt idx="6">
                  <c:v>0.82513505737033777</c:v>
                </c:pt>
                <c:pt idx="7">
                  <c:v>0.791129333886551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04-4706-8B85-7080B3F1C0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46853632"/>
        <c:axId val="352135520"/>
      </c:barChart>
      <c:catAx>
        <c:axId val="246853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52135520"/>
        <c:crosses val="autoZero"/>
        <c:auto val="1"/>
        <c:lblAlgn val="ctr"/>
        <c:lblOffset val="100"/>
        <c:noMultiLvlLbl val="0"/>
      </c:catAx>
      <c:valAx>
        <c:axId val="352135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46853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62541126021218"/>
          <c:y val="0.11904443453707832"/>
          <c:w val="0.78559591192178713"/>
          <c:h val="0.464406548769009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47:$I$54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05</c:v>
                  </c:pt>
                  <c:pt idx="2">
                    <c:v>0.05</c:v>
                  </c:pt>
                  <c:pt idx="3">
                    <c:v>7.0000000000000007E-2</c:v>
                  </c:pt>
                  <c:pt idx="4">
                    <c:v>0.15</c:v>
                  </c:pt>
                  <c:pt idx="5">
                    <c:v>0.09</c:v>
                  </c:pt>
                  <c:pt idx="6">
                    <c:v>0.04</c:v>
                  </c:pt>
                  <c:pt idx="7">
                    <c:v>0.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6:$A$33</c:f>
              <c:strCache>
                <c:ptCount val="8"/>
                <c:pt idx="0">
                  <c:v>Control</c:v>
                </c:pt>
                <c:pt idx="1">
                  <c:v>CK</c:v>
                </c:pt>
                <c:pt idx="2">
                  <c:v>ANI</c:v>
                </c:pt>
                <c:pt idx="3">
                  <c:v>ANI+CK</c:v>
                </c:pt>
                <c:pt idx="4">
                  <c:v>3AB</c:v>
                </c:pt>
                <c:pt idx="5">
                  <c:v>3AB+CK</c:v>
                </c:pt>
                <c:pt idx="6">
                  <c:v>zVAD</c:v>
                </c:pt>
                <c:pt idx="7">
                  <c:v>zVAD+CK</c:v>
                </c:pt>
              </c:strCache>
            </c:strRef>
          </c:cat>
          <c:val>
            <c:numRef>
              <c:f>Sheet1!$K$26:$K$33</c:f>
              <c:numCache>
                <c:formatCode>0.00</c:formatCode>
                <c:ptCount val="8"/>
                <c:pt idx="0" formatCode="General">
                  <c:v>1</c:v>
                </c:pt>
                <c:pt idx="1">
                  <c:v>0.35619173793184777</c:v>
                </c:pt>
                <c:pt idx="2">
                  <c:v>0.95473214038608933</c:v>
                </c:pt>
                <c:pt idx="3">
                  <c:v>0.71642281881617376</c:v>
                </c:pt>
                <c:pt idx="4">
                  <c:v>0.78977968861116821</c:v>
                </c:pt>
                <c:pt idx="5">
                  <c:v>0.76129780242127143</c:v>
                </c:pt>
                <c:pt idx="6">
                  <c:v>0.95626056643936408</c:v>
                </c:pt>
                <c:pt idx="7">
                  <c:v>0.811218685736495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6A-44D5-8589-EC0FB76820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93149344"/>
        <c:axId val="350516688"/>
      </c:barChart>
      <c:catAx>
        <c:axId val="193149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50516688"/>
        <c:crosses val="autoZero"/>
        <c:auto val="1"/>
        <c:lblAlgn val="ctr"/>
        <c:lblOffset val="100"/>
        <c:noMultiLvlLbl val="0"/>
      </c:catAx>
      <c:valAx>
        <c:axId val="3505166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314934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64171329087436"/>
          <c:y val="0.17473350233403184"/>
          <c:w val="0.70825711500252597"/>
          <c:h val="0.3354145787219902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L$57:$L$62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7</c:v>
                  </c:pt>
                  <c:pt idx="2">
                    <c:v>0.2</c:v>
                  </c:pt>
                  <c:pt idx="3">
                    <c:v>0.4</c:v>
                  </c:pt>
                  <c:pt idx="4">
                    <c:v>0.04</c:v>
                  </c:pt>
                  <c:pt idx="5">
                    <c:v>0.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26:$L$31</c:f>
              <c:strCache>
                <c:ptCount val="6"/>
                <c:pt idx="0">
                  <c:v>Control</c:v>
                </c:pt>
                <c:pt idx="1">
                  <c:v>CK</c:v>
                </c:pt>
                <c:pt idx="2">
                  <c:v>NAD25nM</c:v>
                </c:pt>
                <c:pt idx="3">
                  <c:v>NAD25nM +CK</c:v>
                </c:pt>
                <c:pt idx="4">
                  <c:v>NAD50nM</c:v>
                </c:pt>
                <c:pt idx="5">
                  <c:v>NAD50nM +CK</c:v>
                </c:pt>
              </c:strCache>
            </c:strRef>
          </c:cat>
          <c:val>
            <c:numRef>
              <c:f>Sheet1!$N$26:$N$31</c:f>
              <c:numCache>
                <c:formatCode>0.00</c:formatCode>
                <c:ptCount val="6"/>
                <c:pt idx="0" formatCode="General">
                  <c:v>1</c:v>
                </c:pt>
                <c:pt idx="1">
                  <c:v>8.436919638047371</c:v>
                </c:pt>
                <c:pt idx="2">
                  <c:v>1.3531042919818528</c:v>
                </c:pt>
                <c:pt idx="3">
                  <c:v>2.0997067052826792</c:v>
                </c:pt>
                <c:pt idx="4">
                  <c:v>0.4383802372405049</c:v>
                </c:pt>
                <c:pt idx="5">
                  <c:v>1.0944384992249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AB-46E2-B8F0-F096A191B7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68024640"/>
        <c:axId val="327098400"/>
      </c:barChart>
      <c:catAx>
        <c:axId val="468024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27098400"/>
        <c:crosses val="autoZero"/>
        <c:auto val="1"/>
        <c:lblAlgn val="ctr"/>
        <c:lblOffset val="100"/>
        <c:noMultiLvlLbl val="0"/>
      </c:catAx>
      <c:valAx>
        <c:axId val="327098400"/>
        <c:scaling>
          <c:orientation val="minMax"/>
          <c:max val="1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6802464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ko-K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6654803821649"/>
          <c:y val="0.14280614715209389"/>
          <c:w val="0.70821894161352028"/>
          <c:h val="0.333351506348223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N$56:$N$6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7</c:v>
                  </c:pt>
                  <c:pt idx="2">
                    <c:v>0.2</c:v>
                  </c:pt>
                  <c:pt idx="3">
                    <c:v>0.8</c:v>
                  </c:pt>
                  <c:pt idx="4">
                    <c:v>0.6</c:v>
                  </c:pt>
                  <c:pt idx="5">
                    <c:v>1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26:$L$31</c:f>
              <c:strCache>
                <c:ptCount val="6"/>
                <c:pt idx="0">
                  <c:v>Control</c:v>
                </c:pt>
                <c:pt idx="1">
                  <c:v>CK</c:v>
                </c:pt>
                <c:pt idx="2">
                  <c:v>NAD25nM</c:v>
                </c:pt>
                <c:pt idx="3">
                  <c:v>NAD25nM +CK</c:v>
                </c:pt>
                <c:pt idx="4">
                  <c:v>NAD50nM</c:v>
                </c:pt>
                <c:pt idx="5">
                  <c:v>NAD50nM +CK</c:v>
                </c:pt>
              </c:strCache>
            </c:strRef>
          </c:cat>
          <c:val>
            <c:numRef>
              <c:f>Sheet1!$P$26:$P$31</c:f>
              <c:numCache>
                <c:formatCode>0.00</c:formatCode>
                <c:ptCount val="6"/>
                <c:pt idx="0" formatCode="General">
                  <c:v>1</c:v>
                </c:pt>
                <c:pt idx="1">
                  <c:v>2.9955784923553592</c:v>
                </c:pt>
                <c:pt idx="2">
                  <c:v>4.7125431438379062</c:v>
                </c:pt>
                <c:pt idx="3">
                  <c:v>6.4544688304900379</c:v>
                </c:pt>
                <c:pt idx="4">
                  <c:v>4.8760423975024834</c:v>
                </c:pt>
                <c:pt idx="5">
                  <c:v>13.8000386116748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B5-4CCF-971E-00B57266C2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0"/>
        <c:overlap val="-27"/>
        <c:axId val="485413968"/>
        <c:axId val="352070624"/>
      </c:barChart>
      <c:catAx>
        <c:axId val="485413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52070624"/>
        <c:crosses val="autoZero"/>
        <c:auto val="1"/>
        <c:lblAlgn val="ctr"/>
        <c:lblOffset val="100"/>
        <c:noMultiLvlLbl val="0"/>
      </c:catAx>
      <c:valAx>
        <c:axId val="352070624"/>
        <c:scaling>
          <c:orientation val="minMax"/>
          <c:max val="16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85413968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ko-K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7285699478285"/>
          <c:y val="5.1967117508652995E-2"/>
          <c:w val="0.70101079900340513"/>
          <c:h val="0.482515255858227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Z$35:$Z$4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</c:v>
                  </c:pt>
                  <c:pt idx="2">
                    <c:v>0.2</c:v>
                  </c:pt>
                  <c:pt idx="3">
                    <c:v>0.3</c:v>
                  </c:pt>
                  <c:pt idx="4">
                    <c:v>0.1</c:v>
                  </c:pt>
                  <c:pt idx="5">
                    <c:v>0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26:$L$31</c:f>
              <c:strCache>
                <c:ptCount val="6"/>
                <c:pt idx="0">
                  <c:v>Control</c:v>
                </c:pt>
                <c:pt idx="1">
                  <c:v>CK</c:v>
                </c:pt>
                <c:pt idx="2">
                  <c:v>NAD25nM</c:v>
                </c:pt>
                <c:pt idx="3">
                  <c:v>NAD25nM +CK</c:v>
                </c:pt>
                <c:pt idx="4">
                  <c:v>NAD50nM</c:v>
                </c:pt>
                <c:pt idx="5">
                  <c:v>NAD50nM +CK</c:v>
                </c:pt>
              </c:strCache>
            </c:strRef>
          </c:cat>
          <c:val>
            <c:numRef>
              <c:f>Sheet1!$R$26:$R$31</c:f>
              <c:numCache>
                <c:formatCode>0.00</c:formatCode>
                <c:ptCount val="6"/>
                <c:pt idx="0" formatCode="General">
                  <c:v>1</c:v>
                </c:pt>
                <c:pt idx="1">
                  <c:v>0.60470543474129634</c:v>
                </c:pt>
                <c:pt idx="2">
                  <c:v>1.08669942957229</c:v>
                </c:pt>
                <c:pt idx="3">
                  <c:v>1.4175525491879084</c:v>
                </c:pt>
                <c:pt idx="4">
                  <c:v>1.5329264826052804</c:v>
                </c:pt>
                <c:pt idx="5">
                  <c:v>1.37421243522905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8A-46CE-BA0E-66FFF1B956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0"/>
        <c:overlap val="-27"/>
        <c:axId val="498890672"/>
        <c:axId val="327138336"/>
      </c:barChart>
      <c:catAx>
        <c:axId val="498890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27138336"/>
        <c:crosses val="autoZero"/>
        <c:auto val="1"/>
        <c:lblAlgn val="ctr"/>
        <c:lblOffset val="100"/>
        <c:noMultiLvlLbl val="0"/>
      </c:catAx>
      <c:valAx>
        <c:axId val="3271383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98890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39838729354169"/>
          <c:y val="8.4281364007637277E-2"/>
          <c:w val="0.70864793177677121"/>
          <c:h val="0.44121659088961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28BA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V$36:$V$41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.2</c:v>
                  </c:pt>
                  <c:pt idx="2">
                    <c:v>0.2</c:v>
                  </c:pt>
                  <c:pt idx="3">
                    <c:v>0.3</c:v>
                  </c:pt>
                  <c:pt idx="4">
                    <c:v>0.1</c:v>
                  </c:pt>
                  <c:pt idx="5">
                    <c:v>0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31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26:$L$31</c:f>
              <c:strCache>
                <c:ptCount val="6"/>
                <c:pt idx="0">
                  <c:v>Control</c:v>
                </c:pt>
                <c:pt idx="1">
                  <c:v>CK</c:v>
                </c:pt>
                <c:pt idx="2">
                  <c:v>NAD25nM</c:v>
                </c:pt>
                <c:pt idx="3">
                  <c:v>NAD25nM +CK</c:v>
                </c:pt>
                <c:pt idx="4">
                  <c:v>NAD50nM</c:v>
                </c:pt>
                <c:pt idx="5">
                  <c:v>NAD50nM +CK</c:v>
                </c:pt>
              </c:strCache>
            </c:strRef>
          </c:cat>
          <c:val>
            <c:numRef>
              <c:f>Sheet1!$T$26:$T$31</c:f>
              <c:numCache>
                <c:formatCode>0.00</c:formatCode>
                <c:ptCount val="6"/>
                <c:pt idx="0" formatCode="General">
                  <c:v>1</c:v>
                </c:pt>
                <c:pt idx="1">
                  <c:v>11.522052633365744</c:v>
                </c:pt>
                <c:pt idx="2">
                  <c:v>1.0168246572949253</c:v>
                </c:pt>
                <c:pt idx="3">
                  <c:v>2.449641035578312</c:v>
                </c:pt>
                <c:pt idx="4">
                  <c:v>1.3936650151111796</c:v>
                </c:pt>
                <c:pt idx="5">
                  <c:v>2.49898781988953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73-440F-9A51-CB610CC5C6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548356880"/>
        <c:axId val="327136672"/>
      </c:barChart>
      <c:catAx>
        <c:axId val="5483568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27136672"/>
        <c:crosses val="autoZero"/>
        <c:auto val="1"/>
        <c:lblAlgn val="ctr"/>
        <c:lblOffset val="100"/>
        <c:noMultiLvlLbl val="0"/>
      </c:catAx>
      <c:valAx>
        <c:axId val="3271366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54835688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1</cdr:x>
      <cdr:y>0.5142</cdr:y>
    </cdr:from>
    <cdr:to>
      <cdr:x>1</cdr:x>
      <cdr:y>1</cdr:y>
    </cdr:to>
    <cdr:cxnSp macro="">
      <cdr:nvCxnSpPr>
        <cdr:cNvPr id="2" name="직선 연결선 1">
          <a:extLst xmlns:a="http://schemas.openxmlformats.org/drawingml/2006/main">
            <a:ext uri="{FF2B5EF4-FFF2-40B4-BE49-F238E27FC236}">
              <a16:creationId xmlns:a16="http://schemas.microsoft.com/office/drawing/2014/main" id="{142E5EBE-D16D-40C6-B2EF-1D07B6583A79}"/>
            </a:ext>
          </a:extLst>
        </cdr:cNvPr>
        <cdr:cNvCxnSpPr/>
      </cdr:nvCxnSpPr>
      <cdr:spPr>
        <a:xfrm xmlns:a="http://schemas.openxmlformats.org/drawingml/2006/main">
          <a:off x="5027900" y="6692839"/>
          <a:ext cx="0" cy="90000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accent2"/>
        </a:lnRef>
        <a:fillRef xmlns:a="http://schemas.openxmlformats.org/drawingml/2006/main" idx="0">
          <a:schemeClr val="accent2"/>
        </a:fillRef>
        <a:effectRef xmlns:a="http://schemas.openxmlformats.org/drawingml/2006/main" idx="0">
          <a:schemeClr val="accent2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15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662"/>
            </a:lvl1pPr>
            <a:lvl2pPr marL="316520" indent="0" algn="ctr">
              <a:buNone/>
              <a:defRPr sz="1385"/>
            </a:lvl2pPr>
            <a:lvl3pPr marL="633039" indent="0" algn="ctr">
              <a:buNone/>
              <a:defRPr sz="1246"/>
            </a:lvl3pPr>
            <a:lvl4pPr marL="949559" indent="0" algn="ctr">
              <a:buNone/>
              <a:defRPr sz="1108"/>
            </a:lvl4pPr>
            <a:lvl5pPr marL="1266078" indent="0" algn="ctr">
              <a:buNone/>
              <a:defRPr sz="1108"/>
            </a:lvl5pPr>
            <a:lvl6pPr marL="1582598" indent="0" algn="ctr">
              <a:buNone/>
              <a:defRPr sz="1108"/>
            </a:lvl6pPr>
            <a:lvl7pPr marL="1899117" indent="0" algn="ctr">
              <a:buNone/>
              <a:defRPr sz="1108"/>
            </a:lvl7pPr>
            <a:lvl8pPr marL="2215637" indent="0" algn="ctr">
              <a:buNone/>
              <a:defRPr sz="1108"/>
            </a:lvl8pPr>
            <a:lvl9pPr marL="2532156" indent="0" algn="ctr">
              <a:buNone/>
              <a:defRPr sz="1108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4402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3293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5904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3083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15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662">
                <a:solidFill>
                  <a:schemeClr val="tx1"/>
                </a:solidFill>
              </a:defRPr>
            </a:lvl1pPr>
            <a:lvl2pPr marL="31652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2pPr>
            <a:lvl3pPr marL="633039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3pPr>
            <a:lvl4pPr marL="949559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4pPr>
            <a:lvl5pPr marL="126607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5pPr>
            <a:lvl6pPr marL="158259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6pPr>
            <a:lvl7pPr marL="189911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7pPr>
            <a:lvl8pPr marL="221563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8pPr>
            <a:lvl9pPr marL="2532156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3051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4433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7256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40252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891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4"/>
            <a:ext cx="3471863" cy="7039681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145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4"/>
            <a:ext cx="3471863" cy="7039681"/>
          </a:xfrm>
        </p:spPr>
        <p:txBody>
          <a:bodyPr anchor="t"/>
          <a:lstStyle>
            <a:lvl1pPr marL="0" indent="0">
              <a:buNone/>
              <a:defRPr sz="2215"/>
            </a:lvl1pPr>
            <a:lvl2pPr marL="316520" indent="0">
              <a:buNone/>
              <a:defRPr sz="1938"/>
            </a:lvl2pPr>
            <a:lvl3pPr marL="633039" indent="0">
              <a:buNone/>
              <a:defRPr sz="1662"/>
            </a:lvl3pPr>
            <a:lvl4pPr marL="949559" indent="0">
              <a:buNone/>
              <a:defRPr sz="1385"/>
            </a:lvl4pPr>
            <a:lvl5pPr marL="1266078" indent="0">
              <a:buNone/>
              <a:defRPr sz="1385"/>
            </a:lvl5pPr>
            <a:lvl6pPr marL="1582598" indent="0">
              <a:buNone/>
              <a:defRPr sz="1385"/>
            </a:lvl6pPr>
            <a:lvl7pPr marL="1899117" indent="0">
              <a:buNone/>
              <a:defRPr sz="1385"/>
            </a:lvl7pPr>
            <a:lvl8pPr marL="2215637" indent="0">
              <a:buNone/>
              <a:defRPr sz="1385"/>
            </a:lvl8pPr>
            <a:lvl9pPr marL="2532156" indent="0">
              <a:buNone/>
              <a:defRPr sz="1385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058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7D152-CA62-43DF-A566-4A491C2FF0FE}" type="datetimeFigureOut">
              <a:rPr lang="ko-KR" altLang="en-US" smtClean="0"/>
              <a:t>2025-01-2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580C3-F65D-4342-A186-4188A08312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9390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33039" rtl="0" eaLnBrk="1" latinLnBrk="1" hangingPunct="1">
        <a:lnSpc>
          <a:spcPct val="90000"/>
        </a:lnSpc>
        <a:spcBef>
          <a:spcPct val="0"/>
        </a:spcBef>
        <a:buNone/>
        <a:defRPr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260" indent="-158260" algn="l" defTabSz="633039" rtl="0" eaLnBrk="1" latinLnBrk="1" hangingPunct="1">
        <a:lnSpc>
          <a:spcPct val="90000"/>
        </a:lnSpc>
        <a:spcBef>
          <a:spcPts val="692"/>
        </a:spcBef>
        <a:buFont typeface="Arial" panose="020B0604020202020204" pitchFamily="34" charset="0"/>
        <a:buChar char="•"/>
        <a:defRPr sz="1938" kern="1200">
          <a:solidFill>
            <a:schemeClr val="tx1"/>
          </a:solidFill>
          <a:latin typeface="+mn-lt"/>
          <a:ea typeface="+mn-ea"/>
          <a:cs typeface="+mn-cs"/>
        </a:defRPr>
      </a:lvl1pPr>
      <a:lvl2pPr marL="474779" indent="-158260" algn="l" defTabSz="633039" rtl="0" eaLnBrk="1" latinLnBrk="1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791299" indent="-158260" algn="l" defTabSz="633039" rtl="0" eaLnBrk="1" latinLnBrk="1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3pPr>
      <a:lvl4pPr marL="1107818" indent="-158260" algn="l" defTabSz="633039" rtl="0" eaLnBrk="1" latinLnBrk="1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424338" indent="-158260" algn="l" defTabSz="633039" rtl="0" eaLnBrk="1" latinLnBrk="1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740858" indent="-158260" algn="l" defTabSz="633039" rtl="0" eaLnBrk="1" latinLnBrk="1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2057377" indent="-158260" algn="l" defTabSz="633039" rtl="0" eaLnBrk="1" latinLnBrk="1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373897" indent="-158260" algn="l" defTabSz="633039" rtl="0" eaLnBrk="1" latinLnBrk="1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690416" indent="-158260" algn="l" defTabSz="633039" rtl="0" eaLnBrk="1" latinLnBrk="1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20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39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59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078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598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17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637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156" algn="l" defTabSz="633039" rtl="0" eaLnBrk="1" latinLnBrk="1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microsoft.com/office/2007/relationships/hdphoto" Target="../media/hdphoto1.wdp"/><Relationship Id="rId5" Type="http://schemas.openxmlformats.org/officeDocument/2006/relationships/image" Target="../media/image4.emf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3" Type="http://schemas.openxmlformats.org/officeDocument/2006/relationships/image" Target="../media/image13.emf"/><Relationship Id="rId7" Type="http://schemas.openxmlformats.org/officeDocument/2006/relationships/image" Target="../media/image16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microsoft.com/office/2007/relationships/hdphoto" Target="../media/hdphoto3.wdp"/><Relationship Id="rId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19.emf"/><Relationship Id="rId7" Type="http://schemas.openxmlformats.org/officeDocument/2006/relationships/image" Target="../media/image23.png"/><Relationship Id="rId12" Type="http://schemas.openxmlformats.org/officeDocument/2006/relationships/image" Target="../media/image27.emf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emf"/><Relationship Id="rId11" Type="http://schemas.openxmlformats.org/officeDocument/2006/relationships/image" Target="../media/image26.emf"/><Relationship Id="rId5" Type="http://schemas.openxmlformats.org/officeDocument/2006/relationships/image" Target="../media/image21.png"/><Relationship Id="rId10" Type="http://schemas.openxmlformats.org/officeDocument/2006/relationships/image" Target="../media/image25.png"/><Relationship Id="rId4" Type="http://schemas.openxmlformats.org/officeDocument/2006/relationships/image" Target="../media/image20.emf"/><Relationship Id="rId9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microsoft.com/office/2007/relationships/hdphoto" Target="../media/hdphoto5.wdp"/><Relationship Id="rId7" Type="http://schemas.microsoft.com/office/2007/relationships/hdphoto" Target="../media/hdphoto6.wdp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11" Type="http://schemas.openxmlformats.org/officeDocument/2006/relationships/image" Target="../media/image34.png"/><Relationship Id="rId5" Type="http://schemas.openxmlformats.org/officeDocument/2006/relationships/image" Target="../media/image30.png"/><Relationship Id="rId10" Type="http://schemas.openxmlformats.org/officeDocument/2006/relationships/image" Target="../media/image33.emf"/><Relationship Id="rId4" Type="http://schemas.openxmlformats.org/officeDocument/2006/relationships/image" Target="../media/image29.emf"/><Relationship Id="rId9" Type="http://schemas.microsoft.com/office/2007/relationships/hdphoto" Target="../media/hdphoto7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8.xml"/><Relationship Id="rId3" Type="http://schemas.openxmlformats.org/officeDocument/2006/relationships/image" Target="../media/image47.png"/><Relationship Id="rId7" Type="http://schemas.openxmlformats.org/officeDocument/2006/relationships/chart" Target="../charts/chart17.xml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6.xml"/><Relationship Id="rId5" Type="http://schemas.openxmlformats.org/officeDocument/2006/relationships/chart" Target="../charts/chart15.xml"/><Relationship Id="rId4" Type="http://schemas.openxmlformats.org/officeDocument/2006/relationships/image" Target="../media/image4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9D8C3EBF-0E42-4152-B010-6247B37FE629}"/>
              </a:ext>
            </a:extLst>
          </p:cNvPr>
          <p:cNvSpPr txBox="1"/>
          <p:nvPr/>
        </p:nvSpPr>
        <p:spPr>
          <a:xfrm>
            <a:off x="2411589" y="1674980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" name="그룹 18">
            <a:extLst>
              <a:ext uri="{FF2B5EF4-FFF2-40B4-BE49-F238E27FC236}">
                <a16:creationId xmlns:a16="http://schemas.microsoft.com/office/drawing/2014/main" id="{EC63E3D5-9ED2-42E9-AD57-508F2FA3A9B1}"/>
              </a:ext>
            </a:extLst>
          </p:cNvPr>
          <p:cNvGrpSpPr/>
          <p:nvPr/>
        </p:nvGrpSpPr>
        <p:grpSpPr>
          <a:xfrm>
            <a:off x="2005194" y="2310289"/>
            <a:ext cx="2085877" cy="3264920"/>
            <a:chOff x="2005194" y="2310289"/>
            <a:chExt cx="2085877" cy="3264920"/>
          </a:xfrm>
        </p:grpSpPr>
        <p:sp>
          <p:nvSpPr>
            <p:cNvPr id="7" name="직사각형 6">
              <a:extLst>
                <a:ext uri="{FF2B5EF4-FFF2-40B4-BE49-F238E27FC236}">
                  <a16:creationId xmlns:a16="http://schemas.microsoft.com/office/drawing/2014/main" id="{B4DAC1E1-B205-4F2D-90CA-7AC1C688AA32}"/>
                </a:ext>
              </a:extLst>
            </p:cNvPr>
            <p:cNvSpPr/>
            <p:nvPr/>
          </p:nvSpPr>
          <p:spPr>
            <a:xfrm>
              <a:off x="2871871" y="2310289"/>
              <a:ext cx="121920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12   24   36  48   (h)  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A0716F0-8472-4921-9DF3-DDC6BDAF8A41}"/>
                </a:ext>
              </a:extLst>
            </p:cNvPr>
            <p:cNvSpPr txBox="1"/>
            <p:nvPr/>
          </p:nvSpPr>
          <p:spPr>
            <a:xfrm>
              <a:off x="2005194" y="2641885"/>
              <a:ext cx="8627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ADP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ribose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53">
              <a:extLst>
                <a:ext uri="{FF2B5EF4-FFF2-40B4-BE49-F238E27FC236}">
                  <a16:creationId xmlns:a16="http://schemas.microsoft.com/office/drawing/2014/main" id="{2BD6B374-7FDF-4022-A1B0-4742ABDA3EB4}"/>
                </a:ext>
              </a:extLst>
            </p:cNvPr>
            <p:cNvSpPr txBox="1"/>
            <p:nvPr/>
          </p:nvSpPr>
          <p:spPr>
            <a:xfrm>
              <a:off x="2367328" y="5359765"/>
              <a:ext cx="5031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actin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16572B1-3647-429D-8388-650CC8A30F84}"/>
                </a:ext>
              </a:extLst>
            </p:cNvPr>
            <p:cNvSpPr txBox="1"/>
            <p:nvPr/>
          </p:nvSpPr>
          <p:spPr>
            <a:xfrm>
              <a:off x="2295000" y="4191470"/>
              <a:ext cx="5533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3K9Ac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91C7183-5811-4451-970B-27866532E2FF}"/>
                </a:ext>
              </a:extLst>
            </p:cNvPr>
            <p:cNvSpPr txBox="1"/>
            <p:nvPr/>
          </p:nvSpPr>
          <p:spPr>
            <a:xfrm>
              <a:off x="2132456" y="3506437"/>
              <a:ext cx="7232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caspase-8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E9E5B97-DDA5-4F02-875F-98D5E5894B13}"/>
                </a:ext>
              </a:extLst>
            </p:cNvPr>
            <p:cNvSpPr txBox="1"/>
            <p:nvPr/>
          </p:nvSpPr>
          <p:spPr>
            <a:xfrm>
              <a:off x="2463315" y="3957883"/>
              <a:ext cx="3850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t6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4120A19-5E82-4A59-9678-A0CBA7F3252E}"/>
                </a:ext>
              </a:extLst>
            </p:cNvPr>
            <p:cNvSpPr txBox="1"/>
            <p:nvPr/>
          </p:nvSpPr>
          <p:spPr>
            <a:xfrm>
              <a:off x="2125083" y="3718132"/>
              <a:ext cx="7232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caspase-3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C624A44-E5D9-4881-8E9A-2B5CDC78B654}"/>
                </a:ext>
              </a:extLst>
            </p:cNvPr>
            <p:cNvSpPr txBox="1"/>
            <p:nvPr/>
          </p:nvSpPr>
          <p:spPr>
            <a:xfrm>
              <a:off x="2509803" y="439863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62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E0A7009-7F66-4341-B89E-6E9D16C5CCC4}"/>
                </a:ext>
              </a:extLst>
            </p:cNvPr>
            <p:cNvSpPr txBox="1"/>
            <p:nvPr/>
          </p:nvSpPr>
          <p:spPr>
            <a:xfrm>
              <a:off x="2328022" y="3133075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RP-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E86A163-917B-4293-BC61-7A89097D2DB1}"/>
                </a:ext>
              </a:extLst>
            </p:cNvPr>
            <p:cNvSpPr txBox="1"/>
            <p:nvPr/>
          </p:nvSpPr>
          <p:spPr>
            <a:xfrm>
              <a:off x="2453377" y="4935983"/>
              <a:ext cx="4171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-1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53">
              <a:extLst>
                <a:ext uri="{FF2B5EF4-FFF2-40B4-BE49-F238E27FC236}">
                  <a16:creationId xmlns:a16="http://schemas.microsoft.com/office/drawing/2014/main" id="{5741803A-64E7-4337-8FB9-A76358D698D6}"/>
                </a:ext>
              </a:extLst>
            </p:cNvPr>
            <p:cNvSpPr txBox="1"/>
            <p:nvPr/>
          </p:nvSpPr>
          <p:spPr>
            <a:xfrm>
              <a:off x="2427551" y="5158509"/>
              <a:ext cx="4429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D2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왼쪽 대괄호 17">
              <a:extLst>
                <a:ext uri="{FF2B5EF4-FFF2-40B4-BE49-F238E27FC236}">
                  <a16:creationId xmlns:a16="http://schemas.microsoft.com/office/drawing/2014/main" id="{AECEF3C2-2E73-48D0-BF40-FF13119DE3AD}"/>
                </a:ext>
              </a:extLst>
            </p:cNvPr>
            <p:cNvSpPr/>
            <p:nvPr/>
          </p:nvSpPr>
          <p:spPr>
            <a:xfrm>
              <a:off x="2796855" y="2587179"/>
              <a:ext cx="45719" cy="360000"/>
            </a:xfrm>
            <a:prstGeom prst="leftBracket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" name="직선 연결선 3">
              <a:extLst>
                <a:ext uri="{FF2B5EF4-FFF2-40B4-BE49-F238E27FC236}">
                  <a16:creationId xmlns:a16="http://schemas.microsoft.com/office/drawing/2014/main" id="{07D59597-8608-499E-9650-F9BA8458D9D3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2731987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직선 연결선 4">
              <a:extLst>
                <a:ext uri="{FF2B5EF4-FFF2-40B4-BE49-F238E27FC236}">
                  <a16:creationId xmlns:a16="http://schemas.microsoft.com/office/drawing/2014/main" id="{798A0161-BB34-420B-B5FF-7E07F87A9422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2808187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직선 연결선 5">
              <a:extLst>
                <a:ext uri="{FF2B5EF4-FFF2-40B4-BE49-F238E27FC236}">
                  <a16:creationId xmlns:a16="http://schemas.microsoft.com/office/drawing/2014/main" id="{66A226A1-4FEA-4EAD-A4E5-BAE8E8397AD1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2951062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BCD20C0F-2919-4F64-9FD1-C19EB14AEF52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4447050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29">
              <a:extLst>
                <a:ext uri="{FF2B5EF4-FFF2-40B4-BE49-F238E27FC236}">
                  <a16:creationId xmlns:a16="http://schemas.microsoft.com/office/drawing/2014/main" id="{E15D279D-FA59-4F12-8639-D1CE6F1040BF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3121171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직선 연결선 30">
              <a:extLst>
                <a:ext uri="{FF2B5EF4-FFF2-40B4-BE49-F238E27FC236}">
                  <a16:creationId xmlns:a16="http://schemas.microsoft.com/office/drawing/2014/main" id="{079B479D-2998-443D-894F-2C51DD92228A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3206896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>
              <a:extLst>
                <a:ext uri="{FF2B5EF4-FFF2-40B4-BE49-F238E27FC236}">
                  <a16:creationId xmlns:a16="http://schemas.microsoft.com/office/drawing/2014/main" id="{59C7A344-3FCD-474F-90DF-9EE4591FA130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3353152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직선 연결선 48">
              <a:extLst>
                <a:ext uri="{FF2B5EF4-FFF2-40B4-BE49-F238E27FC236}">
                  <a16:creationId xmlns:a16="http://schemas.microsoft.com/office/drawing/2014/main" id="{8A6F89BE-B9CF-446D-9C76-BC02161DD566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3564544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직선 연결선 49">
              <a:extLst>
                <a:ext uri="{FF2B5EF4-FFF2-40B4-BE49-F238E27FC236}">
                  <a16:creationId xmlns:a16="http://schemas.microsoft.com/office/drawing/2014/main" id="{05BA293E-AD83-42E4-B393-8AC20FE503BA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3800517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연결선 50">
              <a:extLst>
                <a:ext uri="{FF2B5EF4-FFF2-40B4-BE49-F238E27FC236}">
                  <a16:creationId xmlns:a16="http://schemas.microsoft.com/office/drawing/2014/main" id="{31676BB3-5623-457F-AF79-42DE10EDEBFA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4058615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6B6DFF1A-4286-45A0-8AC3-643181A74D79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4289367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91DF4976-9F4E-4461-9650-D5E407DD1AD0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4724809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연결선 53">
              <a:extLst>
                <a:ext uri="{FF2B5EF4-FFF2-40B4-BE49-F238E27FC236}">
                  <a16:creationId xmlns:a16="http://schemas.microsoft.com/office/drawing/2014/main" id="{64624D43-E2A9-47FB-9EE9-BF01D739878F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4968159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AA979CE4-FE8B-4E9A-89C6-CB25C757ADB6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5196758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DD64BD50-1FB2-4CBB-9E59-A169280E8223}"/>
                </a:ext>
              </a:extLst>
            </p:cNvPr>
            <p:cNvCxnSpPr>
              <a:cxnSpLocks/>
            </p:cNvCxnSpPr>
            <p:nvPr/>
          </p:nvCxnSpPr>
          <p:spPr>
            <a:xfrm>
              <a:off x="3706151" y="5464382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3F7FF3CE-BF71-43A5-AF17-F3CA657C87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0970" r="4016" b="43032"/>
            <a:stretch/>
          </p:blipFill>
          <p:spPr>
            <a:xfrm>
              <a:off x="2828993" y="2522707"/>
              <a:ext cx="972000" cy="53187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A55CA0E5-515C-4501-8741-99885562F8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825" t="27592" r="4107" b="28590"/>
            <a:stretch/>
          </p:blipFill>
          <p:spPr>
            <a:xfrm>
              <a:off x="2828993" y="5404899"/>
              <a:ext cx="972000" cy="16642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2" name="그림 11">
              <a:extLst>
                <a:ext uri="{FF2B5EF4-FFF2-40B4-BE49-F238E27FC236}">
                  <a16:creationId xmlns:a16="http://schemas.microsoft.com/office/drawing/2014/main" id="{A8365130-9C97-4339-9AAA-0D78C15F77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667" t="27101" r="2722" b="27376"/>
            <a:stretch/>
          </p:blipFill>
          <p:spPr>
            <a:xfrm>
              <a:off x="2828993" y="4201875"/>
              <a:ext cx="972000" cy="18291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5DF97296-B3DA-4D9E-8C8B-67C3C2EB49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621" t="15693" r="4917" b="18219"/>
            <a:stretch/>
          </p:blipFill>
          <p:spPr>
            <a:xfrm>
              <a:off x="2828993" y="3531171"/>
              <a:ext cx="972000" cy="17507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569C7C09-3F18-4F17-99B9-A1B39883C6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279" t="15291" r="3697" b="23150"/>
            <a:stretch/>
          </p:blipFill>
          <p:spPr>
            <a:xfrm>
              <a:off x="2828993" y="3727330"/>
              <a:ext cx="972000" cy="20001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4" name="그림 23">
              <a:extLst>
                <a:ext uri="{FF2B5EF4-FFF2-40B4-BE49-F238E27FC236}">
                  <a16:creationId xmlns:a16="http://schemas.microsoft.com/office/drawing/2014/main" id="{909F27BA-BF5D-4C54-98D8-AE9B945A86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9474" t="30085" r="16051" b="30387"/>
            <a:stretch/>
          </p:blipFill>
          <p:spPr>
            <a:xfrm>
              <a:off x="2828993" y="4647679"/>
              <a:ext cx="972000" cy="27514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6" name="그림 25">
              <a:extLst>
                <a:ext uri="{FF2B5EF4-FFF2-40B4-BE49-F238E27FC236}">
                  <a16:creationId xmlns:a16="http://schemas.microsoft.com/office/drawing/2014/main" id="{FCB3C6FF-2301-4BFF-AE7D-BF20EED744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294" t="24582" r="6706" b="22948"/>
            <a:stretch/>
          </p:blipFill>
          <p:spPr>
            <a:xfrm>
              <a:off x="2828993" y="4411022"/>
              <a:ext cx="972000" cy="21106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7" name="그림 26">
              <a:extLst>
                <a:ext uri="{FF2B5EF4-FFF2-40B4-BE49-F238E27FC236}">
                  <a16:creationId xmlns:a16="http://schemas.microsoft.com/office/drawing/2014/main" id="{4E587F9E-B995-492D-9B39-E6D47F953F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lum bright="3000" contrast="15000"/>
            </a:blip>
            <a:srcRect l="4115" t="22892" r="4872" b="19210"/>
            <a:stretch/>
          </p:blipFill>
          <p:spPr>
            <a:xfrm>
              <a:off x="2828993" y="3949001"/>
              <a:ext cx="972000" cy="219605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9" name="그림 28">
              <a:extLst>
                <a:ext uri="{FF2B5EF4-FFF2-40B4-BE49-F238E27FC236}">
                  <a16:creationId xmlns:a16="http://schemas.microsoft.com/office/drawing/2014/main" id="{A51E1DB3-ED30-401A-8D38-D27AD9C5FA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10" t="35609" r="23923" b="34340"/>
            <a:stretch/>
          </p:blipFill>
          <p:spPr>
            <a:xfrm>
              <a:off x="2828993" y="3089248"/>
              <a:ext cx="972000" cy="42019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8" name="그림 37">
              <a:extLst>
                <a:ext uri="{FF2B5EF4-FFF2-40B4-BE49-F238E27FC236}">
                  <a16:creationId xmlns:a16="http://schemas.microsoft.com/office/drawing/2014/main" id="{590C02AD-F1FD-46B8-BBD1-915A91D037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407" t="26223" r="16709" b="23958"/>
            <a:stretch/>
          </p:blipFill>
          <p:spPr>
            <a:xfrm>
              <a:off x="2828993" y="5173523"/>
              <a:ext cx="972000" cy="1969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9" name="그림 38">
              <a:extLst>
                <a:ext uri="{FF2B5EF4-FFF2-40B4-BE49-F238E27FC236}">
                  <a16:creationId xmlns:a16="http://schemas.microsoft.com/office/drawing/2014/main" id="{21FD24BF-2CBD-4CDC-843D-A3F0440E7F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575" t="18738" b="13648"/>
            <a:stretch/>
          </p:blipFill>
          <p:spPr>
            <a:xfrm>
              <a:off x="2828993" y="4948414"/>
              <a:ext cx="972000" cy="19693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8E79D36-9137-4B04-81A4-B7E3A4603CB9}"/>
                </a:ext>
              </a:extLst>
            </p:cNvPr>
            <p:cNvSpPr txBox="1"/>
            <p:nvPr/>
          </p:nvSpPr>
          <p:spPr>
            <a:xfrm>
              <a:off x="2296236" y="4623781"/>
              <a:ext cx="478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LC3-I</a:t>
              </a:r>
            </a:p>
          </p:txBody>
        </p:sp>
        <p:sp>
          <p:nvSpPr>
            <p:cNvPr id="42" name="Rectangle 1">
              <a:extLst>
                <a:ext uri="{FF2B5EF4-FFF2-40B4-BE49-F238E27FC236}">
                  <a16:creationId xmlns:a16="http://schemas.microsoft.com/office/drawing/2014/main" id="{BF8CA3D9-890D-4F39-9E92-30646244845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V="1">
              <a:off x="2616886" y="4611901"/>
              <a:ext cx="303793" cy="1923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ffectLst/>
          </p:spPr>
          <p:txBody>
            <a:bodyPr vert="horz" wrap="squar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6858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ko-KR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Arial Unicode MS" pitchFamily="50" charset="-127"/>
                  <a:cs typeface="Times New Roman" pitchFamily="18" charset="0"/>
                </a:rPr>
                <a:t>→</a:t>
              </a:r>
              <a:endParaRPr kumimoji="1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3" name="Rectangle 1">
              <a:extLst>
                <a:ext uri="{FF2B5EF4-FFF2-40B4-BE49-F238E27FC236}">
                  <a16:creationId xmlns:a16="http://schemas.microsoft.com/office/drawing/2014/main" id="{007AC123-677B-4EDC-8F74-70BAA830B28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V="1">
              <a:off x="2616876" y="4742404"/>
              <a:ext cx="303793" cy="1923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ffectLst/>
          </p:spPr>
          <p:txBody>
            <a:bodyPr vert="horz" wrap="squar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6858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ko-KR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Arial Unicode MS" pitchFamily="50" charset="-127"/>
                  <a:cs typeface="Times New Roman" pitchFamily="18" charset="0"/>
                </a:rPr>
                <a:t>→</a:t>
              </a:r>
              <a:endParaRPr kumimoji="1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9216EB1-AEB4-4463-8DD0-ED5F35EA85C8}"/>
                </a:ext>
              </a:extLst>
            </p:cNvPr>
            <p:cNvSpPr txBox="1"/>
            <p:nvPr/>
          </p:nvSpPr>
          <p:spPr>
            <a:xfrm>
              <a:off x="2436964" y="4755439"/>
              <a:ext cx="3813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II</a:t>
              </a:r>
            </a:p>
          </p:txBody>
        </p:sp>
        <p:sp>
          <p:nvSpPr>
            <p:cNvPr id="46" name="Rectangle 1">
              <a:extLst>
                <a:ext uri="{FF2B5EF4-FFF2-40B4-BE49-F238E27FC236}">
                  <a16:creationId xmlns:a16="http://schemas.microsoft.com/office/drawing/2014/main" id="{E0EF26DC-7118-4DEB-89F2-B9065691E29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V="1">
              <a:off x="2623952" y="3291613"/>
              <a:ext cx="303793" cy="1923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ffectLst/>
          </p:spPr>
          <p:txBody>
            <a:bodyPr vert="horz" wrap="squar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6858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ko-KR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Arial Unicode MS" pitchFamily="50" charset="-127"/>
                  <a:cs typeface="Times New Roman" pitchFamily="18" charset="0"/>
                </a:rPr>
                <a:t>→</a:t>
              </a:r>
              <a:endParaRPr kumimoji="1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C927617-7179-44DF-A466-7FA33462505E}"/>
                </a:ext>
              </a:extLst>
            </p:cNvPr>
            <p:cNvSpPr txBox="1"/>
            <p:nvPr/>
          </p:nvSpPr>
          <p:spPr>
            <a:xfrm>
              <a:off x="2315710" y="3286784"/>
              <a:ext cx="4459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9 </a:t>
              </a:r>
              <a:r>
                <a:rPr lang="en-US" altLang="ko-KR" sz="7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endParaRPr lang="ko-KR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CAADDD2-72D4-4041-991B-BCED2C500AFA}"/>
                </a:ext>
              </a:extLst>
            </p:cNvPr>
            <p:cNvSpPr txBox="1"/>
            <p:nvPr/>
          </p:nvSpPr>
          <p:spPr>
            <a:xfrm>
              <a:off x="2546673" y="2318365"/>
              <a:ext cx="327334" cy="2867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K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ED623A1-6344-4F0D-BEC7-FED173E662AC}"/>
                </a:ext>
              </a:extLst>
            </p:cNvPr>
            <p:cNvSpPr txBox="1"/>
            <p:nvPr/>
          </p:nvSpPr>
          <p:spPr>
            <a:xfrm>
              <a:off x="3779120" y="2649143"/>
              <a:ext cx="290464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70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96720AA-504E-44FB-98CE-AD26A50CB81D}"/>
                </a:ext>
              </a:extLst>
            </p:cNvPr>
            <p:cNvSpPr txBox="1"/>
            <p:nvPr/>
          </p:nvSpPr>
          <p:spPr>
            <a:xfrm>
              <a:off x="3779120" y="2732140"/>
              <a:ext cx="290464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30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28ADF76D-0F1E-44D1-860A-2575CDDFACE3}"/>
                </a:ext>
              </a:extLst>
            </p:cNvPr>
            <p:cNvSpPr txBox="1"/>
            <p:nvPr/>
          </p:nvSpPr>
          <p:spPr>
            <a:xfrm>
              <a:off x="3779120" y="2866294"/>
              <a:ext cx="290464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00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281C077-0252-4AAD-A48A-88D6E91945A2}"/>
                </a:ext>
              </a:extLst>
            </p:cNvPr>
            <p:cNvSpPr txBox="1"/>
            <p:nvPr/>
          </p:nvSpPr>
          <p:spPr>
            <a:xfrm>
              <a:off x="3779120" y="3483233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70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001940A-C0C6-4F2D-AE81-0F5997B07934}"/>
                </a:ext>
              </a:extLst>
            </p:cNvPr>
            <p:cNvSpPr txBox="1"/>
            <p:nvPr/>
          </p:nvSpPr>
          <p:spPr>
            <a:xfrm>
              <a:off x="3779120" y="3713675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550" dirty="0">
                  <a:solidFill>
                    <a:prstClr val="black"/>
                  </a:solidFill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35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378B638-2FDB-4043-AAF0-12BBE7B67ECC}"/>
                </a:ext>
              </a:extLst>
            </p:cNvPr>
            <p:cNvSpPr txBox="1"/>
            <p:nvPr/>
          </p:nvSpPr>
          <p:spPr>
            <a:xfrm>
              <a:off x="3779120" y="3976299"/>
              <a:ext cx="255198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45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4E0D577-BF85-4408-9558-CD593B9B0486}"/>
                </a:ext>
              </a:extLst>
            </p:cNvPr>
            <p:cNvSpPr txBox="1"/>
            <p:nvPr/>
          </p:nvSpPr>
          <p:spPr>
            <a:xfrm>
              <a:off x="3779120" y="3039668"/>
              <a:ext cx="290464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70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A627306-519F-4804-9485-AB2F30D2DE37}"/>
                </a:ext>
              </a:extLst>
            </p:cNvPr>
            <p:cNvSpPr txBox="1"/>
            <p:nvPr/>
          </p:nvSpPr>
          <p:spPr>
            <a:xfrm>
              <a:off x="3779120" y="3122665"/>
              <a:ext cx="290464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30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39AA913-E3D9-462A-B73F-74615D7A87AA}"/>
                </a:ext>
              </a:extLst>
            </p:cNvPr>
            <p:cNvSpPr txBox="1"/>
            <p:nvPr/>
          </p:nvSpPr>
          <p:spPr>
            <a:xfrm>
              <a:off x="3779120" y="3271567"/>
              <a:ext cx="290464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00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F4B03FF0-4CB1-45B9-A58B-FB92A25293B3}"/>
                </a:ext>
              </a:extLst>
            </p:cNvPr>
            <p:cNvSpPr txBox="1"/>
            <p:nvPr/>
          </p:nvSpPr>
          <p:spPr>
            <a:xfrm>
              <a:off x="3779120" y="4198219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5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8CD529B8-7074-4AA9-A123-AF3F185E0E80}"/>
                </a:ext>
              </a:extLst>
            </p:cNvPr>
            <p:cNvSpPr txBox="1"/>
            <p:nvPr/>
          </p:nvSpPr>
          <p:spPr>
            <a:xfrm>
              <a:off x="3779120" y="4354921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70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C911AB12-D20B-4B8C-84B1-6F5E49818AC4}"/>
                </a:ext>
              </a:extLst>
            </p:cNvPr>
            <p:cNvSpPr txBox="1"/>
            <p:nvPr/>
          </p:nvSpPr>
          <p:spPr>
            <a:xfrm>
              <a:off x="3779120" y="4639667"/>
              <a:ext cx="255198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5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9BEDB2F-C775-404E-AF20-20F9F03F6802}"/>
                </a:ext>
              </a:extLst>
            </p:cNvPr>
            <p:cNvSpPr txBox="1"/>
            <p:nvPr/>
          </p:nvSpPr>
          <p:spPr>
            <a:xfrm>
              <a:off x="3779120" y="4888933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35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ACD749A8-8012-4EDC-B3CA-FA23D225B049}"/>
                </a:ext>
              </a:extLst>
            </p:cNvPr>
            <p:cNvSpPr txBox="1"/>
            <p:nvPr/>
          </p:nvSpPr>
          <p:spPr>
            <a:xfrm>
              <a:off x="3779120" y="5112001"/>
              <a:ext cx="255198" cy="1769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550" dirty="0">
                  <a:solidFill>
                    <a:prstClr val="black"/>
                  </a:solidFill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25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B65A26C-E6D2-41E9-ABFF-7064ECB60C5D}"/>
                </a:ext>
              </a:extLst>
            </p:cNvPr>
            <p:cNvSpPr txBox="1"/>
            <p:nvPr/>
          </p:nvSpPr>
          <p:spPr>
            <a:xfrm>
              <a:off x="3779120" y="5384150"/>
              <a:ext cx="255198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55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45</a:t>
              </a:r>
              <a:endParaRPr kumimoji="0" lang="ko-KR" altLang="en-US" sz="5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CE31060-D65A-4133-9259-383314A76BDB}"/>
              </a:ext>
            </a:extLst>
          </p:cNvPr>
          <p:cNvSpPr txBox="1"/>
          <p:nvPr/>
        </p:nvSpPr>
        <p:spPr>
          <a:xfrm>
            <a:off x="2005193" y="6114239"/>
            <a:ext cx="318095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460 cells were exposed to CK (35 µg/ml) for up to 48 h, harvested, lysed, and the levels of the indicated proteins were assessed by immunoblotting. β-actin was used as the loading control. n &gt; 3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7994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B19FDF48-44E1-4839-B2DF-BA3E533E5C30}"/>
              </a:ext>
            </a:extLst>
          </p:cNvPr>
          <p:cNvGrpSpPr/>
          <p:nvPr/>
        </p:nvGrpSpPr>
        <p:grpSpPr>
          <a:xfrm>
            <a:off x="2337295" y="2452808"/>
            <a:ext cx="1850848" cy="1890616"/>
            <a:chOff x="2442070" y="2452808"/>
            <a:chExt cx="1850848" cy="189061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34C91A9-5656-4409-A0B1-463521568952}"/>
                </a:ext>
              </a:extLst>
            </p:cNvPr>
            <p:cNvSpPr txBox="1"/>
            <p:nvPr/>
          </p:nvSpPr>
          <p:spPr>
            <a:xfrm>
              <a:off x="2668224" y="315401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62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28C3E5F-A993-4B2D-A242-BD6CA636337F}"/>
                </a:ext>
              </a:extLst>
            </p:cNvPr>
            <p:cNvSpPr txBox="1"/>
            <p:nvPr/>
          </p:nvSpPr>
          <p:spPr>
            <a:xfrm>
              <a:off x="2442200" y="3883200"/>
              <a:ext cx="5645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-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2CE72CC-D846-448F-BB8D-C59FA938955F}"/>
                </a:ext>
              </a:extLst>
            </p:cNvPr>
            <p:cNvSpPr txBox="1"/>
            <p:nvPr/>
          </p:nvSpPr>
          <p:spPr>
            <a:xfrm>
              <a:off x="2565632" y="3635440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D2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21CD93B-5451-4627-8C4C-624ACAAEB027}"/>
                </a:ext>
              </a:extLst>
            </p:cNvPr>
            <p:cNvSpPr txBox="1"/>
            <p:nvPr/>
          </p:nvSpPr>
          <p:spPr>
            <a:xfrm>
              <a:off x="3014295" y="2621496"/>
              <a:ext cx="10156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+     -    +    -     + 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A1EEC47-9965-4929-B95B-0674FC5E799D}"/>
                </a:ext>
              </a:extLst>
            </p:cNvPr>
            <p:cNvSpPr txBox="1"/>
            <p:nvPr/>
          </p:nvSpPr>
          <p:spPr>
            <a:xfrm>
              <a:off x="3375452" y="2452808"/>
              <a:ext cx="35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D92FA4DF-95FD-4830-ABAF-66F52A72CE16}"/>
                </a:ext>
              </a:extLst>
            </p:cNvPr>
            <p:cNvSpPr txBox="1"/>
            <p:nvPr/>
          </p:nvSpPr>
          <p:spPr>
            <a:xfrm>
              <a:off x="3684323" y="2452808"/>
              <a:ext cx="35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0" name="직선 연결선 39">
              <a:extLst>
                <a:ext uri="{FF2B5EF4-FFF2-40B4-BE49-F238E27FC236}">
                  <a16:creationId xmlns:a16="http://schemas.microsoft.com/office/drawing/2014/main" id="{A54AB38D-EEBD-4DEC-8E50-BECC3541A5F5}"/>
                </a:ext>
              </a:extLst>
            </p:cNvPr>
            <p:cNvCxnSpPr/>
            <p:nvPr/>
          </p:nvCxnSpPr>
          <p:spPr>
            <a:xfrm>
              <a:off x="3410261" y="2651023"/>
              <a:ext cx="216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B3DCD93F-1829-4BC2-B3B9-268388FFEA58}"/>
                </a:ext>
              </a:extLst>
            </p:cNvPr>
            <p:cNvCxnSpPr/>
            <p:nvPr/>
          </p:nvCxnSpPr>
          <p:spPr>
            <a:xfrm>
              <a:off x="3728366" y="2651023"/>
              <a:ext cx="216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DD2F821-2D1F-41F0-ABE5-F59BA76B57EF}"/>
                </a:ext>
              </a:extLst>
            </p:cNvPr>
            <p:cNvSpPr txBox="1"/>
            <p:nvPr/>
          </p:nvSpPr>
          <p:spPr>
            <a:xfrm>
              <a:off x="2690608" y="2624860"/>
              <a:ext cx="3994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K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27D57FF-EFEA-4862-9B56-CFDE54AA23EB}"/>
                </a:ext>
              </a:extLst>
            </p:cNvPr>
            <p:cNvSpPr txBox="1"/>
            <p:nvPr/>
          </p:nvSpPr>
          <p:spPr>
            <a:xfrm>
              <a:off x="4031308" y="3579937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ko-KR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2623D84-98A8-495C-842B-1DE5F8E07B48}"/>
                </a:ext>
              </a:extLst>
            </p:cNvPr>
            <p:cNvSpPr txBox="1"/>
            <p:nvPr/>
          </p:nvSpPr>
          <p:spPr>
            <a:xfrm>
              <a:off x="4031308" y="3858233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ko-KR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2206A0D-1DEA-4D13-9F00-461049665E2F}"/>
                </a:ext>
              </a:extLst>
            </p:cNvPr>
            <p:cNvSpPr txBox="1"/>
            <p:nvPr/>
          </p:nvSpPr>
          <p:spPr>
            <a:xfrm>
              <a:off x="4031308" y="2860476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ko-KR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2CB822D-A8F0-4985-9328-0F87D3A75359}"/>
                </a:ext>
              </a:extLst>
            </p:cNvPr>
            <p:cNvSpPr txBox="1"/>
            <p:nvPr/>
          </p:nvSpPr>
          <p:spPr>
            <a:xfrm>
              <a:off x="4031308" y="3116856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lang="ko-KR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0D9C49A-5DC8-42A7-9CB3-84FF19F9F944}"/>
                </a:ext>
              </a:extLst>
            </p:cNvPr>
            <p:cNvSpPr txBox="1"/>
            <p:nvPr/>
          </p:nvSpPr>
          <p:spPr>
            <a:xfrm>
              <a:off x="2636257" y="3386036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iX</a:t>
              </a:r>
              <a:endPara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id="{27BE5E20-CB7E-4DCC-BBD4-2B1A2E6AC9E6}"/>
                </a:ext>
              </a:extLst>
            </p:cNvPr>
            <p:cNvCxnSpPr>
              <a:cxnSpLocks/>
            </p:cNvCxnSpPr>
            <p:nvPr/>
          </p:nvCxnSpPr>
          <p:spPr>
            <a:xfrm>
              <a:off x="3979001" y="3552834"/>
              <a:ext cx="1234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03BC1371-E9A9-431C-93EA-0463AEE3A8B5}"/>
                </a:ext>
              </a:extLst>
            </p:cNvPr>
            <p:cNvCxnSpPr>
              <a:cxnSpLocks/>
            </p:cNvCxnSpPr>
            <p:nvPr/>
          </p:nvCxnSpPr>
          <p:spPr>
            <a:xfrm>
              <a:off x="3979001" y="3209560"/>
              <a:ext cx="1234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76910030-A400-4355-9B85-FFFD1A709C2E}"/>
                </a:ext>
              </a:extLst>
            </p:cNvPr>
            <p:cNvCxnSpPr>
              <a:cxnSpLocks/>
            </p:cNvCxnSpPr>
            <p:nvPr/>
          </p:nvCxnSpPr>
          <p:spPr>
            <a:xfrm>
              <a:off x="3979001" y="3679633"/>
              <a:ext cx="1234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직선 연결선 28">
              <a:extLst>
                <a:ext uri="{FF2B5EF4-FFF2-40B4-BE49-F238E27FC236}">
                  <a16:creationId xmlns:a16="http://schemas.microsoft.com/office/drawing/2014/main" id="{6562C47E-F1E1-49A2-AF2C-1BFF5FFC62CF}"/>
                </a:ext>
              </a:extLst>
            </p:cNvPr>
            <p:cNvCxnSpPr>
              <a:cxnSpLocks/>
            </p:cNvCxnSpPr>
            <p:nvPr/>
          </p:nvCxnSpPr>
          <p:spPr>
            <a:xfrm>
              <a:off x="3979001" y="3948403"/>
              <a:ext cx="1234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직선 연결선 29">
              <a:extLst>
                <a:ext uri="{FF2B5EF4-FFF2-40B4-BE49-F238E27FC236}">
                  <a16:creationId xmlns:a16="http://schemas.microsoft.com/office/drawing/2014/main" id="{5D32A633-B08F-4E36-919C-292D6D648CD9}"/>
                </a:ext>
              </a:extLst>
            </p:cNvPr>
            <p:cNvCxnSpPr>
              <a:cxnSpLocks/>
            </p:cNvCxnSpPr>
            <p:nvPr/>
          </p:nvCxnSpPr>
          <p:spPr>
            <a:xfrm>
              <a:off x="3979001" y="2953443"/>
              <a:ext cx="1234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8FB7839A-3760-4559-A894-59DFDCB97EAB}"/>
                </a:ext>
              </a:extLst>
            </p:cNvPr>
            <p:cNvCxnSpPr>
              <a:cxnSpLocks/>
            </p:cNvCxnSpPr>
            <p:nvPr/>
          </p:nvCxnSpPr>
          <p:spPr>
            <a:xfrm>
              <a:off x="3979001" y="4210063"/>
              <a:ext cx="123434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7E5F86FD-5845-4B3E-B4BF-45964B7F71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215" t="22753" r="3227" b="23316"/>
            <a:stretch/>
          </p:blipFill>
          <p:spPr>
            <a:xfrm>
              <a:off x="2967749" y="3173860"/>
              <a:ext cx="1080000" cy="205705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85062975-7CFD-487C-960B-D47E85E3FF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158" t="22302" r="4166" b="30849"/>
            <a:stretch/>
          </p:blipFill>
          <p:spPr>
            <a:xfrm>
              <a:off x="2967749" y="3900476"/>
              <a:ext cx="1080000" cy="19526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" name="그림 13">
              <a:extLst>
                <a:ext uri="{FF2B5EF4-FFF2-40B4-BE49-F238E27FC236}">
                  <a16:creationId xmlns:a16="http://schemas.microsoft.com/office/drawing/2014/main" id="{E2D4FE53-E35F-4C14-ABC5-8AB55AEE4B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50" t="39070" r="21931" b="39178"/>
            <a:stretch/>
          </p:blipFill>
          <p:spPr>
            <a:xfrm>
              <a:off x="2967749" y="3635754"/>
              <a:ext cx="1080000" cy="23324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D08D573F-1B45-483A-86D9-2E1BCC0E2B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783" r="4949" b="8742"/>
            <a:stretch/>
          </p:blipFill>
          <p:spPr>
            <a:xfrm>
              <a:off x="2967749" y="2816810"/>
              <a:ext cx="1080000" cy="323327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4" name="그림 53">
              <a:extLst>
                <a:ext uri="{FF2B5EF4-FFF2-40B4-BE49-F238E27FC236}">
                  <a16:creationId xmlns:a16="http://schemas.microsoft.com/office/drawing/2014/main" id="{25E145D5-6140-4673-9206-DBD26EDC9B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225" t="15363" r="3225" b="18049"/>
            <a:stretch/>
          </p:blipFill>
          <p:spPr>
            <a:xfrm>
              <a:off x="2967749" y="4122413"/>
              <a:ext cx="1080000" cy="22101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0" name="그림 59">
              <a:extLst>
                <a:ext uri="{FF2B5EF4-FFF2-40B4-BE49-F238E27FC236}">
                  <a16:creationId xmlns:a16="http://schemas.microsoft.com/office/drawing/2014/main" id="{4B4C6234-AE2C-44FB-8418-959405A143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185" t="18102" r="2602" b="21712"/>
            <a:stretch/>
          </p:blipFill>
          <p:spPr>
            <a:xfrm>
              <a:off x="2967749" y="3405612"/>
              <a:ext cx="1080000" cy="20908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64" name="TextBox 53">
              <a:extLst>
                <a:ext uri="{FF2B5EF4-FFF2-40B4-BE49-F238E27FC236}">
                  <a16:creationId xmlns:a16="http://schemas.microsoft.com/office/drawing/2014/main" id="{0A000AEC-8F69-461E-A0B1-A489510FE83B}"/>
                </a:ext>
              </a:extLst>
            </p:cNvPr>
            <p:cNvSpPr txBox="1"/>
            <p:nvPr/>
          </p:nvSpPr>
          <p:spPr>
            <a:xfrm>
              <a:off x="2502436" y="4109746"/>
              <a:ext cx="532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actin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B46BE19D-D7EB-4B88-86F3-FACCFE8195A5}"/>
                </a:ext>
              </a:extLst>
            </p:cNvPr>
            <p:cNvSpPr txBox="1"/>
            <p:nvPr/>
          </p:nvSpPr>
          <p:spPr>
            <a:xfrm>
              <a:off x="2442070" y="2804452"/>
              <a:ext cx="478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C3-I</a:t>
              </a:r>
            </a:p>
          </p:txBody>
        </p:sp>
        <p:sp>
          <p:nvSpPr>
            <p:cNvPr id="66" name="Rectangle 1">
              <a:extLst>
                <a:ext uri="{FF2B5EF4-FFF2-40B4-BE49-F238E27FC236}">
                  <a16:creationId xmlns:a16="http://schemas.microsoft.com/office/drawing/2014/main" id="{161DEF9A-E428-4125-BD52-ACCE6EAE067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V="1">
              <a:off x="2769663" y="2809009"/>
              <a:ext cx="303793" cy="1923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ffectLst/>
          </p:spPr>
          <p:txBody>
            <a:bodyPr vert="horz" wrap="squar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6858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ko-KR" altLang="ko-KR" sz="800" dirty="0">
                  <a:latin typeface="Times New Roman" panose="02020603050405020304" pitchFamily="18" charset="0"/>
                  <a:ea typeface="Arial Unicode MS" pitchFamily="50" charset="-127"/>
                  <a:cs typeface="Times New Roman" pitchFamily="18" charset="0"/>
                </a:rPr>
                <a:t>→</a:t>
              </a:r>
              <a:endParaRPr kumimoji="1" lang="ko-KR" altLang="ko-KR" sz="800" dirty="0">
                <a:latin typeface="Times New Roman" panose="02020603050405020304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7" name="Rectangle 1">
              <a:extLst>
                <a:ext uri="{FF2B5EF4-FFF2-40B4-BE49-F238E27FC236}">
                  <a16:creationId xmlns:a16="http://schemas.microsoft.com/office/drawing/2014/main" id="{9E3A7E33-3A66-45C9-82B8-112470FD367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V="1">
              <a:off x="2769663" y="2928067"/>
              <a:ext cx="303793" cy="1923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ffectLst/>
          </p:spPr>
          <p:txBody>
            <a:bodyPr vert="horz" wrap="squar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6858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ko-KR" altLang="ko-KR" sz="800" dirty="0">
                  <a:latin typeface="Times New Roman" panose="02020603050405020304" pitchFamily="18" charset="0"/>
                  <a:ea typeface="Arial Unicode MS" pitchFamily="50" charset="-127"/>
                  <a:cs typeface="Times New Roman" pitchFamily="18" charset="0"/>
                </a:rPr>
                <a:t>→</a:t>
              </a:r>
              <a:endParaRPr kumimoji="1" lang="ko-KR" altLang="ko-KR" sz="800" dirty="0">
                <a:latin typeface="Times New Roman" panose="02020603050405020304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FDDDCD20-C246-48ED-B135-6FFF1B3C3C06}"/>
                </a:ext>
              </a:extLst>
            </p:cNvPr>
            <p:cNvSpPr txBox="1"/>
            <p:nvPr/>
          </p:nvSpPr>
          <p:spPr>
            <a:xfrm>
              <a:off x="2577813" y="2923510"/>
              <a:ext cx="3813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I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85AAFDC-E0C8-4DAD-BDAC-7FF8166E4964}"/>
                </a:ext>
              </a:extLst>
            </p:cNvPr>
            <p:cNvSpPr txBox="1"/>
            <p:nvPr/>
          </p:nvSpPr>
          <p:spPr>
            <a:xfrm>
              <a:off x="4031308" y="3455001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ko-KR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457A058B-768F-4AEC-8DEB-E62DF8930D97}"/>
                </a:ext>
              </a:extLst>
            </p:cNvPr>
            <p:cNvSpPr txBox="1"/>
            <p:nvPr/>
          </p:nvSpPr>
          <p:spPr>
            <a:xfrm>
              <a:off x="4031308" y="4116989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5</a:t>
              </a:r>
              <a:endParaRPr lang="ko-KR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055543F9-4335-4912-A58A-7540CBF30252}"/>
              </a:ext>
            </a:extLst>
          </p:cNvPr>
          <p:cNvSpPr txBox="1"/>
          <p:nvPr/>
        </p:nvSpPr>
        <p:spPr>
          <a:xfrm>
            <a:off x="1848149" y="4953000"/>
            <a:ext cx="345727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460 cells were exposed to CK for 18 h with pretreatment with increasing concentrations of NAD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25 and 50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levels of indicated proteins were analyzed by immunoblotting (n&gt;3)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35E35B1-EA83-4CB1-A2D1-207C2BDD6778}"/>
              </a:ext>
            </a:extLst>
          </p:cNvPr>
          <p:cNvSpPr txBox="1"/>
          <p:nvPr/>
        </p:nvSpPr>
        <p:spPr>
          <a:xfrm>
            <a:off x="2411589" y="1674980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79EAE438-A25C-48B0-8737-ECABE570B595}"/>
              </a:ext>
            </a:extLst>
          </p:cNvPr>
          <p:cNvCxnSpPr/>
          <p:nvPr/>
        </p:nvCxnSpPr>
        <p:spPr>
          <a:xfrm>
            <a:off x="3311433" y="2442756"/>
            <a:ext cx="540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7614DAA1-87B9-40F7-826C-84443903AA2F}"/>
              </a:ext>
            </a:extLst>
          </p:cNvPr>
          <p:cNvSpPr txBox="1"/>
          <p:nvPr/>
        </p:nvSpPr>
        <p:spPr>
          <a:xfrm>
            <a:off x="3214045" y="2207622"/>
            <a:ext cx="7665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D</a:t>
            </a:r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43794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100">
            <a:extLst>
              <a:ext uri="{FF2B5EF4-FFF2-40B4-BE49-F238E27FC236}">
                <a16:creationId xmlns:a16="http://schemas.microsoft.com/office/drawing/2014/main" id="{315F4417-A335-4977-B8CA-E5EFFCE3EEA5}"/>
              </a:ext>
            </a:extLst>
          </p:cNvPr>
          <p:cNvSpPr txBox="1"/>
          <p:nvPr/>
        </p:nvSpPr>
        <p:spPr>
          <a:xfrm>
            <a:off x="1259206" y="5302054"/>
            <a:ext cx="449389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H460 cells silenced with the NC or </a:t>
            </a:r>
            <a:r>
              <a:rPr lang="en-US" altLang="ko-K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6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RNA were exposed to CK for 3 h and 18 h, respectively. (B) After 24 h of transfection with empty vector or pcDNA3.1-Sirt6, The levels of the indicated proteins were analyzed by immunoblotting (n = 3). 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036C818-7384-4579-8A88-2F8CB958EB49}"/>
              </a:ext>
            </a:extLst>
          </p:cNvPr>
          <p:cNvSpPr txBox="1"/>
          <p:nvPr/>
        </p:nvSpPr>
        <p:spPr>
          <a:xfrm>
            <a:off x="2515729" y="252412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98E5CF1-0B08-4D01-9838-837F08D20340}"/>
              </a:ext>
            </a:extLst>
          </p:cNvPr>
          <p:cNvSpPr txBox="1"/>
          <p:nvPr/>
        </p:nvSpPr>
        <p:spPr>
          <a:xfrm>
            <a:off x="4525504" y="252412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TextBox 47">
            <a:extLst>
              <a:ext uri="{FF2B5EF4-FFF2-40B4-BE49-F238E27FC236}">
                <a16:creationId xmlns:a16="http://schemas.microsoft.com/office/drawing/2014/main" id="{8AB4463F-B2B5-48CD-8B8E-E68E4E15740E}"/>
              </a:ext>
            </a:extLst>
          </p:cNvPr>
          <p:cNvSpPr txBox="1"/>
          <p:nvPr/>
        </p:nvSpPr>
        <p:spPr>
          <a:xfrm>
            <a:off x="3312965" y="3480646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70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TextBox 47">
            <a:extLst>
              <a:ext uri="{FF2B5EF4-FFF2-40B4-BE49-F238E27FC236}">
                <a16:creationId xmlns:a16="http://schemas.microsoft.com/office/drawing/2014/main" id="{4CBF04B8-45DF-4E11-8EEF-D3E0685EC956}"/>
              </a:ext>
            </a:extLst>
          </p:cNvPr>
          <p:cNvSpPr txBox="1"/>
          <p:nvPr/>
        </p:nvSpPr>
        <p:spPr>
          <a:xfrm>
            <a:off x="3312965" y="3823546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15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9" name="TextBox 47">
            <a:extLst>
              <a:ext uri="{FF2B5EF4-FFF2-40B4-BE49-F238E27FC236}">
                <a16:creationId xmlns:a16="http://schemas.microsoft.com/office/drawing/2014/main" id="{10055979-4C3A-45D2-9FBA-4D36366C0357}"/>
              </a:ext>
            </a:extLst>
          </p:cNvPr>
          <p:cNvSpPr txBox="1"/>
          <p:nvPr/>
        </p:nvSpPr>
        <p:spPr>
          <a:xfrm>
            <a:off x="3312965" y="4661746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45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9C7F01D-DD2E-4135-8C5B-5281111B75B9}"/>
              </a:ext>
            </a:extLst>
          </p:cNvPr>
          <p:cNvSpPr txBox="1"/>
          <p:nvPr/>
        </p:nvSpPr>
        <p:spPr>
          <a:xfrm>
            <a:off x="1543042" y="3151818"/>
            <a:ext cx="18458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Times New Roman" pitchFamily="18" charset="0"/>
                <a:cs typeface="Times New Roman" pitchFamily="18" charset="0"/>
              </a:rPr>
              <a:t>               </a:t>
            </a:r>
          </a:p>
          <a:p>
            <a:r>
              <a:rPr lang="en-US" altLang="ko-KR" sz="800" dirty="0">
                <a:latin typeface="Times New Roman" pitchFamily="18" charset="0"/>
                <a:cs typeface="Times New Roman" pitchFamily="18" charset="0"/>
              </a:rPr>
              <a:t>CK        -    +    -     +        +    -    +     -      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A832279-86BC-4FFE-818C-7DB46A8DD46F}"/>
              </a:ext>
            </a:extLst>
          </p:cNvPr>
          <p:cNvSpPr txBox="1"/>
          <p:nvPr/>
        </p:nvSpPr>
        <p:spPr>
          <a:xfrm>
            <a:off x="1962939" y="3097210"/>
            <a:ext cx="874636" cy="182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800" dirty="0">
                <a:latin typeface="Times New Roman" pitchFamily="18" charset="0"/>
                <a:cs typeface="Times New Roman" pitchFamily="18" charset="0"/>
              </a:rPr>
              <a:t> Sirt6 siRNA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" name="직선 연결선 3">
            <a:extLst>
              <a:ext uri="{FF2B5EF4-FFF2-40B4-BE49-F238E27FC236}">
                <a16:creationId xmlns:a16="http://schemas.microsoft.com/office/drawing/2014/main" id="{2034835A-203D-4B4D-B187-C0AADD928D7E}"/>
              </a:ext>
            </a:extLst>
          </p:cNvPr>
          <p:cNvCxnSpPr/>
          <p:nvPr/>
        </p:nvCxnSpPr>
        <p:spPr>
          <a:xfrm>
            <a:off x="2227729" y="3279907"/>
            <a:ext cx="28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직선 연결선 4">
            <a:extLst>
              <a:ext uri="{FF2B5EF4-FFF2-40B4-BE49-F238E27FC236}">
                <a16:creationId xmlns:a16="http://schemas.microsoft.com/office/drawing/2014/main" id="{54089D6F-F0AA-4A22-8404-7BC001FB0405}"/>
              </a:ext>
            </a:extLst>
          </p:cNvPr>
          <p:cNvCxnSpPr/>
          <p:nvPr/>
        </p:nvCxnSpPr>
        <p:spPr>
          <a:xfrm>
            <a:off x="2941490" y="3279907"/>
            <a:ext cx="28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직선 연결선 5">
            <a:extLst>
              <a:ext uri="{FF2B5EF4-FFF2-40B4-BE49-F238E27FC236}">
                <a16:creationId xmlns:a16="http://schemas.microsoft.com/office/drawing/2014/main" id="{A03E6239-65F3-4868-8F98-46F236A8052B}"/>
              </a:ext>
            </a:extLst>
          </p:cNvPr>
          <p:cNvCxnSpPr/>
          <p:nvPr/>
        </p:nvCxnSpPr>
        <p:spPr>
          <a:xfrm>
            <a:off x="1904498" y="3061667"/>
            <a:ext cx="612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D9974AB0-71A2-4117-A705-CFDAA9F1C135}"/>
              </a:ext>
            </a:extLst>
          </p:cNvPr>
          <p:cNvCxnSpPr/>
          <p:nvPr/>
        </p:nvCxnSpPr>
        <p:spPr>
          <a:xfrm>
            <a:off x="2639386" y="3061667"/>
            <a:ext cx="612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66F3C76E-ACC9-4183-AD1E-59513B52A1FA}"/>
              </a:ext>
            </a:extLst>
          </p:cNvPr>
          <p:cNvSpPr txBox="1"/>
          <p:nvPr/>
        </p:nvSpPr>
        <p:spPr>
          <a:xfrm>
            <a:off x="2079790" y="2852461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h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3C2A61-D6D6-4FC7-819A-81F4E6F48A80}"/>
              </a:ext>
            </a:extLst>
          </p:cNvPr>
          <p:cNvSpPr txBox="1"/>
          <p:nvPr/>
        </p:nvSpPr>
        <p:spPr>
          <a:xfrm>
            <a:off x="2782408" y="2846165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 h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166975-E56B-43F6-A6D4-C29D60746432}"/>
              </a:ext>
            </a:extLst>
          </p:cNvPr>
          <p:cNvSpPr txBox="1"/>
          <p:nvPr/>
        </p:nvSpPr>
        <p:spPr>
          <a:xfrm>
            <a:off x="2696364" y="3106735"/>
            <a:ext cx="816146" cy="182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00"/>
              </a:lnSpc>
            </a:pPr>
            <a:r>
              <a:rPr lang="en-US" altLang="ko-KR" sz="800" dirty="0">
                <a:latin typeface="Times New Roman" pitchFamily="18" charset="0"/>
                <a:cs typeface="Times New Roman" pitchFamily="18" charset="0"/>
              </a:rPr>
              <a:t> Sirt6 siRNA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2E27736-1FE4-43DA-90C6-A9CEA8F3EBC1}"/>
              </a:ext>
            </a:extLst>
          </p:cNvPr>
          <p:cNvSpPr txBox="1"/>
          <p:nvPr/>
        </p:nvSpPr>
        <p:spPr>
          <a:xfrm>
            <a:off x="1545263" y="348881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</a:p>
        </p:txBody>
      </p:sp>
      <p:sp>
        <p:nvSpPr>
          <p:cNvPr id="78" name="TextBox 53">
            <a:extLst>
              <a:ext uri="{FF2B5EF4-FFF2-40B4-BE49-F238E27FC236}">
                <a16:creationId xmlns:a16="http://schemas.microsoft.com/office/drawing/2014/main" id="{E21DD5B4-D45B-4C1A-B001-EAE3FB5F4C0E}"/>
              </a:ext>
            </a:extLst>
          </p:cNvPr>
          <p:cNvSpPr txBox="1"/>
          <p:nvPr/>
        </p:nvSpPr>
        <p:spPr>
          <a:xfrm>
            <a:off x="1378486" y="4633621"/>
            <a:ext cx="532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ctin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CE73CAF-90E3-4A16-A03E-B87758997C0C}"/>
              </a:ext>
            </a:extLst>
          </p:cNvPr>
          <p:cNvSpPr txBox="1"/>
          <p:nvPr/>
        </p:nvSpPr>
        <p:spPr>
          <a:xfrm>
            <a:off x="1299070" y="3737902"/>
            <a:ext cx="4789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-I</a:t>
            </a:r>
          </a:p>
        </p:txBody>
      </p:sp>
      <p:sp>
        <p:nvSpPr>
          <p:cNvPr id="80" name="Rectangle 1">
            <a:extLst>
              <a:ext uri="{FF2B5EF4-FFF2-40B4-BE49-F238E27FC236}">
                <a16:creationId xmlns:a16="http://schemas.microsoft.com/office/drawing/2014/main" id="{2CE228EC-A099-4BAC-A96D-FDF61DF6C525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1626663" y="3742459"/>
            <a:ext cx="303793" cy="19236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685800" fontAlgn="base">
              <a:spcBef>
                <a:spcPct val="0"/>
              </a:spcBef>
              <a:spcAft>
                <a:spcPct val="0"/>
              </a:spcAft>
            </a:pPr>
            <a:r>
              <a:rPr kumimoji="1" lang="ko-KR" altLang="ko-KR" sz="800" dirty="0">
                <a:latin typeface="Times New Roman" panose="02020603050405020304" pitchFamily="18" charset="0"/>
                <a:ea typeface="Arial Unicode MS" pitchFamily="50" charset="-127"/>
                <a:cs typeface="Times New Roman" pitchFamily="18" charset="0"/>
              </a:rPr>
              <a:t>→</a:t>
            </a:r>
            <a:endParaRPr kumimoji="1" lang="ko-KR" altLang="ko-KR" sz="800" dirty="0">
              <a:latin typeface="Times New Roman" panose="02020603050405020304" pitchFamily="18" charset="0"/>
              <a:ea typeface="굴림" pitchFamily="50" charset="-127"/>
              <a:cs typeface="Times New Roman" pitchFamily="18" charset="0"/>
            </a:endParaRPr>
          </a:p>
        </p:txBody>
      </p:sp>
      <p:sp>
        <p:nvSpPr>
          <p:cNvPr id="81" name="Rectangle 1">
            <a:extLst>
              <a:ext uri="{FF2B5EF4-FFF2-40B4-BE49-F238E27FC236}">
                <a16:creationId xmlns:a16="http://schemas.microsoft.com/office/drawing/2014/main" id="{E6BEFCB7-C647-41E1-A8DB-7CF5C2E0586F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1626663" y="3861517"/>
            <a:ext cx="303793" cy="19236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685800" fontAlgn="base">
              <a:spcBef>
                <a:spcPct val="0"/>
              </a:spcBef>
              <a:spcAft>
                <a:spcPct val="0"/>
              </a:spcAft>
            </a:pPr>
            <a:r>
              <a:rPr kumimoji="1" lang="ko-KR" altLang="ko-KR" sz="800" dirty="0">
                <a:latin typeface="Times New Roman" panose="02020603050405020304" pitchFamily="18" charset="0"/>
                <a:ea typeface="Arial Unicode MS" pitchFamily="50" charset="-127"/>
                <a:cs typeface="Times New Roman" pitchFamily="18" charset="0"/>
              </a:rPr>
              <a:t>→</a:t>
            </a:r>
            <a:endParaRPr kumimoji="1" lang="ko-KR" altLang="ko-KR" sz="800" dirty="0">
              <a:latin typeface="Times New Roman" panose="02020603050405020304" pitchFamily="18" charset="0"/>
              <a:ea typeface="굴림" pitchFamily="50" charset="-127"/>
              <a:cs typeface="Times New Roman" pitchFamily="18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5F50A22-1BB8-4E1A-9A89-7C5B9E49C5EC}"/>
              </a:ext>
            </a:extLst>
          </p:cNvPr>
          <p:cNvSpPr txBox="1"/>
          <p:nvPr/>
        </p:nvSpPr>
        <p:spPr>
          <a:xfrm>
            <a:off x="1434813" y="3856960"/>
            <a:ext cx="3813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88AEC44-7F31-42FC-A386-A8D8E3B22905}"/>
              </a:ext>
            </a:extLst>
          </p:cNvPr>
          <p:cNvSpPr txBox="1"/>
          <p:nvPr/>
        </p:nvSpPr>
        <p:spPr>
          <a:xfrm>
            <a:off x="1475256" y="4139940"/>
            <a:ext cx="4171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-1</a:t>
            </a:r>
          </a:p>
        </p:txBody>
      </p:sp>
      <p:grpSp>
        <p:nvGrpSpPr>
          <p:cNvPr id="120" name="그룹 119">
            <a:extLst>
              <a:ext uri="{FF2B5EF4-FFF2-40B4-BE49-F238E27FC236}">
                <a16:creationId xmlns:a16="http://schemas.microsoft.com/office/drawing/2014/main" id="{E55D0A5F-19B2-4F0C-9982-A71FD0A740CF}"/>
              </a:ext>
            </a:extLst>
          </p:cNvPr>
          <p:cNvGrpSpPr/>
          <p:nvPr/>
        </p:nvGrpSpPr>
        <p:grpSpPr>
          <a:xfrm>
            <a:off x="1855242" y="3482641"/>
            <a:ext cx="1501338" cy="1371035"/>
            <a:chOff x="1931442" y="3692191"/>
            <a:chExt cx="1501338" cy="1371035"/>
          </a:xfrm>
        </p:grpSpPr>
        <p:cxnSp>
          <p:nvCxnSpPr>
            <p:cNvPr id="104" name="직선 연결선 103">
              <a:extLst>
                <a:ext uri="{FF2B5EF4-FFF2-40B4-BE49-F238E27FC236}">
                  <a16:creationId xmlns:a16="http://schemas.microsoft.com/office/drawing/2014/main" id="{52F4866B-A8AC-4053-88E4-ED2FCC78E396}"/>
                </a:ext>
              </a:extLst>
            </p:cNvPr>
            <p:cNvCxnSpPr>
              <a:cxnSpLocks/>
            </p:cNvCxnSpPr>
            <p:nvPr/>
          </p:nvCxnSpPr>
          <p:spPr>
            <a:xfrm>
              <a:off x="3288780" y="3769569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직선 연결선 94">
              <a:extLst>
                <a:ext uri="{FF2B5EF4-FFF2-40B4-BE49-F238E27FC236}">
                  <a16:creationId xmlns:a16="http://schemas.microsoft.com/office/drawing/2014/main" id="{81BC4C58-97F7-4271-8603-0C0BECC6286E}"/>
                </a:ext>
              </a:extLst>
            </p:cNvPr>
            <p:cNvCxnSpPr>
              <a:cxnSpLocks/>
            </p:cNvCxnSpPr>
            <p:nvPr/>
          </p:nvCxnSpPr>
          <p:spPr>
            <a:xfrm>
              <a:off x="3288780" y="4112469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직선 연결선 95">
              <a:extLst>
                <a:ext uri="{FF2B5EF4-FFF2-40B4-BE49-F238E27FC236}">
                  <a16:creationId xmlns:a16="http://schemas.microsoft.com/office/drawing/2014/main" id="{C2DDD6B7-B8A6-49AF-B15E-92F59F20F769}"/>
                </a:ext>
              </a:extLst>
            </p:cNvPr>
            <p:cNvCxnSpPr>
              <a:cxnSpLocks/>
            </p:cNvCxnSpPr>
            <p:nvPr/>
          </p:nvCxnSpPr>
          <p:spPr>
            <a:xfrm>
              <a:off x="3288780" y="4948966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직선 연결선 113">
              <a:extLst>
                <a:ext uri="{FF2B5EF4-FFF2-40B4-BE49-F238E27FC236}">
                  <a16:creationId xmlns:a16="http://schemas.microsoft.com/office/drawing/2014/main" id="{C1F1F404-6230-4D0F-BEAC-09C7E3F0AC84}"/>
                </a:ext>
              </a:extLst>
            </p:cNvPr>
            <p:cNvCxnSpPr>
              <a:cxnSpLocks/>
            </p:cNvCxnSpPr>
            <p:nvPr/>
          </p:nvCxnSpPr>
          <p:spPr>
            <a:xfrm>
              <a:off x="3288780" y="4386991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직선 연결선 115">
              <a:extLst>
                <a:ext uri="{FF2B5EF4-FFF2-40B4-BE49-F238E27FC236}">
                  <a16:creationId xmlns:a16="http://schemas.microsoft.com/office/drawing/2014/main" id="{DFD9F9C1-BFD6-4E24-9671-0A7BF3AFA8A3}"/>
                </a:ext>
              </a:extLst>
            </p:cNvPr>
            <p:cNvCxnSpPr>
              <a:cxnSpLocks/>
            </p:cNvCxnSpPr>
            <p:nvPr/>
          </p:nvCxnSpPr>
          <p:spPr>
            <a:xfrm>
              <a:off x="3288780" y="4625116"/>
              <a:ext cx="144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4" name="그림 43">
              <a:extLst>
                <a:ext uri="{FF2B5EF4-FFF2-40B4-BE49-F238E27FC236}">
                  <a16:creationId xmlns:a16="http://schemas.microsoft.com/office/drawing/2014/main" id="{37C5D0B6-1926-410F-891E-E8CAB1E562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9391" t="29068" r="8596" b="28221"/>
            <a:stretch/>
          </p:blipFill>
          <p:spPr>
            <a:xfrm>
              <a:off x="1935748" y="4848225"/>
              <a:ext cx="1440000" cy="215001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2" name="그림 51">
              <a:extLst>
                <a:ext uri="{FF2B5EF4-FFF2-40B4-BE49-F238E27FC236}">
                  <a16:creationId xmlns:a16="http://schemas.microsoft.com/office/drawing/2014/main" id="{4368D726-7EA2-4892-BFAE-097CCFBA9E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46" t="2229" r="1840" b="7278"/>
            <a:stretch/>
          </p:blipFill>
          <p:spPr>
            <a:xfrm>
              <a:off x="1935748" y="3692191"/>
              <a:ext cx="1440000" cy="2428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9" name="그림 68">
              <a:extLst>
                <a:ext uri="{FF2B5EF4-FFF2-40B4-BE49-F238E27FC236}">
                  <a16:creationId xmlns:a16="http://schemas.microsoft.com/office/drawing/2014/main" id="{C87DDE51-8625-4B8D-9875-E9948EA320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4967" t="17091" r="4231" b="19916"/>
            <a:stretch/>
          </p:blipFill>
          <p:spPr>
            <a:xfrm>
              <a:off x="1935748" y="3969805"/>
              <a:ext cx="1440000" cy="31808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09" name="그림 108">
              <a:extLst>
                <a:ext uri="{FF2B5EF4-FFF2-40B4-BE49-F238E27FC236}">
                  <a16:creationId xmlns:a16="http://schemas.microsoft.com/office/drawing/2014/main" id="{23A5F704-18DA-4EEA-8174-E6FE486440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20700" r="1381" b="28492"/>
            <a:stretch/>
          </p:blipFill>
          <p:spPr>
            <a:xfrm>
              <a:off x="1933575" y="4324350"/>
              <a:ext cx="1440000" cy="228939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10" name="그림 109">
              <a:extLst>
                <a:ext uri="{FF2B5EF4-FFF2-40B4-BE49-F238E27FC236}">
                  <a16:creationId xmlns:a16="http://schemas.microsoft.com/office/drawing/2014/main" id="{F21ACFCE-047D-41B2-924E-1A844C9E61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485" t="11083" r="4586" b="25660"/>
            <a:stretch/>
          </p:blipFill>
          <p:spPr>
            <a:xfrm>
              <a:off x="1931442" y="4592910"/>
              <a:ext cx="1440000" cy="21758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sp>
        <p:nvSpPr>
          <p:cNvPr id="113" name="TextBox 112">
            <a:extLst>
              <a:ext uri="{FF2B5EF4-FFF2-40B4-BE49-F238E27FC236}">
                <a16:creationId xmlns:a16="http://schemas.microsoft.com/office/drawing/2014/main" id="{FB97B4DB-3535-4444-9014-E3915BF70A23}"/>
              </a:ext>
            </a:extLst>
          </p:cNvPr>
          <p:cNvSpPr txBox="1"/>
          <p:nvPr/>
        </p:nvSpPr>
        <p:spPr>
          <a:xfrm>
            <a:off x="1441686" y="438759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2</a:t>
            </a:r>
          </a:p>
        </p:txBody>
      </p:sp>
      <p:sp>
        <p:nvSpPr>
          <p:cNvPr id="115" name="TextBox 47">
            <a:extLst>
              <a:ext uri="{FF2B5EF4-FFF2-40B4-BE49-F238E27FC236}">
                <a16:creationId xmlns:a16="http://schemas.microsoft.com/office/drawing/2014/main" id="{E7288442-1535-43CF-B56B-AC19D57FC676}"/>
              </a:ext>
            </a:extLst>
          </p:cNvPr>
          <p:cNvSpPr txBox="1"/>
          <p:nvPr/>
        </p:nvSpPr>
        <p:spPr>
          <a:xfrm>
            <a:off x="3312965" y="4099771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35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47">
            <a:extLst>
              <a:ext uri="{FF2B5EF4-FFF2-40B4-BE49-F238E27FC236}">
                <a16:creationId xmlns:a16="http://schemas.microsoft.com/office/drawing/2014/main" id="{BF4971C1-865A-4119-BC28-BE1D38AB076B}"/>
              </a:ext>
            </a:extLst>
          </p:cNvPr>
          <p:cNvSpPr txBox="1"/>
          <p:nvPr/>
        </p:nvSpPr>
        <p:spPr>
          <a:xfrm>
            <a:off x="3312965" y="4337896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25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3E0772C-D423-4271-9DBA-DF97F82DAAB8}"/>
              </a:ext>
            </a:extLst>
          </p:cNvPr>
          <p:cNvSpPr txBox="1"/>
          <p:nvPr/>
        </p:nvSpPr>
        <p:spPr>
          <a:xfrm>
            <a:off x="3986721" y="3270719"/>
            <a:ext cx="14070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800" dirty="0">
                <a:latin typeface="Times New Roman" pitchFamily="18" charset="0"/>
                <a:cs typeface="Times New Roman" pitchFamily="18" charset="0"/>
              </a:rPr>
              <a:t>CK        -     +      -     +   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7206274-1207-4F2C-A3D0-FF7DAD71F3E5}"/>
              </a:ext>
            </a:extLst>
          </p:cNvPr>
          <p:cNvSpPr txBox="1"/>
          <p:nvPr/>
        </p:nvSpPr>
        <p:spPr>
          <a:xfrm>
            <a:off x="4605824" y="3128255"/>
            <a:ext cx="603662" cy="182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700"/>
              </a:lnSpc>
            </a:pPr>
            <a:r>
              <a:rPr lang="en-US" altLang="ko-KR" sz="800" dirty="0">
                <a:latin typeface="Times New Roman" pitchFamily="18" charset="0"/>
                <a:cs typeface="Times New Roman" pitchFamily="18" charset="0"/>
              </a:rPr>
              <a:t>Sirt6 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67F854BD-F943-42E8-B091-722C2BF892A8}"/>
              </a:ext>
            </a:extLst>
          </p:cNvPr>
          <p:cNvCxnSpPr/>
          <p:nvPr/>
        </p:nvCxnSpPr>
        <p:spPr>
          <a:xfrm>
            <a:off x="4760403" y="3282377"/>
            <a:ext cx="252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784F25ED-722B-41E0-810E-FDAEBE7B8367}"/>
              </a:ext>
            </a:extLst>
          </p:cNvPr>
          <p:cNvCxnSpPr/>
          <p:nvPr/>
        </p:nvCxnSpPr>
        <p:spPr>
          <a:xfrm>
            <a:off x="4403889" y="3282377"/>
            <a:ext cx="252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A9CDFE3-C1DA-4D68-BB9B-C2F5296F2AAF}"/>
              </a:ext>
            </a:extLst>
          </p:cNvPr>
          <p:cNvSpPr txBox="1"/>
          <p:nvPr/>
        </p:nvSpPr>
        <p:spPr>
          <a:xfrm>
            <a:off x="4215299" y="3118730"/>
            <a:ext cx="603662" cy="182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700"/>
              </a:lnSpc>
            </a:pPr>
            <a:r>
              <a:rPr lang="en-US" altLang="ko-KR" sz="800" dirty="0">
                <a:latin typeface="Times New Roman" pitchFamily="18" charset="0"/>
                <a:cs typeface="Times New Roman" pitchFamily="18" charset="0"/>
              </a:rPr>
              <a:t>Vector</a:t>
            </a:r>
            <a:endParaRPr lang="ko-KR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9C3B1D9-761A-446F-AA4F-E50CD4ACCE56}"/>
              </a:ext>
            </a:extLst>
          </p:cNvPr>
          <p:cNvSpPr txBox="1"/>
          <p:nvPr/>
        </p:nvSpPr>
        <p:spPr>
          <a:xfrm>
            <a:off x="3955088" y="349833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</a:p>
        </p:txBody>
      </p:sp>
      <p:sp>
        <p:nvSpPr>
          <p:cNvPr id="84" name="TextBox 53">
            <a:extLst>
              <a:ext uri="{FF2B5EF4-FFF2-40B4-BE49-F238E27FC236}">
                <a16:creationId xmlns:a16="http://schemas.microsoft.com/office/drawing/2014/main" id="{DF0A27D5-915E-4C93-AEB2-126818D7D0C9}"/>
              </a:ext>
            </a:extLst>
          </p:cNvPr>
          <p:cNvSpPr txBox="1"/>
          <p:nvPr/>
        </p:nvSpPr>
        <p:spPr>
          <a:xfrm>
            <a:off x="3797836" y="4643146"/>
            <a:ext cx="53292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ctin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E5AF27D-5CDF-4F38-A3C9-CC29D05BB263}"/>
              </a:ext>
            </a:extLst>
          </p:cNvPr>
          <p:cNvSpPr txBox="1"/>
          <p:nvPr/>
        </p:nvSpPr>
        <p:spPr>
          <a:xfrm>
            <a:off x="3718420" y="3737902"/>
            <a:ext cx="4789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C3-I</a:t>
            </a:r>
          </a:p>
        </p:txBody>
      </p:sp>
      <p:sp>
        <p:nvSpPr>
          <p:cNvPr id="86" name="Rectangle 1">
            <a:extLst>
              <a:ext uri="{FF2B5EF4-FFF2-40B4-BE49-F238E27FC236}">
                <a16:creationId xmlns:a16="http://schemas.microsoft.com/office/drawing/2014/main" id="{1BF313FE-39CC-406B-9F61-D4A3C2587EFB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4046013" y="3742459"/>
            <a:ext cx="303793" cy="19236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685800" fontAlgn="base">
              <a:spcBef>
                <a:spcPct val="0"/>
              </a:spcBef>
              <a:spcAft>
                <a:spcPct val="0"/>
              </a:spcAft>
            </a:pPr>
            <a:r>
              <a:rPr kumimoji="1" lang="ko-KR" altLang="ko-KR" sz="800" dirty="0">
                <a:latin typeface="Times New Roman" panose="02020603050405020304" pitchFamily="18" charset="0"/>
                <a:ea typeface="Arial Unicode MS" pitchFamily="50" charset="-127"/>
                <a:cs typeface="Times New Roman" pitchFamily="18" charset="0"/>
              </a:rPr>
              <a:t>→</a:t>
            </a:r>
            <a:endParaRPr kumimoji="1" lang="ko-KR" altLang="ko-KR" sz="800" dirty="0">
              <a:latin typeface="Times New Roman" panose="02020603050405020304" pitchFamily="18" charset="0"/>
              <a:ea typeface="굴림" pitchFamily="50" charset="-127"/>
              <a:cs typeface="Times New Roman" pitchFamily="18" charset="0"/>
            </a:endParaRPr>
          </a:p>
        </p:txBody>
      </p:sp>
      <p:sp>
        <p:nvSpPr>
          <p:cNvPr id="87" name="Rectangle 1">
            <a:extLst>
              <a:ext uri="{FF2B5EF4-FFF2-40B4-BE49-F238E27FC236}">
                <a16:creationId xmlns:a16="http://schemas.microsoft.com/office/drawing/2014/main" id="{25C26C85-C8F8-4421-829B-FB2D9DED59E7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4046013" y="3861517"/>
            <a:ext cx="303793" cy="19236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ffectLst/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defTabSz="685800" fontAlgn="base">
              <a:spcBef>
                <a:spcPct val="0"/>
              </a:spcBef>
              <a:spcAft>
                <a:spcPct val="0"/>
              </a:spcAft>
            </a:pPr>
            <a:r>
              <a:rPr kumimoji="1" lang="ko-KR" altLang="ko-KR" sz="800" dirty="0">
                <a:latin typeface="Times New Roman" panose="02020603050405020304" pitchFamily="18" charset="0"/>
                <a:ea typeface="Arial Unicode MS" pitchFamily="50" charset="-127"/>
                <a:cs typeface="Times New Roman" pitchFamily="18" charset="0"/>
              </a:rPr>
              <a:t>→</a:t>
            </a:r>
            <a:endParaRPr kumimoji="1" lang="ko-KR" altLang="ko-KR" sz="800" dirty="0">
              <a:latin typeface="Times New Roman" panose="02020603050405020304" pitchFamily="18" charset="0"/>
              <a:ea typeface="굴림" pitchFamily="50" charset="-127"/>
              <a:cs typeface="Times New Roman" pitchFamily="18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EB58264-A691-4D4F-AB33-7F9AA66451BE}"/>
              </a:ext>
            </a:extLst>
          </p:cNvPr>
          <p:cNvSpPr txBox="1"/>
          <p:nvPr/>
        </p:nvSpPr>
        <p:spPr>
          <a:xfrm>
            <a:off x="3854163" y="3856960"/>
            <a:ext cx="3813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</a:p>
        </p:txBody>
      </p:sp>
      <p:sp>
        <p:nvSpPr>
          <p:cNvPr id="89" name="TextBox 47">
            <a:extLst>
              <a:ext uri="{FF2B5EF4-FFF2-40B4-BE49-F238E27FC236}">
                <a16:creationId xmlns:a16="http://schemas.microsoft.com/office/drawing/2014/main" id="{516ABEF7-B1BC-4EB4-8F07-3DB150BA110E}"/>
              </a:ext>
            </a:extLst>
          </p:cNvPr>
          <p:cNvSpPr txBox="1"/>
          <p:nvPr/>
        </p:nvSpPr>
        <p:spPr>
          <a:xfrm>
            <a:off x="5069354" y="3461596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70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TextBox 47">
            <a:extLst>
              <a:ext uri="{FF2B5EF4-FFF2-40B4-BE49-F238E27FC236}">
                <a16:creationId xmlns:a16="http://schemas.microsoft.com/office/drawing/2014/main" id="{3CFA4610-1764-4965-B767-43AC54560838}"/>
              </a:ext>
            </a:extLst>
          </p:cNvPr>
          <p:cNvSpPr txBox="1"/>
          <p:nvPr/>
        </p:nvSpPr>
        <p:spPr>
          <a:xfrm>
            <a:off x="5069354" y="3814021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15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Box 47">
            <a:extLst>
              <a:ext uri="{FF2B5EF4-FFF2-40B4-BE49-F238E27FC236}">
                <a16:creationId xmlns:a16="http://schemas.microsoft.com/office/drawing/2014/main" id="{3A766362-CBC9-4C95-A0F1-40B89B3CD0DD}"/>
              </a:ext>
            </a:extLst>
          </p:cNvPr>
          <p:cNvSpPr txBox="1"/>
          <p:nvPr/>
        </p:nvSpPr>
        <p:spPr>
          <a:xfrm>
            <a:off x="5069354" y="4661746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45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394D046C-E20F-42A1-9779-7B31CF558D67}"/>
              </a:ext>
            </a:extLst>
          </p:cNvPr>
          <p:cNvCxnSpPr>
            <a:cxnSpLocks/>
          </p:cNvCxnSpPr>
          <p:nvPr/>
        </p:nvCxnSpPr>
        <p:spPr>
          <a:xfrm>
            <a:off x="4988836" y="3542806"/>
            <a:ext cx="12813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2C1A03C5-25C3-49B0-85C7-7956A37F299A}"/>
              </a:ext>
            </a:extLst>
          </p:cNvPr>
          <p:cNvCxnSpPr>
            <a:cxnSpLocks/>
          </p:cNvCxnSpPr>
          <p:nvPr/>
        </p:nvCxnSpPr>
        <p:spPr>
          <a:xfrm>
            <a:off x="4988836" y="3893394"/>
            <a:ext cx="12813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직선 연결선 71">
            <a:extLst>
              <a:ext uri="{FF2B5EF4-FFF2-40B4-BE49-F238E27FC236}">
                <a16:creationId xmlns:a16="http://schemas.microsoft.com/office/drawing/2014/main" id="{FD308554-A989-47FC-BA83-C3B140BCAE78}"/>
              </a:ext>
            </a:extLst>
          </p:cNvPr>
          <p:cNvCxnSpPr>
            <a:cxnSpLocks/>
          </p:cNvCxnSpPr>
          <p:nvPr/>
        </p:nvCxnSpPr>
        <p:spPr>
          <a:xfrm>
            <a:off x="4988836" y="4739416"/>
            <a:ext cx="12813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직선 연결선 105">
            <a:extLst>
              <a:ext uri="{FF2B5EF4-FFF2-40B4-BE49-F238E27FC236}">
                <a16:creationId xmlns:a16="http://schemas.microsoft.com/office/drawing/2014/main" id="{B53066E7-B5B8-4311-9577-4AAB9D446333}"/>
              </a:ext>
            </a:extLst>
          </p:cNvPr>
          <p:cNvCxnSpPr>
            <a:cxnSpLocks/>
          </p:cNvCxnSpPr>
          <p:nvPr/>
        </p:nvCxnSpPr>
        <p:spPr>
          <a:xfrm>
            <a:off x="4988836" y="4139325"/>
            <a:ext cx="12813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직선 연결선 111">
            <a:extLst>
              <a:ext uri="{FF2B5EF4-FFF2-40B4-BE49-F238E27FC236}">
                <a16:creationId xmlns:a16="http://schemas.microsoft.com/office/drawing/2014/main" id="{D24FF7DE-AD49-4820-9CD6-805826214723}"/>
              </a:ext>
            </a:extLst>
          </p:cNvPr>
          <p:cNvCxnSpPr>
            <a:cxnSpLocks/>
          </p:cNvCxnSpPr>
          <p:nvPr/>
        </p:nvCxnSpPr>
        <p:spPr>
          <a:xfrm>
            <a:off x="4988836" y="4425075"/>
            <a:ext cx="128136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그림 37">
            <a:extLst>
              <a:ext uri="{FF2B5EF4-FFF2-40B4-BE49-F238E27FC236}">
                <a16:creationId xmlns:a16="http://schemas.microsoft.com/office/drawing/2014/main" id="{88B18DDA-88B8-4E6B-9D15-E7725D2D9F6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25000"/>
                    </a14:imgEffect>
                    <a14:imgEffect>
                      <a14:brightnessContrast bright="24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366" t="41720" r="27236" b="35959"/>
          <a:stretch/>
        </p:blipFill>
        <p:spPr>
          <a:xfrm>
            <a:off x="4269011" y="4653371"/>
            <a:ext cx="800851" cy="20373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8" name="그림 47">
            <a:extLst>
              <a:ext uri="{FF2B5EF4-FFF2-40B4-BE49-F238E27FC236}">
                <a16:creationId xmlns:a16="http://schemas.microsoft.com/office/drawing/2014/main" id="{5AD90B3D-6059-4218-B628-7625FC78245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083" t="13082" r="6273" b="13963"/>
          <a:stretch/>
        </p:blipFill>
        <p:spPr>
          <a:xfrm>
            <a:off x="4270741" y="3769781"/>
            <a:ext cx="799121" cy="31500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5" name="그림 104">
            <a:extLst>
              <a:ext uri="{FF2B5EF4-FFF2-40B4-BE49-F238E27FC236}">
                <a16:creationId xmlns:a16="http://schemas.microsoft.com/office/drawing/2014/main" id="{3776FBEF-BF18-422A-B412-DADC4389B6D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0487" t="18225" r="6360" b="22487"/>
          <a:stretch/>
        </p:blipFill>
        <p:spPr>
          <a:xfrm>
            <a:off x="4270740" y="3490762"/>
            <a:ext cx="799122" cy="23881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8" name="그림 107">
            <a:extLst>
              <a:ext uri="{FF2B5EF4-FFF2-40B4-BE49-F238E27FC236}">
                <a16:creationId xmlns:a16="http://schemas.microsoft.com/office/drawing/2014/main" id="{F7002A41-5762-4F1D-8E1B-402407DEB03C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lum bright="20000" contrast="-40000"/>
          </a:blip>
          <a:srcRect l="8726" t="21905" r="5904" b="29911"/>
          <a:stretch/>
        </p:blipFill>
        <p:spPr>
          <a:xfrm>
            <a:off x="4269011" y="4121320"/>
            <a:ext cx="800851" cy="24149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18" name="TextBox 117">
            <a:extLst>
              <a:ext uri="{FF2B5EF4-FFF2-40B4-BE49-F238E27FC236}">
                <a16:creationId xmlns:a16="http://schemas.microsoft.com/office/drawing/2014/main" id="{B5C137CB-0B8B-4D6F-A2B7-9F9AE409439A}"/>
              </a:ext>
            </a:extLst>
          </p:cNvPr>
          <p:cNvSpPr txBox="1"/>
          <p:nvPr/>
        </p:nvSpPr>
        <p:spPr>
          <a:xfrm>
            <a:off x="3885081" y="4139940"/>
            <a:ext cx="4171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-1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1609AC95-2A5E-4349-A8E7-D22ECA8530C0}"/>
              </a:ext>
            </a:extLst>
          </p:cNvPr>
          <p:cNvSpPr txBox="1"/>
          <p:nvPr/>
        </p:nvSpPr>
        <p:spPr>
          <a:xfrm>
            <a:off x="3851511" y="4416165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2</a:t>
            </a:r>
          </a:p>
        </p:txBody>
      </p:sp>
      <p:sp>
        <p:nvSpPr>
          <p:cNvPr id="121" name="TextBox 47">
            <a:extLst>
              <a:ext uri="{FF2B5EF4-FFF2-40B4-BE49-F238E27FC236}">
                <a16:creationId xmlns:a16="http://schemas.microsoft.com/office/drawing/2014/main" id="{0B71ABA3-FD01-4D96-9782-8542909277EA}"/>
              </a:ext>
            </a:extLst>
          </p:cNvPr>
          <p:cNvSpPr txBox="1"/>
          <p:nvPr/>
        </p:nvSpPr>
        <p:spPr>
          <a:xfrm>
            <a:off x="5069354" y="4347421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25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TextBox 47">
            <a:extLst>
              <a:ext uri="{FF2B5EF4-FFF2-40B4-BE49-F238E27FC236}">
                <a16:creationId xmlns:a16="http://schemas.microsoft.com/office/drawing/2014/main" id="{710689D1-5227-41B8-BE83-4F2CFF7B76C2}"/>
              </a:ext>
            </a:extLst>
          </p:cNvPr>
          <p:cNvSpPr txBox="1"/>
          <p:nvPr/>
        </p:nvSpPr>
        <p:spPr>
          <a:xfrm>
            <a:off x="5069354" y="4061671"/>
            <a:ext cx="312884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50" dirty="0">
                <a:latin typeface="Times New Roman" pitchFamily="18" charset="0"/>
                <a:cs typeface="Times New Roman" pitchFamily="18" charset="0"/>
              </a:rPr>
              <a:t>35</a:t>
            </a:r>
            <a:endParaRPr lang="ko-KR" altLang="en-US" sz="6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781004D5-B02E-47C2-9F54-5EE962EAA51C}"/>
              </a:ext>
            </a:extLst>
          </p:cNvPr>
          <p:cNvSpPr txBox="1"/>
          <p:nvPr/>
        </p:nvSpPr>
        <p:spPr>
          <a:xfrm>
            <a:off x="2640189" y="1674980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0" name="그림 129">
            <a:extLst>
              <a:ext uri="{FF2B5EF4-FFF2-40B4-BE49-F238E27FC236}">
                <a16:creationId xmlns:a16="http://schemas.microsoft.com/office/drawing/2014/main" id="{F143617F-681E-4DD8-B6EE-A3CA50E159DD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lum bright="7000" contrast="-20000"/>
          </a:blip>
          <a:srcRect l="5826" t="19520" r="5218" b="24285"/>
          <a:stretch/>
        </p:blipFill>
        <p:spPr>
          <a:xfrm>
            <a:off x="4267062" y="4402744"/>
            <a:ext cx="802800" cy="211644"/>
          </a:xfrm>
          <a:prstGeom prst="rect">
            <a:avLst/>
          </a:prstGeom>
          <a:ln w="31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01475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그룹 64">
            <a:extLst>
              <a:ext uri="{FF2B5EF4-FFF2-40B4-BE49-F238E27FC236}">
                <a16:creationId xmlns:a16="http://schemas.microsoft.com/office/drawing/2014/main" id="{410CD5AB-3D6B-47FC-973D-AD5EE1C81467}"/>
              </a:ext>
            </a:extLst>
          </p:cNvPr>
          <p:cNvGrpSpPr/>
          <p:nvPr/>
        </p:nvGrpSpPr>
        <p:grpSpPr>
          <a:xfrm>
            <a:off x="1948044" y="2571750"/>
            <a:ext cx="2435958" cy="2979703"/>
            <a:chOff x="1976619" y="2571750"/>
            <a:chExt cx="2435958" cy="2979703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2014575-1CFC-491D-9B2D-6D7B0B38760B}"/>
                </a:ext>
              </a:extLst>
            </p:cNvPr>
            <p:cNvSpPr txBox="1"/>
            <p:nvPr/>
          </p:nvSpPr>
          <p:spPr>
            <a:xfrm>
              <a:off x="2453561" y="3559721"/>
              <a:ext cx="3850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rt6</a:t>
              </a:r>
            </a:p>
          </p:txBody>
        </p:sp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B38316BB-22CC-46F2-ABE2-333BEF7B6C0E}"/>
                </a:ext>
              </a:extLst>
            </p:cNvPr>
            <p:cNvCxnSpPr/>
            <p:nvPr/>
          </p:nvCxnSpPr>
          <p:spPr>
            <a:xfrm>
              <a:off x="3351132" y="3039534"/>
              <a:ext cx="288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 9">
              <a:extLst>
                <a:ext uri="{FF2B5EF4-FFF2-40B4-BE49-F238E27FC236}">
                  <a16:creationId xmlns:a16="http://schemas.microsoft.com/office/drawing/2014/main" id="{6B3966AE-9A03-4CC5-8D4C-FA9EA8D4B87E}"/>
                </a:ext>
              </a:extLst>
            </p:cNvPr>
            <p:cNvCxnSpPr/>
            <p:nvPr/>
          </p:nvCxnSpPr>
          <p:spPr>
            <a:xfrm>
              <a:off x="3732132" y="3039534"/>
              <a:ext cx="288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FD808F8-9CA4-4C1C-AE6E-5797B3BC0492}"/>
                </a:ext>
              </a:extLst>
            </p:cNvPr>
            <p:cNvSpPr txBox="1"/>
            <p:nvPr/>
          </p:nvSpPr>
          <p:spPr>
            <a:xfrm>
              <a:off x="2918630" y="3023226"/>
              <a:ext cx="126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   +    -    +    -    + 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BAAA506-E369-4B45-9566-6CD08B39976A}"/>
                </a:ext>
              </a:extLst>
            </p:cNvPr>
            <p:cNvSpPr txBox="1"/>
            <p:nvPr/>
          </p:nvSpPr>
          <p:spPr>
            <a:xfrm>
              <a:off x="2415418" y="4668659"/>
              <a:ext cx="4411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D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07D1DCF-D801-43D5-A0D6-07B0474CEDFD}"/>
                </a:ext>
              </a:extLst>
            </p:cNvPr>
            <p:cNvSpPr txBox="1"/>
            <p:nvPr/>
          </p:nvSpPr>
          <p:spPr>
            <a:xfrm>
              <a:off x="2441564" y="4386869"/>
              <a:ext cx="4171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-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B1B11E4-CF59-4DAC-9B99-FAE383319801}"/>
                </a:ext>
              </a:extLst>
            </p:cNvPr>
            <p:cNvSpPr txBox="1"/>
            <p:nvPr/>
          </p:nvSpPr>
          <p:spPr>
            <a:xfrm>
              <a:off x="2505260" y="327223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21</a:t>
              </a:r>
            </a:p>
          </p:txBody>
        </p:sp>
        <p:cxnSp>
          <p:nvCxnSpPr>
            <p:cNvPr id="40" name="직선 연결선 39">
              <a:extLst>
                <a:ext uri="{FF2B5EF4-FFF2-40B4-BE49-F238E27FC236}">
                  <a16:creationId xmlns:a16="http://schemas.microsoft.com/office/drawing/2014/main" id="{2E298CC8-8F6F-4AD1-8B71-764BAE9A326A}"/>
                </a:ext>
              </a:extLst>
            </p:cNvPr>
            <p:cNvCxnSpPr/>
            <p:nvPr/>
          </p:nvCxnSpPr>
          <p:spPr>
            <a:xfrm>
              <a:off x="2964302" y="3041806"/>
              <a:ext cx="288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346C193-6F4B-4606-AA4F-49EDAEC32D93}"/>
                </a:ext>
              </a:extLst>
            </p:cNvPr>
            <p:cNvSpPr txBox="1"/>
            <p:nvPr/>
          </p:nvSpPr>
          <p:spPr>
            <a:xfrm>
              <a:off x="2890201" y="2818465"/>
              <a:ext cx="13865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MSO    2 </a:t>
              </a:r>
              <a:r>
                <a:rPr lang="en-US" altLang="ko-KR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5 </a:t>
              </a:r>
              <a:r>
                <a:rPr lang="en-US" altLang="ko-KR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직선 연결선 33">
              <a:extLst>
                <a:ext uri="{FF2B5EF4-FFF2-40B4-BE49-F238E27FC236}">
                  <a16:creationId xmlns:a16="http://schemas.microsoft.com/office/drawing/2014/main" id="{C67C9588-B3F5-4B0F-8EDC-DA51EFCF341E}"/>
                </a:ext>
              </a:extLst>
            </p:cNvPr>
            <p:cNvCxnSpPr/>
            <p:nvPr/>
          </p:nvCxnSpPr>
          <p:spPr>
            <a:xfrm>
              <a:off x="3351132" y="2818465"/>
              <a:ext cx="620698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B781492-2D02-453E-A783-6829AB866284}"/>
                </a:ext>
              </a:extLst>
            </p:cNvPr>
            <p:cNvSpPr txBox="1"/>
            <p:nvPr/>
          </p:nvSpPr>
          <p:spPr>
            <a:xfrm>
              <a:off x="3400425" y="2571750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G132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53">
              <a:extLst>
                <a:ext uri="{FF2B5EF4-FFF2-40B4-BE49-F238E27FC236}">
                  <a16:creationId xmlns:a16="http://schemas.microsoft.com/office/drawing/2014/main" id="{A7FAB76C-46E5-435E-8AEB-7D2B534374DB}"/>
                </a:ext>
              </a:extLst>
            </p:cNvPr>
            <p:cNvSpPr txBox="1"/>
            <p:nvPr/>
          </p:nvSpPr>
          <p:spPr>
            <a:xfrm>
              <a:off x="2350036" y="5309896"/>
              <a:ext cx="5329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 actin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415A38D-C09C-41BF-AC40-835B08A08774}"/>
                </a:ext>
              </a:extLst>
            </p:cNvPr>
            <p:cNvSpPr txBox="1"/>
            <p:nvPr/>
          </p:nvSpPr>
          <p:spPr>
            <a:xfrm>
              <a:off x="2289670" y="4947577"/>
              <a:ext cx="478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C3-I</a:t>
              </a:r>
            </a:p>
          </p:txBody>
        </p:sp>
        <p:sp>
          <p:nvSpPr>
            <p:cNvPr id="42" name="Rectangle 1">
              <a:extLst>
                <a:ext uri="{FF2B5EF4-FFF2-40B4-BE49-F238E27FC236}">
                  <a16:creationId xmlns:a16="http://schemas.microsoft.com/office/drawing/2014/main" id="{EA16CF6A-09DA-427B-BC00-32AE4F43C35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V="1">
              <a:off x="2617263" y="4942609"/>
              <a:ext cx="303793" cy="1923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ffectLst/>
          </p:spPr>
          <p:txBody>
            <a:bodyPr vert="horz" wrap="squar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6858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ko-KR" altLang="ko-KR" sz="800" dirty="0">
                  <a:latin typeface="Times New Roman" panose="02020603050405020304" pitchFamily="18" charset="0"/>
                  <a:ea typeface="Arial Unicode MS" pitchFamily="50" charset="-127"/>
                  <a:cs typeface="Times New Roman" pitchFamily="18" charset="0"/>
                </a:rPr>
                <a:t>→</a:t>
              </a:r>
              <a:endParaRPr kumimoji="1" lang="ko-KR" altLang="ko-KR" sz="800" dirty="0">
                <a:latin typeface="Times New Roman" panose="02020603050405020304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3" name="Rectangle 1">
              <a:extLst>
                <a:ext uri="{FF2B5EF4-FFF2-40B4-BE49-F238E27FC236}">
                  <a16:creationId xmlns:a16="http://schemas.microsoft.com/office/drawing/2014/main" id="{7C8D16BE-5127-48F4-B284-DFA333DB9CD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800000" flipV="1">
              <a:off x="2617263" y="5090242"/>
              <a:ext cx="303793" cy="1923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  <a:effectLst/>
          </p:spPr>
          <p:txBody>
            <a:bodyPr vert="horz" wrap="square" lIns="68580" tIns="34290" rIns="68580" bIns="34290" numCol="1" anchor="ctr" anchorCtr="0" compatLnSpc="1">
              <a:prstTxWarp prst="textNoShape">
                <a:avLst/>
              </a:prstTxWarp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defTabSz="685800"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1" lang="ko-KR" altLang="ko-KR" sz="800" dirty="0">
                  <a:latin typeface="Times New Roman" panose="02020603050405020304" pitchFamily="18" charset="0"/>
                  <a:ea typeface="Arial Unicode MS" pitchFamily="50" charset="-127"/>
                  <a:cs typeface="Times New Roman" pitchFamily="18" charset="0"/>
                </a:rPr>
                <a:t>→</a:t>
              </a:r>
              <a:endParaRPr kumimoji="1" lang="ko-KR" altLang="ko-KR" sz="800" dirty="0">
                <a:latin typeface="Times New Roman" panose="02020603050405020304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3F79CC7-B80B-4DC8-A0F4-BE5988306586}"/>
                </a:ext>
              </a:extLst>
            </p:cNvPr>
            <p:cNvSpPr txBox="1"/>
            <p:nvPr/>
          </p:nvSpPr>
          <p:spPr>
            <a:xfrm>
              <a:off x="2425413" y="5085685"/>
              <a:ext cx="3813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I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D3332E3-2C5C-48CC-97A7-CC580B3F2C87}"/>
                </a:ext>
              </a:extLst>
            </p:cNvPr>
            <p:cNvSpPr txBox="1"/>
            <p:nvPr/>
          </p:nvSpPr>
          <p:spPr>
            <a:xfrm>
              <a:off x="4112495" y="3915968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70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D46510D-D52B-4F72-AFF0-3425E9C6C6FB}"/>
                </a:ext>
              </a:extLst>
            </p:cNvPr>
            <p:cNvSpPr txBox="1"/>
            <p:nvPr/>
          </p:nvSpPr>
          <p:spPr>
            <a:xfrm>
              <a:off x="4112495" y="3998965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30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3AE50D41-5E28-4B21-871A-EB01F52DCD3D}"/>
                </a:ext>
              </a:extLst>
            </p:cNvPr>
            <p:cNvSpPr txBox="1"/>
            <p:nvPr/>
          </p:nvSpPr>
          <p:spPr>
            <a:xfrm>
              <a:off x="4112495" y="4142644"/>
              <a:ext cx="30008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00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444548A1-203D-4035-AE65-3248C6FFDEED}"/>
                </a:ext>
              </a:extLst>
            </p:cNvPr>
            <p:cNvSpPr txBox="1"/>
            <p:nvPr/>
          </p:nvSpPr>
          <p:spPr>
            <a:xfrm>
              <a:off x="4112495" y="3342544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5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0196ED5-D7B0-48C0-8B50-0F2592E52BAF}"/>
                </a:ext>
              </a:extLst>
            </p:cNvPr>
            <p:cNvSpPr txBox="1"/>
            <p:nvPr/>
          </p:nvSpPr>
          <p:spPr>
            <a:xfrm>
              <a:off x="4112495" y="3571144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45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DC205E6-E746-4B7C-93A6-8205E050DB45}"/>
                </a:ext>
              </a:extLst>
            </p:cNvPr>
            <p:cNvSpPr txBox="1"/>
            <p:nvPr/>
          </p:nvSpPr>
          <p:spPr>
            <a:xfrm>
              <a:off x="4112495" y="4266469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35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83633D4-A343-41E3-9A6F-955D630C713F}"/>
                </a:ext>
              </a:extLst>
            </p:cNvPr>
            <p:cNvSpPr txBox="1"/>
            <p:nvPr/>
          </p:nvSpPr>
          <p:spPr>
            <a:xfrm>
              <a:off x="4112495" y="4599844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25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487FD12-61C2-4F85-8329-E58A38E477FC}"/>
                </a:ext>
              </a:extLst>
            </p:cNvPr>
            <p:cNvSpPr txBox="1"/>
            <p:nvPr/>
          </p:nvSpPr>
          <p:spPr>
            <a:xfrm>
              <a:off x="4112495" y="4961794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5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6F872BA-5115-48D1-A319-FF71A98DE4F3}"/>
                </a:ext>
              </a:extLst>
            </p:cNvPr>
            <p:cNvSpPr txBox="1"/>
            <p:nvPr/>
          </p:nvSpPr>
          <p:spPr>
            <a:xfrm>
              <a:off x="4102666" y="5349940"/>
              <a:ext cx="2616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45</a:t>
              </a:r>
              <a:endParaRPr kumimoji="0" lang="ko-KR" altLang="en-US" sz="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8C49D0EE-7ED3-4547-A4F1-E1D5C13D2298}"/>
                </a:ext>
              </a:extLst>
            </p:cNvPr>
            <p:cNvSpPr txBox="1"/>
            <p:nvPr/>
          </p:nvSpPr>
          <p:spPr>
            <a:xfrm>
              <a:off x="1976619" y="3899185"/>
              <a:ext cx="8627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ADP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ribose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7" name="그룹 36">
              <a:extLst>
                <a:ext uri="{FF2B5EF4-FFF2-40B4-BE49-F238E27FC236}">
                  <a16:creationId xmlns:a16="http://schemas.microsoft.com/office/drawing/2014/main" id="{739D834F-BAB5-4285-84EC-F8BE823CE80C}"/>
                </a:ext>
              </a:extLst>
            </p:cNvPr>
            <p:cNvGrpSpPr/>
            <p:nvPr/>
          </p:nvGrpSpPr>
          <p:grpSpPr>
            <a:xfrm>
              <a:off x="2787330" y="3269447"/>
              <a:ext cx="1375437" cy="2282006"/>
              <a:chOff x="2787330" y="3269447"/>
              <a:chExt cx="1375437" cy="2282006"/>
            </a:xfrm>
          </p:grpSpPr>
          <p:cxnSp>
            <p:nvCxnSpPr>
              <p:cNvPr id="6" name="직선 연결선 5">
                <a:extLst>
                  <a:ext uri="{FF2B5EF4-FFF2-40B4-BE49-F238E27FC236}">
                    <a16:creationId xmlns:a16="http://schemas.microsoft.com/office/drawing/2014/main" id="{D40B6B9E-FEE9-402C-8669-3BF2713D63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3435415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직선 연결선 44">
                <a:extLst>
                  <a:ext uri="{FF2B5EF4-FFF2-40B4-BE49-F238E27FC236}">
                    <a16:creationId xmlns:a16="http://schemas.microsoft.com/office/drawing/2014/main" id="{BC5605EA-803E-4C0D-9BD7-382B94A6EB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3664015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직선 연결선 45">
                <a:extLst>
                  <a:ext uri="{FF2B5EF4-FFF2-40B4-BE49-F238E27FC236}">
                    <a16:creationId xmlns:a16="http://schemas.microsoft.com/office/drawing/2014/main" id="{26B48D4E-A41E-47C3-A715-08ABBD4E91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4359340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직선 연결선 46">
                <a:extLst>
                  <a:ext uri="{FF2B5EF4-FFF2-40B4-BE49-F238E27FC236}">
                    <a16:creationId xmlns:a16="http://schemas.microsoft.com/office/drawing/2014/main" id="{CD244EC5-CAEB-4DCD-A91C-480ABF0B25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4692715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직선 연결선 47">
                <a:extLst>
                  <a:ext uri="{FF2B5EF4-FFF2-40B4-BE49-F238E27FC236}">
                    <a16:creationId xmlns:a16="http://schemas.microsoft.com/office/drawing/2014/main" id="{0DA79FC4-AC43-4802-AD99-4D1F515999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5054665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직선 연결선 48">
                <a:extLst>
                  <a:ext uri="{FF2B5EF4-FFF2-40B4-BE49-F238E27FC236}">
                    <a16:creationId xmlns:a16="http://schemas.microsoft.com/office/drawing/2014/main" id="{7E383506-2F37-4D6E-B166-3B6758DEFA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5426140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직선 연결선 49">
                <a:extLst>
                  <a:ext uri="{FF2B5EF4-FFF2-40B4-BE49-F238E27FC236}">
                    <a16:creationId xmlns:a16="http://schemas.microsoft.com/office/drawing/2014/main" id="{45F1A7AA-BBFE-48B2-A144-48E21F522F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4017862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직선 연결선 50">
                <a:extLst>
                  <a:ext uri="{FF2B5EF4-FFF2-40B4-BE49-F238E27FC236}">
                    <a16:creationId xmlns:a16="http://schemas.microsoft.com/office/drawing/2014/main" id="{06611684-E7E2-4299-B8BB-17D8EE23A3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4094062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직선 연결선 51">
                <a:extLst>
                  <a:ext uri="{FF2B5EF4-FFF2-40B4-BE49-F238E27FC236}">
                    <a16:creationId xmlns:a16="http://schemas.microsoft.com/office/drawing/2014/main" id="{09D45E0F-EEBD-4286-A848-D7BA4FCCC4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18767" y="4236937"/>
                <a:ext cx="144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DA59ED21-ED89-4DC3-B63F-DE14421044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691" t="26840" r="22892" b="33764"/>
              <a:stretch/>
            </p:blipFill>
            <p:spPr>
              <a:xfrm>
                <a:off x="2842666" y="3541085"/>
                <a:ext cx="1260000" cy="248796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3" name="그림 12">
                <a:extLst>
                  <a:ext uri="{FF2B5EF4-FFF2-40B4-BE49-F238E27FC236}">
                    <a16:creationId xmlns:a16="http://schemas.microsoft.com/office/drawing/2014/main" id="{DBCA6B66-8B0F-41FC-B8F8-FBAB7A5ECC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3474" t="21401" r="3426" b="20357"/>
              <a:stretch/>
            </p:blipFill>
            <p:spPr>
              <a:xfrm>
                <a:off x="2842666" y="4339784"/>
                <a:ext cx="1260000" cy="269157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5" name="그림 14">
                <a:extLst>
                  <a:ext uri="{FF2B5EF4-FFF2-40B4-BE49-F238E27FC236}">
                    <a16:creationId xmlns:a16="http://schemas.microsoft.com/office/drawing/2014/main" id="{2BDFACD0-A283-42A0-BF6B-08CD10F8E9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5495" t="27430" r="15241" b="25282"/>
              <a:stretch/>
            </p:blipFill>
            <p:spPr>
              <a:xfrm>
                <a:off x="2842666" y="3269447"/>
                <a:ext cx="1260000" cy="243392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8" name="그림 17">
                <a:extLst>
                  <a:ext uri="{FF2B5EF4-FFF2-40B4-BE49-F238E27FC236}">
                    <a16:creationId xmlns:a16="http://schemas.microsoft.com/office/drawing/2014/main" id="{7AA62D3D-930B-4901-BDDE-1250950FDC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108" t="41856" r="21610" b="37964"/>
              <a:stretch/>
            </p:blipFill>
            <p:spPr>
              <a:xfrm>
                <a:off x="2842666" y="4648426"/>
                <a:ext cx="1260000" cy="266365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0" name="그림 19">
                <a:extLst>
                  <a:ext uri="{FF2B5EF4-FFF2-40B4-BE49-F238E27FC236}">
                    <a16:creationId xmlns:a16="http://schemas.microsoft.com/office/drawing/2014/main" id="{96D035CD-CF26-48C3-BF0A-74BFD51094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261" t="30182" r="28242" b="33921"/>
              <a:stretch/>
            </p:blipFill>
            <p:spPr>
              <a:xfrm>
                <a:off x="2842666" y="3819670"/>
                <a:ext cx="1260000" cy="489563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1" name="그림 20">
                <a:extLst>
                  <a:ext uri="{FF2B5EF4-FFF2-40B4-BE49-F238E27FC236}">
                    <a16:creationId xmlns:a16="http://schemas.microsoft.com/office/drawing/2014/main" id="{17D90B25-C1D0-472E-A85B-800B4A90F2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5127" t="17526" r="6932" b="23672"/>
              <a:stretch/>
            </p:blipFill>
            <p:spPr>
              <a:xfrm>
                <a:off x="2842666" y="5314625"/>
                <a:ext cx="1260000" cy="236828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24" name="그림 23">
                <a:extLst>
                  <a:ext uri="{FF2B5EF4-FFF2-40B4-BE49-F238E27FC236}">
                    <a16:creationId xmlns:a16="http://schemas.microsoft.com/office/drawing/2014/main" id="{F267DB3C-7C99-42F9-872A-9BD2E0332E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3391" t="12401" r="1779" b="10921"/>
              <a:stretch/>
            </p:blipFill>
            <p:spPr>
              <a:xfrm>
                <a:off x="2842666" y="4939687"/>
                <a:ext cx="1260000" cy="338293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sp>
            <p:nvSpPr>
              <p:cNvPr id="63" name="왼쪽 대괄호 62">
                <a:extLst>
                  <a:ext uri="{FF2B5EF4-FFF2-40B4-BE49-F238E27FC236}">
                    <a16:creationId xmlns:a16="http://schemas.microsoft.com/office/drawing/2014/main" id="{C9DEF4D5-84F1-4DD1-9E30-411E1D6ECDF7}"/>
                  </a:ext>
                </a:extLst>
              </p:cNvPr>
              <p:cNvSpPr/>
              <p:nvPr/>
            </p:nvSpPr>
            <p:spPr>
              <a:xfrm>
                <a:off x="2787330" y="3844479"/>
                <a:ext cx="45719" cy="360000"/>
              </a:xfrm>
              <a:prstGeom prst="leftBracket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ko-KR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0EB9C272-40CA-4973-B7B8-F49F4C2EDEE8}"/>
              </a:ext>
            </a:extLst>
          </p:cNvPr>
          <p:cNvSpPr txBox="1"/>
          <p:nvPr/>
        </p:nvSpPr>
        <p:spPr>
          <a:xfrm>
            <a:off x="2468739" y="1674980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4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3110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5EB8FAB0-FF73-4453-998D-6A72897449EC}"/>
              </a:ext>
            </a:extLst>
          </p:cNvPr>
          <p:cNvGrpSpPr/>
          <p:nvPr/>
        </p:nvGrpSpPr>
        <p:grpSpPr>
          <a:xfrm>
            <a:off x="1000125" y="2059300"/>
            <a:ext cx="4991099" cy="3350900"/>
            <a:chOff x="1231310" y="1097275"/>
            <a:chExt cx="3948359" cy="2647024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E722FC3-6676-44CF-A5AB-C0FEB23DC175}"/>
                </a:ext>
              </a:extLst>
            </p:cNvPr>
            <p:cNvSpPr txBox="1"/>
            <p:nvPr/>
          </p:nvSpPr>
          <p:spPr>
            <a:xfrm>
              <a:off x="1231310" y="1097275"/>
              <a:ext cx="554415" cy="1945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Fig</a:t>
              </a:r>
              <a:r>
                <a:rPr lang="en-US" altLang="ko-KR" sz="1000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ure</a:t>
              </a:r>
              <a:r>
                <a:rPr lang="en-US" altLang="ko-KR" sz="1000" dirty="0">
                  <a:solidFill>
                    <a:prstClr val="black"/>
                  </a:solidFill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</a:t>
              </a: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C</a:t>
              </a:r>
              <a:endParaRPr kumimoji="0" lang="ko-KR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D5C279F-D756-44CC-B62B-90D381C2ADF3}"/>
                </a:ext>
              </a:extLst>
            </p:cNvPr>
            <p:cNvSpPr txBox="1"/>
            <p:nvPr/>
          </p:nvSpPr>
          <p:spPr>
            <a:xfrm>
              <a:off x="1235211" y="2775413"/>
              <a:ext cx="560756" cy="1945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Figure 1D</a:t>
              </a:r>
              <a:endParaRPr kumimoji="0" lang="ko-KR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4637DC8-7EE2-44FF-A7E9-71C38B5CCE51}"/>
                </a:ext>
              </a:extLst>
            </p:cNvPr>
            <p:cNvSpPr txBox="1"/>
            <p:nvPr/>
          </p:nvSpPr>
          <p:spPr>
            <a:xfrm rot="16200000">
              <a:off x="1408102" y="1566532"/>
              <a:ext cx="75693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protein level (fold)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02735B5-8532-4C81-BE66-45D8E0C03448}"/>
                </a:ext>
              </a:extLst>
            </p:cNvPr>
            <p:cNvSpPr txBox="1"/>
            <p:nvPr/>
          </p:nvSpPr>
          <p:spPr>
            <a:xfrm rot="16200000">
              <a:off x="1408102" y="2196789"/>
              <a:ext cx="75693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protein level (fold)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BDF2C0E-E03C-4EEE-9B66-9A0DEF46F0B5}"/>
                </a:ext>
              </a:extLst>
            </p:cNvPr>
            <p:cNvSpPr txBox="1"/>
            <p:nvPr/>
          </p:nvSpPr>
          <p:spPr>
            <a:xfrm>
              <a:off x="1860237" y="2591282"/>
              <a:ext cx="7761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s            Times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" name="직선 연결선 7">
              <a:extLst>
                <a:ext uri="{FF2B5EF4-FFF2-40B4-BE49-F238E27FC236}">
                  <a16:creationId xmlns:a16="http://schemas.microsoft.com/office/drawing/2014/main" id="{1B5B3004-FEAB-494A-9B7D-4D34597B0A6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41517" y="2634462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ACC0F19B-C0E4-4A07-A341-7683CC6D43D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99588" y="2634462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B56AE19-9491-460F-88A0-646A3E87E2FD}"/>
                </a:ext>
              </a:extLst>
            </p:cNvPr>
            <p:cNvSpPr txBox="1"/>
            <p:nvPr/>
          </p:nvSpPr>
          <p:spPr>
            <a:xfrm>
              <a:off x="2678249" y="2591282"/>
              <a:ext cx="7761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s            Times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직선 연결선 10">
              <a:extLst>
                <a:ext uri="{FF2B5EF4-FFF2-40B4-BE49-F238E27FC236}">
                  <a16:creationId xmlns:a16="http://schemas.microsoft.com/office/drawing/2014/main" id="{76B8E54C-DC05-441C-A852-429D7B60C3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9529" y="2634462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E664DFB1-3C5C-4D45-9B66-0DD85989791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17600" y="2634462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CE4D57F-5EF0-43B3-A752-766F47304E8A}"/>
                </a:ext>
              </a:extLst>
            </p:cNvPr>
            <p:cNvSpPr txBox="1"/>
            <p:nvPr/>
          </p:nvSpPr>
          <p:spPr>
            <a:xfrm>
              <a:off x="3521607" y="2593634"/>
              <a:ext cx="7761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s            Times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" name="직선 연결선 13">
              <a:extLst>
                <a:ext uri="{FF2B5EF4-FFF2-40B4-BE49-F238E27FC236}">
                  <a16:creationId xmlns:a16="http://schemas.microsoft.com/office/drawing/2014/main" id="{E8B858BA-F622-4701-BA09-394DBA1EA1B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02887" y="2636814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직선 연결선 14">
              <a:extLst>
                <a:ext uri="{FF2B5EF4-FFF2-40B4-BE49-F238E27FC236}">
                  <a16:creationId xmlns:a16="http://schemas.microsoft.com/office/drawing/2014/main" id="{DC03CB3C-2F26-48A2-B469-CF2B42DBCB1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0958" y="2636814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054FCAE-53B8-408F-A3A9-8713CF69D9C2}"/>
                </a:ext>
              </a:extLst>
            </p:cNvPr>
            <p:cNvSpPr txBox="1"/>
            <p:nvPr/>
          </p:nvSpPr>
          <p:spPr>
            <a:xfrm>
              <a:off x="4352469" y="1945001"/>
              <a:ext cx="7761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s            Times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id="{3EA8A927-C5D6-42B0-BE7D-BFFA82E8C39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33749" y="1988181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FDD5259F-C9DE-498D-ABAF-1BFC4F8AD90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91820" y="1988181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93A2A8CC-288B-4B0C-AA44-9225422365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81307" y="2992642"/>
              <a:ext cx="1728976" cy="651109"/>
            </a:xfrm>
            <a:prstGeom prst="rect">
              <a:avLst/>
            </a:prstGeom>
          </p:spPr>
        </p:pic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060908AA-56F7-45A2-89FE-BDF9A2154D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11964" y="1352422"/>
              <a:ext cx="3467705" cy="129978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12D14B3-9F3F-49ED-9193-67BE9CECA82F}"/>
                </a:ext>
              </a:extLst>
            </p:cNvPr>
            <p:cNvSpPr txBox="1"/>
            <p:nvPr/>
          </p:nvSpPr>
          <p:spPr>
            <a:xfrm>
              <a:off x="1858693" y="3590411"/>
              <a:ext cx="7761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s            Times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6149A22B-7595-4772-8105-FE76BDF850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39973" y="3633591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직선 연결선 22">
              <a:extLst>
                <a:ext uri="{FF2B5EF4-FFF2-40B4-BE49-F238E27FC236}">
                  <a16:creationId xmlns:a16="http://schemas.microsoft.com/office/drawing/2014/main" id="{3001F184-A0B6-480A-892D-BB45299C61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98044" y="3633591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0DD2350-4FDF-446C-9B8B-8797401B9150}"/>
                </a:ext>
              </a:extLst>
            </p:cNvPr>
            <p:cNvSpPr txBox="1"/>
            <p:nvPr/>
          </p:nvSpPr>
          <p:spPr>
            <a:xfrm>
              <a:off x="2676705" y="3590411"/>
              <a:ext cx="7761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s            Times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99F48C20-9301-4DB6-8471-6EF5B447CF6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7985" y="3633591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>
              <a:extLst>
                <a:ext uri="{FF2B5EF4-FFF2-40B4-BE49-F238E27FC236}">
                  <a16:creationId xmlns:a16="http://schemas.microsoft.com/office/drawing/2014/main" id="{7CC14650-192E-445E-8B6C-C02B044F941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16056" y="3633591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D3962C4-5CAB-4973-9F2D-2C4D31A6B90D}"/>
                </a:ext>
              </a:extLst>
            </p:cNvPr>
            <p:cNvSpPr txBox="1"/>
            <p:nvPr/>
          </p:nvSpPr>
          <p:spPr>
            <a:xfrm rot="16200000">
              <a:off x="1386201" y="3222046"/>
              <a:ext cx="75693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protein level (fold)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0142AC7E-F6F7-4EC1-A973-91B638329EDA}"/>
              </a:ext>
            </a:extLst>
          </p:cNvPr>
          <p:cNvSpPr txBox="1"/>
          <p:nvPr/>
        </p:nvSpPr>
        <p:spPr>
          <a:xfrm>
            <a:off x="2468739" y="1462946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5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80119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차트 29">
            <a:extLst>
              <a:ext uri="{FF2B5EF4-FFF2-40B4-BE49-F238E27FC236}">
                <a16:creationId xmlns:a16="http://schemas.microsoft.com/office/drawing/2014/main" id="{AE3B99E1-1111-4913-8164-C4414C359A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6337430"/>
              </p:ext>
            </p:extLst>
          </p:nvPr>
        </p:nvGraphicFramePr>
        <p:xfrm>
          <a:off x="1629872" y="3932396"/>
          <a:ext cx="1307638" cy="9630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1" name="직사각형 30">
            <a:extLst>
              <a:ext uri="{FF2B5EF4-FFF2-40B4-BE49-F238E27FC236}">
                <a16:creationId xmlns:a16="http://schemas.microsoft.com/office/drawing/2014/main" id="{9BD85240-8789-488A-9AFA-7EF5B3209477}"/>
              </a:ext>
            </a:extLst>
          </p:cNvPr>
          <p:cNvSpPr/>
          <p:nvPr/>
        </p:nvSpPr>
        <p:spPr>
          <a:xfrm>
            <a:off x="1730837" y="4017717"/>
            <a:ext cx="1307638" cy="1614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500"/>
              </a:lnSpc>
              <a:defRPr sz="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ADP</a:t>
            </a: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bose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4C5B051-4333-46F5-ACC5-71C81B705BF2}"/>
              </a:ext>
            </a:extLst>
          </p:cNvPr>
          <p:cNvSpPr txBox="1"/>
          <p:nvPr/>
        </p:nvSpPr>
        <p:spPr>
          <a:xfrm rot="16200000">
            <a:off x="113382" y="5269004"/>
            <a:ext cx="2606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protein level  (Fold)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4" name="차트 33">
            <a:extLst>
              <a:ext uri="{FF2B5EF4-FFF2-40B4-BE49-F238E27FC236}">
                <a16:creationId xmlns:a16="http://schemas.microsoft.com/office/drawing/2014/main" id="{4BE212D5-E414-4F17-9435-EDFAFD403E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1347615"/>
              </p:ext>
            </p:extLst>
          </p:nvPr>
        </p:nvGraphicFramePr>
        <p:xfrm>
          <a:off x="1616876" y="4844740"/>
          <a:ext cx="1320634" cy="7910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5" name="직사각형 34">
            <a:extLst>
              <a:ext uri="{FF2B5EF4-FFF2-40B4-BE49-F238E27FC236}">
                <a16:creationId xmlns:a16="http://schemas.microsoft.com/office/drawing/2014/main" id="{6FA63C49-314E-4899-84E3-281DCF47B09E}"/>
              </a:ext>
            </a:extLst>
          </p:cNvPr>
          <p:cNvSpPr/>
          <p:nvPr/>
        </p:nvSpPr>
        <p:spPr>
          <a:xfrm>
            <a:off x="2020423" y="4892671"/>
            <a:ext cx="602002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PARP-1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직사각형 35">
            <a:extLst>
              <a:ext uri="{FF2B5EF4-FFF2-40B4-BE49-F238E27FC236}">
                <a16:creationId xmlns:a16="http://schemas.microsoft.com/office/drawing/2014/main" id="{816D14A5-5939-4A62-A84C-AF1B9958A7AB}"/>
              </a:ext>
            </a:extLst>
          </p:cNvPr>
          <p:cNvSpPr/>
          <p:nvPr/>
        </p:nvSpPr>
        <p:spPr>
          <a:xfrm>
            <a:off x="1760170" y="5945876"/>
            <a:ext cx="1051913" cy="24418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37" name="차트 36">
            <a:extLst>
              <a:ext uri="{FF2B5EF4-FFF2-40B4-BE49-F238E27FC236}">
                <a16:creationId xmlns:a16="http://schemas.microsoft.com/office/drawing/2014/main" id="{0C949382-8381-4E66-9497-D7E7B1EFFF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8398120"/>
              </p:ext>
            </p:extLst>
          </p:nvPr>
        </p:nvGraphicFramePr>
        <p:xfrm>
          <a:off x="1590081" y="5699159"/>
          <a:ext cx="1347426" cy="6566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8" name="직사각형 37">
            <a:extLst>
              <a:ext uri="{FF2B5EF4-FFF2-40B4-BE49-F238E27FC236}">
                <a16:creationId xmlns:a16="http://schemas.microsoft.com/office/drawing/2014/main" id="{AD28AA61-EB9F-4203-AD2B-B8194998CF8E}"/>
              </a:ext>
            </a:extLst>
          </p:cNvPr>
          <p:cNvSpPr/>
          <p:nvPr/>
        </p:nvSpPr>
        <p:spPr>
          <a:xfrm>
            <a:off x="1928870" y="5545232"/>
            <a:ext cx="681966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6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caspase-8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0" name="차트 39">
            <a:extLst>
              <a:ext uri="{FF2B5EF4-FFF2-40B4-BE49-F238E27FC236}">
                <a16:creationId xmlns:a16="http://schemas.microsoft.com/office/drawing/2014/main" id="{3ED19FA9-A478-46C8-9B63-071D26CC2D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1553188"/>
              </p:ext>
            </p:extLst>
          </p:nvPr>
        </p:nvGraphicFramePr>
        <p:xfrm>
          <a:off x="1609131" y="6391688"/>
          <a:ext cx="1347423" cy="7501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1" name="직사각형 40">
            <a:extLst>
              <a:ext uri="{FF2B5EF4-FFF2-40B4-BE49-F238E27FC236}">
                <a16:creationId xmlns:a16="http://schemas.microsoft.com/office/drawing/2014/main" id="{A4014EAD-7A83-4D34-B5B1-6209B47BB136}"/>
              </a:ext>
            </a:extLst>
          </p:cNvPr>
          <p:cNvSpPr/>
          <p:nvPr/>
        </p:nvSpPr>
        <p:spPr>
          <a:xfrm>
            <a:off x="1959940" y="6347091"/>
            <a:ext cx="655577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caspase-3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EDAAF724-0D37-4123-9FBF-B931AAFAB038}"/>
              </a:ext>
            </a:extLst>
          </p:cNvPr>
          <p:cNvSpPr/>
          <p:nvPr/>
        </p:nvSpPr>
        <p:spPr>
          <a:xfrm>
            <a:off x="1681130" y="7203221"/>
            <a:ext cx="1095084" cy="2682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aphicFrame>
        <p:nvGraphicFramePr>
          <p:cNvPr id="43" name="차트 42">
            <a:extLst>
              <a:ext uri="{FF2B5EF4-FFF2-40B4-BE49-F238E27FC236}">
                <a16:creationId xmlns:a16="http://schemas.microsoft.com/office/drawing/2014/main" id="{3B2AA9D2-06FB-4509-9886-E8866613C1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4735935"/>
              </p:ext>
            </p:extLst>
          </p:nvPr>
        </p:nvGraphicFramePr>
        <p:xfrm>
          <a:off x="1608085" y="7171966"/>
          <a:ext cx="1354187" cy="7501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4" name="직사각형 43">
            <a:extLst>
              <a:ext uri="{FF2B5EF4-FFF2-40B4-BE49-F238E27FC236}">
                <a16:creationId xmlns:a16="http://schemas.microsoft.com/office/drawing/2014/main" id="{439359DF-97B7-4BCF-80FC-EB3DB228B1B8}"/>
              </a:ext>
            </a:extLst>
          </p:cNvPr>
          <p:cNvSpPr/>
          <p:nvPr/>
        </p:nvSpPr>
        <p:spPr>
          <a:xfrm>
            <a:off x="1965431" y="7167112"/>
            <a:ext cx="54597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6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286652D6-26B2-4F69-91A2-E3280A79C3F3}"/>
              </a:ext>
            </a:extLst>
          </p:cNvPr>
          <p:cNvCxnSpPr/>
          <p:nvPr/>
        </p:nvCxnSpPr>
        <p:spPr>
          <a:xfrm>
            <a:off x="1525321" y="4115741"/>
            <a:ext cx="0" cy="37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3434BEC1-AD89-4C44-A98C-79E1D341D0BC}"/>
              </a:ext>
            </a:extLst>
          </p:cNvPr>
          <p:cNvSpPr txBox="1"/>
          <p:nvPr/>
        </p:nvSpPr>
        <p:spPr>
          <a:xfrm>
            <a:off x="2130253" y="1581150"/>
            <a:ext cx="81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A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DCA8AB4-D6B7-490E-885A-04D5981F0CEC}"/>
              </a:ext>
            </a:extLst>
          </p:cNvPr>
          <p:cNvSpPr txBox="1"/>
          <p:nvPr/>
        </p:nvSpPr>
        <p:spPr>
          <a:xfrm>
            <a:off x="4427023" y="1600200"/>
            <a:ext cx="8050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C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64801C7-9617-4AC2-8A55-200B8D3E5FBC}"/>
              </a:ext>
            </a:extLst>
          </p:cNvPr>
          <p:cNvSpPr txBox="1"/>
          <p:nvPr/>
        </p:nvSpPr>
        <p:spPr>
          <a:xfrm>
            <a:off x="2022581" y="3676650"/>
            <a:ext cx="797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E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50FDBD4-395C-4A99-9428-71B72589B633}"/>
              </a:ext>
            </a:extLst>
          </p:cNvPr>
          <p:cNvSpPr txBox="1"/>
          <p:nvPr/>
        </p:nvSpPr>
        <p:spPr>
          <a:xfrm>
            <a:off x="4318106" y="3676650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F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6" name="차트 55">
            <a:extLst>
              <a:ext uri="{FF2B5EF4-FFF2-40B4-BE49-F238E27FC236}">
                <a16:creationId xmlns:a16="http://schemas.microsoft.com/office/drawing/2014/main" id="{B395E668-CB71-4F30-80FC-D3ADB9FB81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8137832"/>
              </p:ext>
            </p:extLst>
          </p:nvPr>
        </p:nvGraphicFramePr>
        <p:xfrm>
          <a:off x="3946524" y="3877281"/>
          <a:ext cx="1242694" cy="1125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7" name="차트 56">
            <a:extLst>
              <a:ext uri="{FF2B5EF4-FFF2-40B4-BE49-F238E27FC236}">
                <a16:creationId xmlns:a16="http://schemas.microsoft.com/office/drawing/2014/main" id="{80ECE664-1AF3-456C-B606-8AAD7247D9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4189567"/>
              </p:ext>
            </p:extLst>
          </p:nvPr>
        </p:nvGraphicFramePr>
        <p:xfrm>
          <a:off x="3946524" y="4964207"/>
          <a:ext cx="1242693" cy="1125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58" name="차트 57">
            <a:extLst>
              <a:ext uri="{FF2B5EF4-FFF2-40B4-BE49-F238E27FC236}">
                <a16:creationId xmlns:a16="http://schemas.microsoft.com/office/drawing/2014/main" id="{666330D4-CAF2-4371-82B2-3BF7A5CABC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1996676"/>
              </p:ext>
            </p:extLst>
          </p:nvPr>
        </p:nvGraphicFramePr>
        <p:xfrm>
          <a:off x="3940859" y="6022360"/>
          <a:ext cx="1242693" cy="8950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59" name="차트 58">
            <a:extLst>
              <a:ext uri="{FF2B5EF4-FFF2-40B4-BE49-F238E27FC236}">
                <a16:creationId xmlns:a16="http://schemas.microsoft.com/office/drawing/2014/main" id="{4A1694EE-4772-422E-B4F0-28247736E2C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1221779"/>
              </p:ext>
            </p:extLst>
          </p:nvPr>
        </p:nvGraphicFramePr>
        <p:xfrm>
          <a:off x="3952875" y="6933328"/>
          <a:ext cx="1208347" cy="9684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60" name="직사각형 59">
            <a:extLst>
              <a:ext uri="{FF2B5EF4-FFF2-40B4-BE49-F238E27FC236}">
                <a16:creationId xmlns:a16="http://schemas.microsoft.com/office/drawing/2014/main" id="{47C7D447-9EB6-45E8-8567-F1D60A203E21}"/>
              </a:ext>
            </a:extLst>
          </p:cNvPr>
          <p:cNvSpPr/>
          <p:nvPr/>
        </p:nvSpPr>
        <p:spPr>
          <a:xfrm>
            <a:off x="4200319" y="4978434"/>
            <a:ext cx="71611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7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PARP-1</a:t>
            </a:r>
            <a:endParaRPr lang="ko-KR" altLang="ko-K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9D94B221-9846-48C9-B5B1-24A8F6A77EDB}"/>
              </a:ext>
            </a:extLst>
          </p:cNvPr>
          <p:cNvSpPr/>
          <p:nvPr/>
        </p:nvSpPr>
        <p:spPr>
          <a:xfrm>
            <a:off x="4255334" y="3930684"/>
            <a:ext cx="77938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7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ADP</a:t>
            </a: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bose</a:t>
            </a:r>
            <a:endParaRPr lang="ko-KR" altLang="ko-K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7DFD7998-8827-4F63-9A81-8239BA2FB777}"/>
              </a:ext>
            </a:extLst>
          </p:cNvPr>
          <p:cNvSpPr/>
          <p:nvPr/>
        </p:nvSpPr>
        <p:spPr>
          <a:xfrm>
            <a:off x="4345160" y="5974968"/>
            <a:ext cx="439344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6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92C746EA-8EDF-438D-91F8-17C608F74E76}"/>
              </a:ext>
            </a:extLst>
          </p:cNvPr>
          <p:cNvSpPr/>
          <p:nvPr/>
        </p:nvSpPr>
        <p:spPr>
          <a:xfrm>
            <a:off x="4393971" y="6929857"/>
            <a:ext cx="50687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3K9Ac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8633DF62-E8E1-4009-9D38-4C38664628D1}"/>
              </a:ext>
            </a:extLst>
          </p:cNvPr>
          <p:cNvCxnSpPr/>
          <p:nvPr/>
        </p:nvCxnSpPr>
        <p:spPr>
          <a:xfrm>
            <a:off x="3963721" y="4039541"/>
            <a:ext cx="0" cy="3744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FD57DB5A-9014-46B6-A2DB-70312F31900A}"/>
              </a:ext>
            </a:extLst>
          </p:cNvPr>
          <p:cNvSpPr txBox="1"/>
          <p:nvPr/>
        </p:nvSpPr>
        <p:spPr>
          <a:xfrm rot="16200000">
            <a:off x="2939492" y="5618612"/>
            <a:ext cx="18122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protein level  (Fold)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9" name="차트 68">
            <a:extLst>
              <a:ext uri="{FF2B5EF4-FFF2-40B4-BE49-F238E27FC236}">
                <a16:creationId xmlns:a16="http://schemas.microsoft.com/office/drawing/2014/main" id="{A028FA63-5BD1-4172-92DC-FE22CE6002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7141833"/>
              </p:ext>
            </p:extLst>
          </p:nvPr>
        </p:nvGraphicFramePr>
        <p:xfrm>
          <a:off x="1416167" y="3051014"/>
          <a:ext cx="1992724" cy="558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71" name="차트 70">
            <a:extLst>
              <a:ext uri="{FF2B5EF4-FFF2-40B4-BE49-F238E27FC236}">
                <a16:creationId xmlns:a16="http://schemas.microsoft.com/office/drawing/2014/main" id="{736CEA82-8D6D-4507-8341-C647DCD870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0014048"/>
              </p:ext>
            </p:extLst>
          </p:nvPr>
        </p:nvGraphicFramePr>
        <p:xfrm>
          <a:off x="1407762" y="2009223"/>
          <a:ext cx="1999329" cy="5814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72" name="TextBox 71">
            <a:extLst>
              <a:ext uri="{FF2B5EF4-FFF2-40B4-BE49-F238E27FC236}">
                <a16:creationId xmlns:a16="http://schemas.microsoft.com/office/drawing/2014/main" id="{485AEF9F-1D9A-41FD-A739-2DAB5D07B727}"/>
              </a:ext>
            </a:extLst>
          </p:cNvPr>
          <p:cNvSpPr txBox="1"/>
          <p:nvPr/>
        </p:nvSpPr>
        <p:spPr>
          <a:xfrm rot="16200000">
            <a:off x="732299" y="2685774"/>
            <a:ext cx="1372139" cy="174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protein  level (Fold)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4BCAFE5-0795-405B-8872-2D3439BDEB1B}"/>
              </a:ext>
            </a:extLst>
          </p:cNvPr>
          <p:cNvSpPr txBox="1"/>
          <p:nvPr/>
        </p:nvSpPr>
        <p:spPr>
          <a:xfrm>
            <a:off x="2099095" y="2022971"/>
            <a:ext cx="7793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ADP</a:t>
            </a: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bose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5" name="차트 74">
            <a:extLst>
              <a:ext uri="{FF2B5EF4-FFF2-40B4-BE49-F238E27FC236}">
                <a16:creationId xmlns:a16="http://schemas.microsoft.com/office/drawing/2014/main" id="{49C73DE2-EE00-4983-839A-EFF3151B7F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4123195"/>
              </p:ext>
            </p:extLst>
          </p:nvPr>
        </p:nvGraphicFramePr>
        <p:xfrm>
          <a:off x="1425691" y="2517450"/>
          <a:ext cx="1992720" cy="6162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77" name="TextBox 76">
            <a:extLst>
              <a:ext uri="{FF2B5EF4-FFF2-40B4-BE49-F238E27FC236}">
                <a16:creationId xmlns:a16="http://schemas.microsoft.com/office/drawing/2014/main" id="{C11A5610-8703-46FA-A9D8-2BF5E45AE1B8}"/>
              </a:ext>
            </a:extLst>
          </p:cNvPr>
          <p:cNvSpPr txBox="1"/>
          <p:nvPr/>
        </p:nvSpPr>
        <p:spPr>
          <a:xfrm>
            <a:off x="2300130" y="2922043"/>
            <a:ext cx="392584" cy="1663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6</a:t>
            </a:r>
            <a:endParaRPr lang="ko-KR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1413D99-2266-4CC1-987F-9FB400C3C8BB}"/>
              </a:ext>
            </a:extLst>
          </p:cNvPr>
          <p:cNvSpPr txBox="1"/>
          <p:nvPr/>
        </p:nvSpPr>
        <p:spPr>
          <a:xfrm>
            <a:off x="2313170" y="3081085"/>
            <a:ext cx="5453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3K9Ac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12ACB49-5A54-408A-A83B-A6BCA1CD64FE}"/>
              </a:ext>
            </a:extLst>
          </p:cNvPr>
          <p:cNvSpPr txBox="1"/>
          <p:nvPr/>
        </p:nvSpPr>
        <p:spPr>
          <a:xfrm>
            <a:off x="4512734" y="2074130"/>
            <a:ext cx="7793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ADP</a:t>
            </a: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bose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2" name="차트 81">
            <a:extLst>
              <a:ext uri="{FF2B5EF4-FFF2-40B4-BE49-F238E27FC236}">
                <a16:creationId xmlns:a16="http://schemas.microsoft.com/office/drawing/2014/main" id="{AAA7A1EE-8B41-44D3-BDBA-39D9A2A9DE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4477634"/>
              </p:ext>
            </p:extLst>
          </p:nvPr>
        </p:nvGraphicFramePr>
        <p:xfrm>
          <a:off x="3752149" y="2029626"/>
          <a:ext cx="2078607" cy="7511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83" name="직사각형 82">
            <a:extLst>
              <a:ext uri="{FF2B5EF4-FFF2-40B4-BE49-F238E27FC236}">
                <a16:creationId xmlns:a16="http://schemas.microsoft.com/office/drawing/2014/main" id="{10656B1D-5695-40B0-938B-BC6661ED62E7}"/>
              </a:ext>
            </a:extLst>
          </p:cNvPr>
          <p:cNvSpPr/>
          <p:nvPr/>
        </p:nvSpPr>
        <p:spPr>
          <a:xfrm>
            <a:off x="4005537" y="2837957"/>
            <a:ext cx="1772782" cy="757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6A76093-B82E-4D84-89EA-121411A726AA}"/>
              </a:ext>
            </a:extLst>
          </p:cNvPr>
          <p:cNvSpPr txBox="1"/>
          <p:nvPr/>
        </p:nvSpPr>
        <p:spPr>
          <a:xfrm>
            <a:off x="4674883" y="2882848"/>
            <a:ext cx="360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IF</a:t>
            </a:r>
            <a:endParaRPr lang="ko-KR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5" name="차트 84">
            <a:extLst>
              <a:ext uri="{FF2B5EF4-FFF2-40B4-BE49-F238E27FC236}">
                <a16:creationId xmlns:a16="http://schemas.microsoft.com/office/drawing/2014/main" id="{5B5CA158-4EFB-402C-A1CA-C23C1A1ABE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359053"/>
              </p:ext>
            </p:extLst>
          </p:nvPr>
        </p:nvGraphicFramePr>
        <p:xfrm>
          <a:off x="3754434" y="2863093"/>
          <a:ext cx="2169871" cy="5497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86" name="TextBox 85">
            <a:extLst>
              <a:ext uri="{FF2B5EF4-FFF2-40B4-BE49-F238E27FC236}">
                <a16:creationId xmlns:a16="http://schemas.microsoft.com/office/drawing/2014/main" id="{E92BE902-CCC5-44F5-B842-F8B8FF8B9819}"/>
              </a:ext>
            </a:extLst>
          </p:cNvPr>
          <p:cNvSpPr txBox="1"/>
          <p:nvPr/>
        </p:nvSpPr>
        <p:spPr>
          <a:xfrm rot="16200000">
            <a:off x="3014353" y="2600125"/>
            <a:ext cx="1545289" cy="174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protein  level (Fold)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408CB6F-D4C1-40A1-80AB-2BA8C058E3A8}"/>
              </a:ext>
            </a:extLst>
          </p:cNvPr>
          <p:cNvSpPr txBox="1"/>
          <p:nvPr/>
        </p:nvSpPr>
        <p:spPr>
          <a:xfrm>
            <a:off x="4719480" y="2883943"/>
            <a:ext cx="3925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IF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7627C32-C225-44D4-A1F2-FE77A543821A}"/>
              </a:ext>
            </a:extLst>
          </p:cNvPr>
          <p:cNvSpPr txBox="1"/>
          <p:nvPr/>
        </p:nvSpPr>
        <p:spPr>
          <a:xfrm>
            <a:off x="2300130" y="2598193"/>
            <a:ext cx="3925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6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2DD28D0-37CB-45CF-8014-F7FC0239D013}"/>
              </a:ext>
            </a:extLst>
          </p:cNvPr>
          <p:cNvSpPr txBox="1"/>
          <p:nvPr/>
        </p:nvSpPr>
        <p:spPr>
          <a:xfrm>
            <a:off x="2468739" y="906353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6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09136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81099DC-99D6-4399-BA94-3BC2B2051870}"/>
              </a:ext>
            </a:extLst>
          </p:cNvPr>
          <p:cNvSpPr txBox="1"/>
          <p:nvPr/>
        </p:nvSpPr>
        <p:spPr>
          <a:xfrm>
            <a:off x="1009263" y="3075051"/>
            <a:ext cx="7328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 3B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5101A1AB-FA52-4108-899D-F9C615742D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0958" y="3241458"/>
            <a:ext cx="3764017" cy="83325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FBFDDEA-6CEF-4743-9F44-7FE06754DF85}"/>
              </a:ext>
            </a:extLst>
          </p:cNvPr>
          <p:cNvSpPr txBox="1"/>
          <p:nvPr/>
        </p:nvSpPr>
        <p:spPr>
          <a:xfrm rot="16200000">
            <a:off x="1266592" y="3453887"/>
            <a:ext cx="10342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level (fold)</a:t>
            </a:r>
            <a:endParaRPr lang="ko-KR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F711B20-D638-4042-840B-10850BA82471}"/>
              </a:ext>
            </a:extLst>
          </p:cNvPr>
          <p:cNvSpPr txBox="1"/>
          <p:nvPr/>
        </p:nvSpPr>
        <p:spPr>
          <a:xfrm>
            <a:off x="1009263" y="4105305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3D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A2F0CB1-4ECB-4C54-A13D-DC0F2539A6A9}"/>
              </a:ext>
            </a:extLst>
          </p:cNvPr>
          <p:cNvSpPr txBox="1"/>
          <p:nvPr/>
        </p:nvSpPr>
        <p:spPr>
          <a:xfrm rot="16200000">
            <a:off x="1483190" y="4395271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</a:t>
            </a:r>
          </a:p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 (fold)</a:t>
            </a:r>
            <a:endParaRPr lang="ko-KR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4986D4B3-C6A7-4E7C-8974-C922AB8FBA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0147" y="4011724"/>
            <a:ext cx="1157216" cy="128397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810CAE2-387E-4524-93B3-BBF1DD7F5A2F}"/>
              </a:ext>
            </a:extLst>
          </p:cNvPr>
          <p:cNvSpPr txBox="1"/>
          <p:nvPr/>
        </p:nvSpPr>
        <p:spPr>
          <a:xfrm rot="16200000">
            <a:off x="995168" y="5804450"/>
            <a:ext cx="1496292" cy="1518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400"/>
              </a:lnSpc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level (fold)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EDFD3D53-C82F-4025-819C-5F64F7BA3E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89058" y="5247097"/>
            <a:ext cx="2153295" cy="149629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997EE6AD-3161-45B1-B7F0-B310CE4D0943}"/>
              </a:ext>
            </a:extLst>
          </p:cNvPr>
          <p:cNvSpPr txBox="1"/>
          <p:nvPr/>
        </p:nvSpPr>
        <p:spPr>
          <a:xfrm>
            <a:off x="1009263" y="5168055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3F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E462A4DC-8BC8-4A6E-A708-92D77BF27D8E}"/>
              </a:ext>
            </a:extLst>
          </p:cNvPr>
          <p:cNvSpPr/>
          <p:nvPr/>
        </p:nvSpPr>
        <p:spPr>
          <a:xfrm>
            <a:off x="1009263" y="2028155"/>
            <a:ext cx="7409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srgbClr val="212121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 3A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3480AAE3-C394-4A0C-B771-32237196D1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08376" y="2001291"/>
            <a:ext cx="1157217" cy="117204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25B5FDBA-F880-42CB-BAB9-C3D968D8952F}"/>
              </a:ext>
            </a:extLst>
          </p:cNvPr>
          <p:cNvSpPr txBox="1"/>
          <p:nvPr/>
        </p:nvSpPr>
        <p:spPr>
          <a:xfrm rot="16200000">
            <a:off x="1300316" y="2330870"/>
            <a:ext cx="11043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</a:t>
            </a:r>
          </a:p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 (fold)</a:t>
            </a:r>
            <a:endParaRPr lang="ko-KR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65BC563-53C2-4EB1-9C06-40CAA5B06996}"/>
              </a:ext>
            </a:extLst>
          </p:cNvPr>
          <p:cNvSpPr txBox="1"/>
          <p:nvPr/>
        </p:nvSpPr>
        <p:spPr>
          <a:xfrm>
            <a:off x="2468739" y="1264162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7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73679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642CA1C2-8E6A-4A89-8C02-BDA67ACABF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5331" y="2390658"/>
            <a:ext cx="1797256" cy="65354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A3E6BF0-81C4-475E-9961-9887D2AA9608}"/>
              </a:ext>
            </a:extLst>
          </p:cNvPr>
          <p:cNvSpPr txBox="1"/>
          <p:nvPr/>
        </p:nvSpPr>
        <p:spPr>
          <a:xfrm>
            <a:off x="1036604" y="2170338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4A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FFDBC9-4DD6-4A54-843F-BB99B4267BE5}"/>
              </a:ext>
            </a:extLst>
          </p:cNvPr>
          <p:cNvSpPr txBox="1"/>
          <p:nvPr/>
        </p:nvSpPr>
        <p:spPr>
          <a:xfrm rot="16200000">
            <a:off x="1465436" y="2579871"/>
            <a:ext cx="756938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level (fold)</a:t>
            </a:r>
            <a:endParaRPr lang="ko-KR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3D90F490-A714-4258-B188-30E65218A75B}"/>
              </a:ext>
            </a:extLst>
          </p:cNvPr>
          <p:cNvGrpSpPr/>
          <p:nvPr/>
        </p:nvGrpSpPr>
        <p:grpSpPr>
          <a:xfrm>
            <a:off x="1879857" y="2926358"/>
            <a:ext cx="1605617" cy="153888"/>
            <a:chOff x="1210227" y="8218804"/>
            <a:chExt cx="1605617" cy="153888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7688017-D84D-40BC-BCAB-8C9168B8AE7E}"/>
                </a:ext>
              </a:extLst>
            </p:cNvPr>
            <p:cNvSpPr txBox="1"/>
            <p:nvPr/>
          </p:nvSpPr>
          <p:spPr>
            <a:xfrm>
              <a:off x="1210227" y="8218804"/>
              <a:ext cx="7761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s            Times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직선 연결선 20">
              <a:extLst>
                <a:ext uri="{FF2B5EF4-FFF2-40B4-BE49-F238E27FC236}">
                  <a16:creationId xmlns:a16="http://schemas.microsoft.com/office/drawing/2014/main" id="{395A3D8F-7A34-4396-8F92-4E4DA96B75D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91507" y="8261984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직선 연결선 21">
              <a:extLst>
                <a:ext uri="{FF2B5EF4-FFF2-40B4-BE49-F238E27FC236}">
                  <a16:creationId xmlns:a16="http://schemas.microsoft.com/office/drawing/2014/main" id="{F6A145EB-1DCE-4190-9818-3C53C0173E9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49578" y="8261984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4AB4774-68A8-4A21-B056-E4AA2213085D}"/>
                </a:ext>
              </a:extLst>
            </p:cNvPr>
            <p:cNvSpPr txBox="1"/>
            <p:nvPr/>
          </p:nvSpPr>
          <p:spPr>
            <a:xfrm>
              <a:off x="2039669" y="8218804"/>
              <a:ext cx="776175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entrations            Times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56E56D5B-F871-4C67-82ED-92348CF69C2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20949" y="8261984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FA3678E9-DEE9-407F-B3A7-6EB7F3087AA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79020" y="8261984"/>
              <a:ext cx="32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06470652-7F8B-4BFD-A698-2339F2F1C94F}"/>
              </a:ext>
            </a:extLst>
          </p:cNvPr>
          <p:cNvSpPr txBox="1"/>
          <p:nvPr/>
        </p:nvSpPr>
        <p:spPr>
          <a:xfrm>
            <a:off x="1036604" y="3101461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4C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C0487A02-0D4C-47E2-B3AC-01034939DC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3502" y="4995129"/>
            <a:ext cx="704759" cy="73646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987106D-865C-477B-8AA8-C87A0FEDB09F}"/>
              </a:ext>
            </a:extLst>
          </p:cNvPr>
          <p:cNvSpPr txBox="1"/>
          <p:nvPr/>
        </p:nvSpPr>
        <p:spPr>
          <a:xfrm rot="16200000">
            <a:off x="1523635" y="5153199"/>
            <a:ext cx="638316" cy="194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400"/>
              </a:lnSpc>
            </a:pPr>
            <a:r>
              <a:rPr lang="en-US" altLang="ko-KR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level </a:t>
            </a:r>
          </a:p>
          <a:p>
            <a:pPr algn="ctr">
              <a:lnSpc>
                <a:spcPts val="400"/>
              </a:lnSpc>
            </a:pPr>
            <a:r>
              <a:rPr lang="en-US" altLang="ko-KR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old)</a:t>
            </a:r>
            <a:endParaRPr lang="ko-KR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그룹 9">
            <a:extLst>
              <a:ext uri="{FF2B5EF4-FFF2-40B4-BE49-F238E27FC236}">
                <a16:creationId xmlns:a16="http://schemas.microsoft.com/office/drawing/2014/main" id="{75E16BB6-849C-4AB4-877B-6BF669AF4F91}"/>
              </a:ext>
            </a:extLst>
          </p:cNvPr>
          <p:cNvGrpSpPr/>
          <p:nvPr/>
        </p:nvGrpSpPr>
        <p:grpSpPr>
          <a:xfrm>
            <a:off x="1733152" y="3170497"/>
            <a:ext cx="4067522" cy="772407"/>
            <a:chOff x="1391637" y="6601993"/>
            <a:chExt cx="4067522" cy="772407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A9DF0FD-D72D-4C96-8664-FC7FD5D55125}"/>
                </a:ext>
              </a:extLst>
            </p:cNvPr>
            <p:cNvSpPr txBox="1"/>
            <p:nvPr/>
          </p:nvSpPr>
          <p:spPr>
            <a:xfrm rot="16200000">
              <a:off x="1169942" y="6823688"/>
              <a:ext cx="638316" cy="1949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420"/>
                </a:lnSpc>
              </a:pPr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protein level </a:t>
              </a:r>
            </a:p>
            <a:p>
              <a:pPr algn="ctr">
                <a:lnSpc>
                  <a:spcPts val="420"/>
                </a:lnSpc>
              </a:pPr>
              <a:r>
                <a:rPr lang="en-US" altLang="ko-KR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fold)</a:t>
              </a:r>
              <a:endParaRPr lang="ko-KR" alt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4F00D751-F551-40E5-A241-61C0541F69B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98854" y="6679396"/>
              <a:ext cx="3960305" cy="695004"/>
            </a:xfrm>
            <a:prstGeom prst="rect">
              <a:avLst/>
            </a:prstGeom>
          </p:spPr>
        </p:pic>
      </p:grpSp>
      <p:pic>
        <p:nvPicPr>
          <p:cNvPr id="11" name="그림 10">
            <a:extLst>
              <a:ext uri="{FF2B5EF4-FFF2-40B4-BE49-F238E27FC236}">
                <a16:creationId xmlns:a16="http://schemas.microsoft.com/office/drawing/2014/main" id="{A3A52E2F-023D-49DA-B716-7FAC26FB55B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43112" y="4140229"/>
            <a:ext cx="3960305" cy="69500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7980FD7-97DD-46A6-8D69-81BE779252CB}"/>
              </a:ext>
            </a:extLst>
          </p:cNvPr>
          <p:cNvSpPr txBox="1"/>
          <p:nvPr/>
        </p:nvSpPr>
        <p:spPr>
          <a:xfrm rot="16200000">
            <a:off x="1513794" y="4255792"/>
            <a:ext cx="638316" cy="194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420"/>
              </a:lnSpc>
            </a:pPr>
            <a:r>
              <a:rPr lang="en-US" altLang="ko-KR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level </a:t>
            </a:r>
          </a:p>
          <a:p>
            <a:pPr algn="ctr">
              <a:lnSpc>
                <a:spcPts val="420"/>
              </a:lnSpc>
            </a:pPr>
            <a:r>
              <a:rPr lang="en-US" altLang="ko-KR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old)</a:t>
            </a:r>
            <a:endParaRPr lang="ko-KR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1C72270A-93DA-453D-AF44-B1552A26304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48192" y="5892728"/>
            <a:ext cx="3960305" cy="8779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A768195-F176-4735-B378-975B48B8F154}"/>
              </a:ext>
            </a:extLst>
          </p:cNvPr>
          <p:cNvSpPr txBox="1"/>
          <p:nvPr/>
        </p:nvSpPr>
        <p:spPr>
          <a:xfrm rot="16200000">
            <a:off x="1513795" y="5993666"/>
            <a:ext cx="638316" cy="194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420"/>
              </a:lnSpc>
            </a:pPr>
            <a:r>
              <a:rPr lang="en-US" altLang="ko-KR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level </a:t>
            </a:r>
          </a:p>
          <a:p>
            <a:pPr algn="ctr">
              <a:lnSpc>
                <a:spcPts val="420"/>
              </a:lnSpc>
            </a:pPr>
            <a:r>
              <a:rPr lang="en-US" altLang="ko-KR" sz="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old)</a:t>
            </a:r>
            <a:endParaRPr lang="ko-KR" altLang="en-US" sz="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0BFDC19-4954-4A90-9091-86CA528767D7}"/>
              </a:ext>
            </a:extLst>
          </p:cNvPr>
          <p:cNvSpPr txBox="1"/>
          <p:nvPr/>
        </p:nvSpPr>
        <p:spPr>
          <a:xfrm>
            <a:off x="1036604" y="3970008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4E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68C52D3-17BC-4383-A4B2-4D4F366B4905}"/>
              </a:ext>
            </a:extLst>
          </p:cNvPr>
          <p:cNvSpPr txBox="1"/>
          <p:nvPr/>
        </p:nvSpPr>
        <p:spPr>
          <a:xfrm>
            <a:off x="1036604" y="4852030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4F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2BB9E5-563F-430D-BC0B-35EFAD93C233}"/>
              </a:ext>
            </a:extLst>
          </p:cNvPr>
          <p:cNvSpPr txBox="1"/>
          <p:nvPr/>
        </p:nvSpPr>
        <p:spPr>
          <a:xfrm>
            <a:off x="1036604" y="5693700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4G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E613CAF-F488-40D6-B2E4-3026933E7D19}"/>
              </a:ext>
            </a:extLst>
          </p:cNvPr>
          <p:cNvSpPr txBox="1"/>
          <p:nvPr/>
        </p:nvSpPr>
        <p:spPr>
          <a:xfrm>
            <a:off x="2521747" y="1396685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8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93136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E9A3365-3529-4C07-9937-F9F17561F3AD}"/>
              </a:ext>
            </a:extLst>
          </p:cNvPr>
          <p:cNvSpPr txBox="1"/>
          <p:nvPr/>
        </p:nvSpPr>
        <p:spPr>
          <a:xfrm>
            <a:off x="1011750" y="2239625"/>
            <a:ext cx="7088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5A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5D2482F6-C129-419A-A46D-21779332D00D}"/>
              </a:ext>
            </a:extLst>
          </p:cNvPr>
          <p:cNvGrpSpPr/>
          <p:nvPr/>
        </p:nvGrpSpPr>
        <p:grpSpPr>
          <a:xfrm>
            <a:off x="1705416" y="2176302"/>
            <a:ext cx="2428433" cy="990842"/>
            <a:chOff x="1175338" y="3061108"/>
            <a:chExt cx="2153303" cy="953029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B0D1267-644D-4557-AC0B-ABBA6DAF8A3C}"/>
                </a:ext>
              </a:extLst>
            </p:cNvPr>
            <p:cNvSpPr txBox="1"/>
            <p:nvPr/>
          </p:nvSpPr>
          <p:spPr>
            <a:xfrm>
              <a:off x="2844177" y="3702652"/>
              <a:ext cx="484464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articulates</a:t>
              </a:r>
              <a:endParaRPr kumimoji="0" lang="ko-KR" altLang="en-US" sz="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grpSp>
          <p:nvGrpSpPr>
            <p:cNvPr id="13" name="그룹 12">
              <a:extLst>
                <a:ext uri="{FF2B5EF4-FFF2-40B4-BE49-F238E27FC236}">
                  <a16:creationId xmlns:a16="http://schemas.microsoft.com/office/drawing/2014/main" id="{0499B13A-0116-4AAC-A57A-D9B337101398}"/>
                </a:ext>
              </a:extLst>
            </p:cNvPr>
            <p:cNvGrpSpPr/>
            <p:nvPr/>
          </p:nvGrpSpPr>
          <p:grpSpPr>
            <a:xfrm>
              <a:off x="1175338" y="3061108"/>
              <a:ext cx="2067942" cy="953029"/>
              <a:chOff x="1160098" y="3061108"/>
              <a:chExt cx="2067942" cy="953029"/>
            </a:xfrm>
          </p:grpSpPr>
          <p:pic>
            <p:nvPicPr>
              <p:cNvPr id="14" name="그림 13">
                <a:extLst>
                  <a:ext uri="{FF2B5EF4-FFF2-40B4-BE49-F238E27FC236}">
                    <a16:creationId xmlns:a16="http://schemas.microsoft.com/office/drawing/2014/main" id="{30CD92F3-A66A-43CA-AA27-A8A1C53FDD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160098" y="3165501"/>
                <a:ext cx="2067942" cy="848636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6148078-B4B0-4F92-A404-C63BA7B4ED05}"/>
                  </a:ext>
                </a:extLst>
              </p:cNvPr>
              <p:cNvSpPr txBox="1"/>
              <p:nvPr/>
            </p:nvSpPr>
            <p:spPr>
              <a:xfrm>
                <a:off x="1374323" y="3704462"/>
                <a:ext cx="56953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Insoluble</a:t>
                </a:r>
                <a:endParaRPr kumimoji="0" lang="ko-KR" altLang="en-US" sz="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4F5D7E2-EBDF-4DB6-AB1D-E648BF94C5F5}"/>
                  </a:ext>
                </a:extLst>
              </p:cNvPr>
              <p:cNvSpPr txBox="1"/>
              <p:nvPr/>
            </p:nvSpPr>
            <p:spPr>
              <a:xfrm>
                <a:off x="1682653" y="3704462"/>
                <a:ext cx="56953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Soluble</a:t>
                </a:r>
                <a:endParaRPr kumimoji="0" lang="ko-KR" altLang="en-US" sz="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262E301-5954-435E-98B3-F23B8A9D2968}"/>
                  </a:ext>
                </a:extLst>
              </p:cNvPr>
              <p:cNvSpPr txBox="1"/>
              <p:nvPr/>
            </p:nvSpPr>
            <p:spPr>
              <a:xfrm>
                <a:off x="1931339" y="3704462"/>
                <a:ext cx="66724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Particulates</a:t>
                </a:r>
                <a:endParaRPr kumimoji="0" lang="ko-KR" altLang="en-US" sz="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직선 연결선 17">
                <a:extLst>
                  <a:ext uri="{FF2B5EF4-FFF2-40B4-BE49-F238E27FC236}">
                    <a16:creationId xmlns:a16="http://schemas.microsoft.com/office/drawing/2014/main" id="{25F1D787-7168-4069-B0DB-8198793CE428}"/>
                  </a:ext>
                </a:extLst>
              </p:cNvPr>
              <p:cNvCxnSpPr/>
              <p:nvPr/>
            </p:nvCxnSpPr>
            <p:spPr>
              <a:xfrm>
                <a:off x="1717654" y="3745190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직선 연결선 18">
                <a:extLst>
                  <a:ext uri="{FF2B5EF4-FFF2-40B4-BE49-F238E27FC236}">
                    <a16:creationId xmlns:a16="http://schemas.microsoft.com/office/drawing/2014/main" id="{BB3994BF-352A-4D0D-8058-61D83DB9EF8E}"/>
                  </a:ext>
                </a:extLst>
              </p:cNvPr>
              <p:cNvCxnSpPr/>
              <p:nvPr/>
            </p:nvCxnSpPr>
            <p:spPr>
              <a:xfrm>
                <a:off x="1435079" y="3745190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직선 연결선 19">
                <a:extLst>
                  <a:ext uri="{FF2B5EF4-FFF2-40B4-BE49-F238E27FC236}">
                    <a16:creationId xmlns:a16="http://schemas.microsoft.com/office/drawing/2014/main" id="{14A833A3-5AED-40C2-A6CC-0442DEB86898}"/>
                  </a:ext>
                </a:extLst>
              </p:cNvPr>
              <p:cNvCxnSpPr/>
              <p:nvPr/>
            </p:nvCxnSpPr>
            <p:spPr>
              <a:xfrm>
                <a:off x="2009119" y="3745190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직선 연결선 20">
                <a:extLst>
                  <a:ext uri="{FF2B5EF4-FFF2-40B4-BE49-F238E27FC236}">
                    <a16:creationId xmlns:a16="http://schemas.microsoft.com/office/drawing/2014/main" id="{53007BBD-452C-45F8-BFB7-40D016094DF4}"/>
                  </a:ext>
                </a:extLst>
              </p:cNvPr>
              <p:cNvCxnSpPr/>
              <p:nvPr/>
            </p:nvCxnSpPr>
            <p:spPr>
              <a:xfrm>
                <a:off x="2624810" y="3745638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직선 연결선 21">
                <a:extLst>
                  <a:ext uri="{FF2B5EF4-FFF2-40B4-BE49-F238E27FC236}">
                    <a16:creationId xmlns:a16="http://schemas.microsoft.com/office/drawing/2014/main" id="{45CF6409-A171-4CB5-B9B4-C77ED5E3D941}"/>
                  </a:ext>
                </a:extLst>
              </p:cNvPr>
              <p:cNvCxnSpPr/>
              <p:nvPr/>
            </p:nvCxnSpPr>
            <p:spPr>
              <a:xfrm>
                <a:off x="2342235" y="3745638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직선 연결선 22">
                <a:extLst>
                  <a:ext uri="{FF2B5EF4-FFF2-40B4-BE49-F238E27FC236}">
                    <a16:creationId xmlns:a16="http://schemas.microsoft.com/office/drawing/2014/main" id="{FB29E996-66DD-4255-B9C1-2FF695CE7F50}"/>
                  </a:ext>
                </a:extLst>
              </p:cNvPr>
              <p:cNvCxnSpPr/>
              <p:nvPr/>
            </p:nvCxnSpPr>
            <p:spPr>
              <a:xfrm>
                <a:off x="2916275" y="3745638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80E7727D-2D4F-4BC4-B165-B4404234BFF2}"/>
                  </a:ext>
                </a:extLst>
              </p:cNvPr>
              <p:cNvSpPr txBox="1"/>
              <p:nvPr/>
            </p:nvSpPr>
            <p:spPr>
              <a:xfrm>
                <a:off x="2277636" y="3702652"/>
                <a:ext cx="56953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Insoluble</a:t>
                </a:r>
                <a:endParaRPr kumimoji="0" lang="ko-KR" altLang="en-US" sz="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A1B0AC1A-0D62-43B7-B780-7A04E579D306}"/>
                  </a:ext>
                </a:extLst>
              </p:cNvPr>
              <p:cNvSpPr txBox="1"/>
              <p:nvPr/>
            </p:nvSpPr>
            <p:spPr>
              <a:xfrm>
                <a:off x="2585966" y="3702652"/>
                <a:ext cx="56953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Soluble</a:t>
                </a:r>
                <a:endParaRPr kumimoji="0" lang="ko-KR" altLang="en-US" sz="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342F8886-AA6D-4B2B-9EB3-F10069020C6F}"/>
                  </a:ext>
                </a:extLst>
              </p:cNvPr>
              <p:cNvSpPr txBox="1"/>
              <p:nvPr/>
            </p:nvSpPr>
            <p:spPr>
              <a:xfrm>
                <a:off x="1273026" y="3629829"/>
                <a:ext cx="273582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CK</a:t>
                </a:r>
                <a:endParaRPr kumimoji="0" lang="ko-KR" altLang="en-US" sz="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EA163D57-4873-49AF-9D77-138B942BF216}"/>
                  </a:ext>
                </a:extLst>
              </p:cNvPr>
              <p:cNvSpPr txBox="1"/>
              <p:nvPr/>
            </p:nvSpPr>
            <p:spPr>
              <a:xfrm rot="16200000">
                <a:off x="895677" y="3401856"/>
                <a:ext cx="825125" cy="1436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400"/>
                  </a:lnSpc>
                </a:pPr>
                <a:r>
                  <a:rPr lang="en-US" altLang="ko-KR" sz="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protein level (fold)</a:t>
                </a:r>
                <a:endParaRPr lang="ko-KR" altLang="en-US" sz="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pic>
        <p:nvPicPr>
          <p:cNvPr id="5" name="그림 4">
            <a:extLst>
              <a:ext uri="{FF2B5EF4-FFF2-40B4-BE49-F238E27FC236}">
                <a16:creationId xmlns:a16="http://schemas.microsoft.com/office/drawing/2014/main" id="{DDCB63A6-025D-40FD-9709-D7E2945322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7638" y="3194803"/>
            <a:ext cx="965279" cy="88230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198FDA4-E2ED-42A3-92C0-A59F88765392}"/>
              </a:ext>
            </a:extLst>
          </p:cNvPr>
          <p:cNvSpPr txBox="1"/>
          <p:nvPr/>
        </p:nvSpPr>
        <p:spPr>
          <a:xfrm>
            <a:off x="1011750" y="3125388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5B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F94328-D7B0-4D2D-97AB-82A585FD87AE}"/>
              </a:ext>
            </a:extLst>
          </p:cNvPr>
          <p:cNvSpPr txBox="1"/>
          <p:nvPr/>
        </p:nvSpPr>
        <p:spPr>
          <a:xfrm rot="16200000">
            <a:off x="1378277" y="3351283"/>
            <a:ext cx="8578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</a:t>
            </a:r>
          </a:p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 (fold)</a:t>
            </a:r>
            <a:endParaRPr lang="ko-KR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4565CF6-BA2B-4D78-B535-D595394DA779}"/>
              </a:ext>
            </a:extLst>
          </p:cNvPr>
          <p:cNvSpPr txBox="1"/>
          <p:nvPr/>
        </p:nvSpPr>
        <p:spPr>
          <a:xfrm>
            <a:off x="1011750" y="3968727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5C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71" name="그룹 70">
            <a:extLst>
              <a:ext uri="{FF2B5EF4-FFF2-40B4-BE49-F238E27FC236}">
                <a16:creationId xmlns:a16="http://schemas.microsoft.com/office/drawing/2014/main" id="{B708933D-01A7-442C-AB45-443A47534346}"/>
              </a:ext>
            </a:extLst>
          </p:cNvPr>
          <p:cNvGrpSpPr/>
          <p:nvPr/>
        </p:nvGrpSpPr>
        <p:grpSpPr>
          <a:xfrm>
            <a:off x="1710732" y="3844012"/>
            <a:ext cx="1059504" cy="1350418"/>
            <a:chOff x="1986957" y="3872587"/>
            <a:chExt cx="1059504" cy="1350418"/>
          </a:xfrm>
        </p:grpSpPr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5F66DF2A-A14C-415C-B3C8-EF2AEAF615F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86957" y="4019872"/>
              <a:ext cx="1059504" cy="1203133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8656FCA-EDD9-4F4B-8161-5584868E0D40}"/>
                </a:ext>
              </a:extLst>
            </p:cNvPr>
            <p:cNvSpPr txBox="1"/>
            <p:nvPr/>
          </p:nvSpPr>
          <p:spPr>
            <a:xfrm rot="16200000">
              <a:off x="1452518" y="4408941"/>
              <a:ext cx="1221596" cy="148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400"/>
                </a:lnSpc>
              </a:pPr>
              <a:r>
                <a:rPr lang="en-US" altLang="ko-KR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protein level (fold)</a:t>
              </a:r>
              <a:endParaRPr lang="ko-KR" altLang="en-US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CDD8209B-D2A6-42AE-A591-E518B7FFABCD}"/>
              </a:ext>
            </a:extLst>
          </p:cNvPr>
          <p:cNvSpPr txBox="1"/>
          <p:nvPr/>
        </p:nvSpPr>
        <p:spPr>
          <a:xfrm>
            <a:off x="1011750" y="5313317"/>
            <a:ext cx="7732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6A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32" name="차트 31">
            <a:extLst>
              <a:ext uri="{FF2B5EF4-FFF2-40B4-BE49-F238E27FC236}">
                <a16:creationId xmlns:a16="http://schemas.microsoft.com/office/drawing/2014/main" id="{8260F5B5-38D3-431E-97AA-8E836DCE03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2559856"/>
              </p:ext>
            </p:extLst>
          </p:nvPr>
        </p:nvGraphicFramePr>
        <p:xfrm>
          <a:off x="1887337" y="5106643"/>
          <a:ext cx="875727" cy="11823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3" name="차트 32">
            <a:extLst>
              <a:ext uri="{FF2B5EF4-FFF2-40B4-BE49-F238E27FC236}">
                <a16:creationId xmlns:a16="http://schemas.microsoft.com/office/drawing/2014/main" id="{46C36FB6-9AC0-466F-BD34-B3F6479708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3713762"/>
              </p:ext>
            </p:extLst>
          </p:nvPr>
        </p:nvGraphicFramePr>
        <p:xfrm>
          <a:off x="2952750" y="5435030"/>
          <a:ext cx="905720" cy="8696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4" name="직사각형 33">
            <a:extLst>
              <a:ext uri="{FF2B5EF4-FFF2-40B4-BE49-F238E27FC236}">
                <a16:creationId xmlns:a16="http://schemas.microsoft.com/office/drawing/2014/main" id="{144C7C7E-578E-4D35-8194-0A3649AD9BAD}"/>
              </a:ext>
            </a:extLst>
          </p:cNvPr>
          <p:cNvSpPr/>
          <p:nvPr/>
        </p:nvSpPr>
        <p:spPr>
          <a:xfrm>
            <a:off x="2243816" y="5297042"/>
            <a:ext cx="31931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7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  <a:endParaRPr lang="ko-KR" altLang="ko-K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사각형: 둥근 모서리 34">
            <a:extLst>
              <a:ext uri="{FF2B5EF4-FFF2-40B4-BE49-F238E27FC236}">
                <a16:creationId xmlns:a16="http://schemas.microsoft.com/office/drawing/2014/main" id="{6F901CB6-4877-4305-8BA7-C11657426510}"/>
              </a:ext>
            </a:extLst>
          </p:cNvPr>
          <p:cNvSpPr/>
          <p:nvPr/>
        </p:nvSpPr>
        <p:spPr>
          <a:xfrm>
            <a:off x="3215714" y="5484333"/>
            <a:ext cx="576000" cy="45719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직사각형 35">
            <a:extLst>
              <a:ext uri="{FF2B5EF4-FFF2-40B4-BE49-F238E27FC236}">
                <a16:creationId xmlns:a16="http://schemas.microsoft.com/office/drawing/2014/main" id="{5591C151-0C98-440A-B99D-7C81C429977D}"/>
              </a:ext>
            </a:extLst>
          </p:cNvPr>
          <p:cNvSpPr/>
          <p:nvPr/>
        </p:nvSpPr>
        <p:spPr>
          <a:xfrm>
            <a:off x="3280252" y="5287711"/>
            <a:ext cx="36099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6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8" name="차트 57">
            <a:extLst>
              <a:ext uri="{FF2B5EF4-FFF2-40B4-BE49-F238E27FC236}">
                <a16:creationId xmlns:a16="http://schemas.microsoft.com/office/drawing/2014/main" id="{40AFC92F-B81D-4811-B389-D2B592DFE5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1867646"/>
              </p:ext>
            </p:extLst>
          </p:nvPr>
        </p:nvGraphicFramePr>
        <p:xfrm>
          <a:off x="1840323" y="6233673"/>
          <a:ext cx="2162362" cy="14061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59" name="차트 58">
            <a:extLst>
              <a:ext uri="{FF2B5EF4-FFF2-40B4-BE49-F238E27FC236}">
                <a16:creationId xmlns:a16="http://schemas.microsoft.com/office/drawing/2014/main" id="{E5DB21D7-2F7A-4D3F-95DB-1B36236B1B7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6854398"/>
              </p:ext>
            </p:extLst>
          </p:nvPr>
        </p:nvGraphicFramePr>
        <p:xfrm>
          <a:off x="1875215" y="7323506"/>
          <a:ext cx="2162361" cy="10400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0" name="직사각형 59">
            <a:extLst>
              <a:ext uri="{FF2B5EF4-FFF2-40B4-BE49-F238E27FC236}">
                <a16:creationId xmlns:a16="http://schemas.microsoft.com/office/drawing/2014/main" id="{A7BEB418-A68C-4C25-B479-D23E71A63D7F}"/>
              </a:ext>
            </a:extLst>
          </p:cNvPr>
          <p:cNvSpPr/>
          <p:nvPr/>
        </p:nvSpPr>
        <p:spPr>
          <a:xfrm>
            <a:off x="2512501" y="7639413"/>
            <a:ext cx="373259" cy="20990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7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  <a:endParaRPr lang="ko-KR" altLang="ko-KR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BE0377CA-24B3-444B-A942-A0FA38EE451E}"/>
              </a:ext>
            </a:extLst>
          </p:cNvPr>
          <p:cNvSpPr/>
          <p:nvPr/>
        </p:nvSpPr>
        <p:spPr>
          <a:xfrm>
            <a:off x="2703399" y="6626975"/>
            <a:ext cx="421977" cy="20990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80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rt6</a:t>
            </a:r>
            <a:endParaRPr lang="ko-KR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4C345A80-EE54-4A88-8212-E44BC8BC233E}"/>
              </a:ext>
            </a:extLst>
          </p:cNvPr>
          <p:cNvSpPr txBox="1"/>
          <p:nvPr/>
        </p:nvSpPr>
        <p:spPr>
          <a:xfrm rot="16200000">
            <a:off x="949695" y="7236023"/>
            <a:ext cx="1633803" cy="2034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protein  level (Fold)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EDA2E52-4E5E-4384-A68E-34AECBDDFEDE}"/>
              </a:ext>
            </a:extLst>
          </p:cNvPr>
          <p:cNvSpPr txBox="1"/>
          <p:nvPr/>
        </p:nvSpPr>
        <p:spPr>
          <a:xfrm>
            <a:off x="998498" y="6546575"/>
            <a:ext cx="807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6B</a:t>
            </a:r>
            <a:endParaRPr kumimoji="0" lang="ko-KR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CC84E6F-DA89-45C5-9978-4E14D234FC4F}"/>
              </a:ext>
            </a:extLst>
          </p:cNvPr>
          <p:cNvSpPr txBox="1"/>
          <p:nvPr/>
        </p:nvSpPr>
        <p:spPr>
          <a:xfrm rot="16200000">
            <a:off x="1415412" y="5569348"/>
            <a:ext cx="825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</a:t>
            </a:r>
          </a:p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 (fold)</a:t>
            </a:r>
            <a:endParaRPr lang="ko-KR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5474FFC0-2B96-490F-A032-AB63849E276D}"/>
              </a:ext>
            </a:extLst>
          </p:cNvPr>
          <p:cNvSpPr txBox="1"/>
          <p:nvPr/>
        </p:nvSpPr>
        <p:spPr>
          <a:xfrm rot="16200000">
            <a:off x="2510787" y="5569348"/>
            <a:ext cx="8251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protein </a:t>
            </a:r>
          </a:p>
          <a:p>
            <a:pPr algn="ctr">
              <a:lnSpc>
                <a:spcPts val="600"/>
              </a:lnSpc>
            </a:pPr>
            <a:r>
              <a:rPr lang="en-US" altLang="ko-KR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 (fold)</a:t>
            </a:r>
            <a:endParaRPr lang="ko-KR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직사각형 71">
            <a:extLst>
              <a:ext uri="{FF2B5EF4-FFF2-40B4-BE49-F238E27FC236}">
                <a16:creationId xmlns:a16="http://schemas.microsoft.com/office/drawing/2014/main" id="{8FC977A0-3D90-4EE7-AAAD-2C013F59BBAE}"/>
              </a:ext>
            </a:extLst>
          </p:cNvPr>
          <p:cNvSpPr/>
          <p:nvPr/>
        </p:nvSpPr>
        <p:spPr>
          <a:xfrm>
            <a:off x="1712647" y="5194430"/>
            <a:ext cx="2145824" cy="1107705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6E25B90-03FD-4C20-9B3D-E37A26DCE81B}"/>
              </a:ext>
            </a:extLst>
          </p:cNvPr>
          <p:cNvSpPr txBox="1"/>
          <p:nvPr/>
        </p:nvSpPr>
        <p:spPr>
          <a:xfrm>
            <a:off x="2177193" y="1211153"/>
            <a:ext cx="20585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9     </a:t>
            </a:r>
            <a:endParaRPr lang="ko-KR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3917964"/>
      </p:ext>
    </p:extLst>
  </p:cSld>
  <p:clrMapOvr>
    <a:masterClrMapping/>
  </p:clrMapOvr>
</p:sld>
</file>

<file path=ppt/theme/theme1.xml><?xml version="1.0" encoding="utf-8"?>
<a:theme xmlns:a="http://schemas.openxmlformats.org/drawingml/2006/main" name="테마1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테마1" id="{A14DAEC8-A846-4419-8755-9372445027F3}" vid="{605BC7CC-3C27-41D2-86AB-587B9A5B4B2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419</TotalTime>
  <Words>559</Words>
  <Application>Microsoft Office PowerPoint</Application>
  <PresentationFormat>A4 용지(210x297mm)</PresentationFormat>
  <Paragraphs>210</Paragraphs>
  <Slides>9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7" baseType="lpstr">
      <vt:lpstr>Arial Unicode MS</vt:lpstr>
      <vt:lpstr>굴림</vt:lpstr>
      <vt:lpstr>맑은 고딕</vt:lpstr>
      <vt:lpstr>Arial</vt:lpstr>
      <vt:lpstr>Calibri</vt:lpstr>
      <vt:lpstr>Calibri Light</vt:lpstr>
      <vt:lpstr>Times New Roman</vt:lpstr>
      <vt:lpstr>테마1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1</cp:revision>
  <dcterms:created xsi:type="dcterms:W3CDTF">2024-01-02T12:53:27Z</dcterms:created>
  <dcterms:modified xsi:type="dcterms:W3CDTF">2025-01-29T10:59:02Z</dcterms:modified>
</cp:coreProperties>
</file>